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9" r:id="rId5"/>
  </p:sldIdLst>
  <p:sldSz cx="7556500" cy="10693400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1.xml"/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1.xml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1.xml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1.xml"/><Relationship Id="rId8" Type="http://schemas.openxmlformats.org/officeDocument/2006/relationships/image" Target="../media/image22.png"/><Relationship Id="rId7" Type="http://schemas.openxmlformats.org/officeDocument/2006/relationships/image" Target="../media/image21.png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rot="21600000">
            <a:off x="3416636" y="3651151"/>
            <a:ext cx="117555" cy="364687"/>
          </a:xfrm>
          <a:prstGeom prst="rect">
            <a:avLst/>
          </a:prstGeom>
        </p:spPr>
      </p:pic>
      <p:sp>
        <p:nvSpPr>
          <p:cNvPr id="4" name="path"/>
          <p:cNvSpPr/>
          <p:nvPr/>
        </p:nvSpPr>
        <p:spPr>
          <a:xfrm>
            <a:off x="924574" y="3651151"/>
            <a:ext cx="3620944" cy="254627"/>
          </a:xfrm>
          <a:custGeom>
            <a:avLst/>
            <a:gdLst/>
            <a:ahLst/>
            <a:cxnLst/>
            <a:rect l="0" t="0" r="0" b="0"/>
            <a:pathLst>
              <a:path w="5702" h="400">
                <a:moveTo>
                  <a:pt x="7" y="393"/>
                </a:moveTo>
                <a:lnTo>
                  <a:pt x="35" y="393"/>
                </a:lnTo>
                <a:lnTo>
                  <a:pt x="64" y="393"/>
                </a:lnTo>
                <a:lnTo>
                  <a:pt x="92" y="393"/>
                </a:lnTo>
                <a:lnTo>
                  <a:pt x="121" y="393"/>
                </a:lnTo>
                <a:lnTo>
                  <a:pt x="149" y="393"/>
                </a:lnTo>
                <a:lnTo>
                  <a:pt x="177" y="393"/>
                </a:lnTo>
                <a:lnTo>
                  <a:pt x="206" y="393"/>
                </a:lnTo>
                <a:lnTo>
                  <a:pt x="234" y="393"/>
                </a:lnTo>
                <a:lnTo>
                  <a:pt x="263" y="393"/>
                </a:lnTo>
                <a:lnTo>
                  <a:pt x="291" y="393"/>
                </a:lnTo>
                <a:lnTo>
                  <a:pt x="320" y="393"/>
                </a:lnTo>
                <a:lnTo>
                  <a:pt x="348" y="393"/>
                </a:lnTo>
                <a:lnTo>
                  <a:pt x="376" y="393"/>
                </a:lnTo>
                <a:lnTo>
                  <a:pt x="405" y="393"/>
                </a:lnTo>
                <a:lnTo>
                  <a:pt x="433" y="393"/>
                </a:lnTo>
                <a:lnTo>
                  <a:pt x="462" y="393"/>
                </a:lnTo>
                <a:lnTo>
                  <a:pt x="490" y="393"/>
                </a:lnTo>
                <a:lnTo>
                  <a:pt x="519" y="393"/>
                </a:lnTo>
                <a:lnTo>
                  <a:pt x="547" y="393"/>
                </a:lnTo>
                <a:lnTo>
                  <a:pt x="576" y="393"/>
                </a:lnTo>
                <a:lnTo>
                  <a:pt x="604" y="393"/>
                </a:lnTo>
                <a:lnTo>
                  <a:pt x="632" y="393"/>
                </a:lnTo>
                <a:lnTo>
                  <a:pt x="661" y="393"/>
                </a:lnTo>
                <a:lnTo>
                  <a:pt x="689" y="393"/>
                </a:lnTo>
                <a:lnTo>
                  <a:pt x="718" y="393"/>
                </a:lnTo>
                <a:lnTo>
                  <a:pt x="746" y="393"/>
                </a:lnTo>
                <a:lnTo>
                  <a:pt x="775" y="393"/>
                </a:lnTo>
                <a:lnTo>
                  <a:pt x="803" y="393"/>
                </a:lnTo>
                <a:lnTo>
                  <a:pt x="832" y="393"/>
                </a:lnTo>
                <a:lnTo>
                  <a:pt x="860" y="393"/>
                </a:lnTo>
                <a:lnTo>
                  <a:pt x="888" y="393"/>
                </a:lnTo>
                <a:lnTo>
                  <a:pt x="917" y="393"/>
                </a:lnTo>
                <a:lnTo>
                  <a:pt x="945" y="393"/>
                </a:lnTo>
                <a:lnTo>
                  <a:pt x="974" y="393"/>
                </a:lnTo>
                <a:lnTo>
                  <a:pt x="1002" y="393"/>
                </a:lnTo>
                <a:lnTo>
                  <a:pt x="1031" y="393"/>
                </a:lnTo>
                <a:lnTo>
                  <a:pt x="1059" y="393"/>
                </a:lnTo>
                <a:lnTo>
                  <a:pt x="1087" y="393"/>
                </a:lnTo>
                <a:lnTo>
                  <a:pt x="1116" y="393"/>
                </a:lnTo>
                <a:lnTo>
                  <a:pt x="1144" y="393"/>
                </a:lnTo>
                <a:lnTo>
                  <a:pt x="1173" y="393"/>
                </a:lnTo>
                <a:lnTo>
                  <a:pt x="1201" y="393"/>
                </a:lnTo>
                <a:lnTo>
                  <a:pt x="1230" y="393"/>
                </a:lnTo>
                <a:lnTo>
                  <a:pt x="1258" y="393"/>
                </a:lnTo>
                <a:lnTo>
                  <a:pt x="1287" y="393"/>
                </a:lnTo>
                <a:lnTo>
                  <a:pt x="1315" y="393"/>
                </a:lnTo>
                <a:lnTo>
                  <a:pt x="1343" y="393"/>
                </a:lnTo>
                <a:lnTo>
                  <a:pt x="1372" y="393"/>
                </a:lnTo>
                <a:lnTo>
                  <a:pt x="1400" y="393"/>
                </a:lnTo>
                <a:lnTo>
                  <a:pt x="1429" y="390"/>
                </a:lnTo>
                <a:lnTo>
                  <a:pt x="1457" y="388"/>
                </a:lnTo>
                <a:lnTo>
                  <a:pt x="1486" y="383"/>
                </a:lnTo>
                <a:lnTo>
                  <a:pt x="1514" y="382"/>
                </a:lnTo>
                <a:lnTo>
                  <a:pt x="1542" y="383"/>
                </a:lnTo>
                <a:lnTo>
                  <a:pt x="1571" y="388"/>
                </a:lnTo>
                <a:lnTo>
                  <a:pt x="1599" y="388"/>
                </a:lnTo>
                <a:lnTo>
                  <a:pt x="1628" y="382"/>
                </a:lnTo>
                <a:lnTo>
                  <a:pt x="1656" y="374"/>
                </a:lnTo>
                <a:lnTo>
                  <a:pt x="1685" y="362"/>
                </a:lnTo>
                <a:lnTo>
                  <a:pt x="1713" y="297"/>
                </a:lnTo>
                <a:lnTo>
                  <a:pt x="1742" y="217"/>
                </a:lnTo>
                <a:moveTo>
                  <a:pt x="2282" y="100"/>
                </a:moveTo>
                <a:lnTo>
                  <a:pt x="2310" y="147"/>
                </a:lnTo>
                <a:lnTo>
                  <a:pt x="2339" y="219"/>
                </a:lnTo>
                <a:lnTo>
                  <a:pt x="2367" y="251"/>
                </a:lnTo>
                <a:lnTo>
                  <a:pt x="2396" y="266"/>
                </a:lnTo>
                <a:lnTo>
                  <a:pt x="2424" y="287"/>
                </a:lnTo>
                <a:lnTo>
                  <a:pt x="2452" y="294"/>
                </a:lnTo>
                <a:lnTo>
                  <a:pt x="2481" y="276"/>
                </a:lnTo>
                <a:lnTo>
                  <a:pt x="2509" y="273"/>
                </a:lnTo>
                <a:lnTo>
                  <a:pt x="2538" y="295"/>
                </a:lnTo>
                <a:lnTo>
                  <a:pt x="2566" y="299"/>
                </a:lnTo>
                <a:lnTo>
                  <a:pt x="2595" y="318"/>
                </a:lnTo>
                <a:lnTo>
                  <a:pt x="2623" y="304"/>
                </a:lnTo>
                <a:lnTo>
                  <a:pt x="2652" y="286"/>
                </a:lnTo>
                <a:lnTo>
                  <a:pt x="2680" y="294"/>
                </a:lnTo>
                <a:lnTo>
                  <a:pt x="2708" y="274"/>
                </a:lnTo>
                <a:lnTo>
                  <a:pt x="2737" y="313"/>
                </a:lnTo>
                <a:lnTo>
                  <a:pt x="2765" y="308"/>
                </a:lnTo>
                <a:lnTo>
                  <a:pt x="2794" y="290"/>
                </a:lnTo>
                <a:lnTo>
                  <a:pt x="2822" y="323"/>
                </a:lnTo>
                <a:lnTo>
                  <a:pt x="2851" y="320"/>
                </a:lnTo>
                <a:lnTo>
                  <a:pt x="2879" y="320"/>
                </a:lnTo>
                <a:lnTo>
                  <a:pt x="2908" y="292"/>
                </a:lnTo>
                <a:lnTo>
                  <a:pt x="2936" y="317"/>
                </a:lnTo>
                <a:lnTo>
                  <a:pt x="2964" y="300"/>
                </a:lnTo>
                <a:lnTo>
                  <a:pt x="2993" y="325"/>
                </a:lnTo>
                <a:lnTo>
                  <a:pt x="3021" y="317"/>
                </a:lnTo>
                <a:lnTo>
                  <a:pt x="3050" y="299"/>
                </a:lnTo>
                <a:lnTo>
                  <a:pt x="3078" y="299"/>
                </a:lnTo>
                <a:lnTo>
                  <a:pt x="3107" y="304"/>
                </a:lnTo>
                <a:lnTo>
                  <a:pt x="3135" y="336"/>
                </a:lnTo>
                <a:lnTo>
                  <a:pt x="3163" y="300"/>
                </a:lnTo>
                <a:lnTo>
                  <a:pt x="3192" y="300"/>
                </a:lnTo>
                <a:lnTo>
                  <a:pt x="3220" y="313"/>
                </a:lnTo>
                <a:lnTo>
                  <a:pt x="3249" y="299"/>
                </a:lnTo>
                <a:lnTo>
                  <a:pt x="3277" y="321"/>
                </a:lnTo>
                <a:lnTo>
                  <a:pt x="3306" y="302"/>
                </a:lnTo>
                <a:lnTo>
                  <a:pt x="3334" y="286"/>
                </a:lnTo>
                <a:lnTo>
                  <a:pt x="3363" y="302"/>
                </a:lnTo>
                <a:lnTo>
                  <a:pt x="3391" y="277"/>
                </a:lnTo>
                <a:lnTo>
                  <a:pt x="3419" y="305"/>
                </a:lnTo>
                <a:lnTo>
                  <a:pt x="3448" y="292"/>
                </a:lnTo>
                <a:lnTo>
                  <a:pt x="3476" y="250"/>
                </a:lnTo>
                <a:lnTo>
                  <a:pt x="3505" y="297"/>
                </a:lnTo>
                <a:lnTo>
                  <a:pt x="3533" y="261"/>
                </a:lnTo>
                <a:lnTo>
                  <a:pt x="3562" y="240"/>
                </a:lnTo>
                <a:lnTo>
                  <a:pt x="3590" y="240"/>
                </a:lnTo>
                <a:lnTo>
                  <a:pt x="3618" y="219"/>
                </a:lnTo>
                <a:lnTo>
                  <a:pt x="3647" y="211"/>
                </a:lnTo>
                <a:lnTo>
                  <a:pt x="3675" y="227"/>
                </a:lnTo>
                <a:lnTo>
                  <a:pt x="3704" y="238"/>
                </a:lnTo>
                <a:lnTo>
                  <a:pt x="3732" y="214"/>
                </a:lnTo>
                <a:lnTo>
                  <a:pt x="3761" y="188"/>
                </a:lnTo>
                <a:lnTo>
                  <a:pt x="3789" y="185"/>
                </a:lnTo>
                <a:lnTo>
                  <a:pt x="3818" y="204"/>
                </a:lnTo>
                <a:lnTo>
                  <a:pt x="3846" y="173"/>
                </a:lnTo>
                <a:lnTo>
                  <a:pt x="3874" y="158"/>
                </a:lnTo>
                <a:lnTo>
                  <a:pt x="3903" y="147"/>
                </a:lnTo>
                <a:lnTo>
                  <a:pt x="3931" y="170"/>
                </a:lnTo>
                <a:moveTo>
                  <a:pt x="3960" y="52"/>
                </a:moveTo>
                <a:lnTo>
                  <a:pt x="3988" y="106"/>
                </a:lnTo>
                <a:moveTo>
                  <a:pt x="4017" y="7"/>
                </a:moveTo>
                <a:lnTo>
                  <a:pt x="4045" y="25"/>
                </a:lnTo>
                <a:lnTo>
                  <a:pt x="4073" y="90"/>
                </a:lnTo>
                <a:lnTo>
                  <a:pt x="4102" y="119"/>
                </a:lnTo>
                <a:lnTo>
                  <a:pt x="4130" y="93"/>
                </a:lnTo>
                <a:lnTo>
                  <a:pt x="4159" y="183"/>
                </a:lnTo>
                <a:lnTo>
                  <a:pt x="4187" y="222"/>
                </a:lnTo>
                <a:lnTo>
                  <a:pt x="4216" y="243"/>
                </a:lnTo>
                <a:lnTo>
                  <a:pt x="4244" y="289"/>
                </a:lnTo>
                <a:lnTo>
                  <a:pt x="4273" y="338"/>
                </a:lnTo>
                <a:lnTo>
                  <a:pt x="4301" y="330"/>
                </a:lnTo>
                <a:lnTo>
                  <a:pt x="4329" y="364"/>
                </a:lnTo>
                <a:lnTo>
                  <a:pt x="4358" y="377"/>
                </a:lnTo>
                <a:lnTo>
                  <a:pt x="4386" y="382"/>
                </a:lnTo>
                <a:lnTo>
                  <a:pt x="4415" y="382"/>
                </a:lnTo>
                <a:lnTo>
                  <a:pt x="4443" y="380"/>
                </a:lnTo>
                <a:lnTo>
                  <a:pt x="4472" y="382"/>
                </a:lnTo>
                <a:lnTo>
                  <a:pt x="4500" y="387"/>
                </a:lnTo>
                <a:lnTo>
                  <a:pt x="4529" y="385"/>
                </a:lnTo>
                <a:lnTo>
                  <a:pt x="4557" y="393"/>
                </a:lnTo>
                <a:lnTo>
                  <a:pt x="4585" y="383"/>
                </a:lnTo>
                <a:lnTo>
                  <a:pt x="4614" y="390"/>
                </a:lnTo>
                <a:lnTo>
                  <a:pt x="4642" y="392"/>
                </a:lnTo>
                <a:lnTo>
                  <a:pt x="4671" y="392"/>
                </a:lnTo>
                <a:lnTo>
                  <a:pt x="4699" y="393"/>
                </a:lnTo>
                <a:lnTo>
                  <a:pt x="4728" y="392"/>
                </a:lnTo>
                <a:lnTo>
                  <a:pt x="4756" y="387"/>
                </a:lnTo>
                <a:lnTo>
                  <a:pt x="4784" y="393"/>
                </a:lnTo>
                <a:lnTo>
                  <a:pt x="4813" y="393"/>
                </a:lnTo>
                <a:lnTo>
                  <a:pt x="4841" y="393"/>
                </a:lnTo>
                <a:lnTo>
                  <a:pt x="4870" y="388"/>
                </a:lnTo>
                <a:lnTo>
                  <a:pt x="4898" y="392"/>
                </a:lnTo>
                <a:lnTo>
                  <a:pt x="4927" y="392"/>
                </a:lnTo>
                <a:lnTo>
                  <a:pt x="4955" y="392"/>
                </a:lnTo>
                <a:lnTo>
                  <a:pt x="4984" y="393"/>
                </a:lnTo>
                <a:lnTo>
                  <a:pt x="5012" y="393"/>
                </a:lnTo>
                <a:lnTo>
                  <a:pt x="5040" y="393"/>
                </a:lnTo>
                <a:lnTo>
                  <a:pt x="5069" y="390"/>
                </a:lnTo>
                <a:lnTo>
                  <a:pt x="5097" y="392"/>
                </a:lnTo>
                <a:lnTo>
                  <a:pt x="5126" y="393"/>
                </a:lnTo>
                <a:lnTo>
                  <a:pt x="5154" y="390"/>
                </a:lnTo>
                <a:lnTo>
                  <a:pt x="5183" y="392"/>
                </a:lnTo>
                <a:lnTo>
                  <a:pt x="5211" y="393"/>
                </a:lnTo>
                <a:lnTo>
                  <a:pt x="5239" y="390"/>
                </a:lnTo>
                <a:lnTo>
                  <a:pt x="5268" y="392"/>
                </a:lnTo>
                <a:lnTo>
                  <a:pt x="5296" y="393"/>
                </a:lnTo>
                <a:lnTo>
                  <a:pt x="5325" y="393"/>
                </a:lnTo>
                <a:lnTo>
                  <a:pt x="5353" y="392"/>
                </a:lnTo>
                <a:lnTo>
                  <a:pt x="5382" y="393"/>
                </a:lnTo>
                <a:lnTo>
                  <a:pt x="5410" y="392"/>
                </a:lnTo>
                <a:lnTo>
                  <a:pt x="5439" y="393"/>
                </a:lnTo>
                <a:lnTo>
                  <a:pt x="5467" y="393"/>
                </a:lnTo>
                <a:lnTo>
                  <a:pt x="5495" y="393"/>
                </a:lnTo>
                <a:lnTo>
                  <a:pt x="5524" y="393"/>
                </a:lnTo>
                <a:lnTo>
                  <a:pt x="5552" y="393"/>
                </a:lnTo>
                <a:lnTo>
                  <a:pt x="5581" y="393"/>
                </a:lnTo>
                <a:lnTo>
                  <a:pt x="5609" y="393"/>
                </a:lnTo>
                <a:lnTo>
                  <a:pt x="5638" y="393"/>
                </a:lnTo>
                <a:lnTo>
                  <a:pt x="5666" y="393"/>
                </a:lnTo>
                <a:lnTo>
                  <a:pt x="5694" y="393"/>
                </a:lnTo>
              </a:path>
            </a:pathLst>
          </a:custGeom>
          <a:noFill/>
          <a:ln w="9260" cap="rnd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" name="path"/>
          <p:cNvSpPr/>
          <p:nvPr/>
        </p:nvSpPr>
        <p:spPr>
          <a:xfrm>
            <a:off x="3807583" y="3900191"/>
            <a:ext cx="733734" cy="135349"/>
          </a:xfrm>
          <a:custGeom>
            <a:avLst/>
            <a:gdLst/>
            <a:ahLst/>
            <a:cxnLst/>
            <a:rect l="0" t="0" r="0" b="0"/>
            <a:pathLst>
              <a:path w="1155" h="213">
                <a:moveTo>
                  <a:pt x="5" y="5"/>
                </a:moveTo>
                <a:lnTo>
                  <a:pt x="5" y="106"/>
                </a:lnTo>
                <a:moveTo>
                  <a:pt x="297" y="5"/>
                </a:moveTo>
                <a:lnTo>
                  <a:pt x="297" y="106"/>
                </a:lnTo>
                <a:moveTo>
                  <a:pt x="577" y="5"/>
                </a:moveTo>
                <a:lnTo>
                  <a:pt x="577" y="106"/>
                </a:lnTo>
                <a:moveTo>
                  <a:pt x="869" y="5"/>
                </a:moveTo>
                <a:lnTo>
                  <a:pt x="869" y="106"/>
                </a:lnTo>
                <a:moveTo>
                  <a:pt x="1149" y="5"/>
                </a:moveTo>
                <a:lnTo>
                  <a:pt x="1149" y="207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pic>
        <p:nvPicPr>
          <p:cNvPr id="8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600000">
            <a:off x="2188719" y="3899554"/>
            <a:ext cx="117500" cy="116283"/>
          </a:xfrm>
          <a:prstGeom prst="rect">
            <a:avLst/>
          </a:prstGeom>
        </p:spPr>
      </p:pic>
      <p:sp>
        <p:nvSpPr>
          <p:cNvPr id="10" name="path"/>
          <p:cNvSpPr/>
          <p:nvPr/>
        </p:nvSpPr>
        <p:spPr>
          <a:xfrm>
            <a:off x="915387" y="3900191"/>
            <a:ext cx="7123" cy="135349"/>
          </a:xfrm>
          <a:custGeom>
            <a:avLst/>
            <a:gdLst/>
            <a:ahLst/>
            <a:cxnLst/>
            <a:rect l="0" t="0" r="0" b="0"/>
            <a:pathLst>
              <a:path w="11" h="213">
                <a:moveTo>
                  <a:pt x="5" y="5"/>
                </a:moveTo>
                <a:lnTo>
                  <a:pt x="5" y="207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2" name="path"/>
          <p:cNvSpPr/>
          <p:nvPr/>
        </p:nvSpPr>
        <p:spPr>
          <a:xfrm>
            <a:off x="1093478" y="3900191"/>
            <a:ext cx="733734" cy="135349"/>
          </a:xfrm>
          <a:custGeom>
            <a:avLst/>
            <a:gdLst/>
            <a:ahLst/>
            <a:cxnLst/>
            <a:rect l="0" t="0" r="0" b="0"/>
            <a:pathLst>
              <a:path w="1155" h="213">
                <a:moveTo>
                  <a:pt x="5" y="5"/>
                </a:moveTo>
                <a:lnTo>
                  <a:pt x="5" y="106"/>
                </a:lnTo>
                <a:moveTo>
                  <a:pt x="297" y="5"/>
                </a:moveTo>
                <a:lnTo>
                  <a:pt x="297" y="106"/>
                </a:lnTo>
                <a:moveTo>
                  <a:pt x="577" y="5"/>
                </a:moveTo>
                <a:lnTo>
                  <a:pt x="577" y="106"/>
                </a:lnTo>
                <a:moveTo>
                  <a:pt x="869" y="5"/>
                </a:moveTo>
                <a:lnTo>
                  <a:pt x="869" y="106"/>
                </a:lnTo>
                <a:moveTo>
                  <a:pt x="1149" y="5"/>
                </a:moveTo>
                <a:lnTo>
                  <a:pt x="1149" y="207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4" name="path"/>
          <p:cNvSpPr/>
          <p:nvPr/>
        </p:nvSpPr>
        <p:spPr>
          <a:xfrm>
            <a:off x="1998180" y="3900191"/>
            <a:ext cx="733734" cy="135349"/>
          </a:xfrm>
          <a:custGeom>
            <a:avLst/>
            <a:gdLst/>
            <a:ahLst/>
            <a:cxnLst/>
            <a:rect l="0" t="0" r="0" b="0"/>
            <a:pathLst>
              <a:path w="1155" h="213">
                <a:moveTo>
                  <a:pt x="5" y="5"/>
                </a:moveTo>
                <a:lnTo>
                  <a:pt x="5" y="106"/>
                </a:lnTo>
                <a:moveTo>
                  <a:pt x="297" y="5"/>
                </a:moveTo>
                <a:lnTo>
                  <a:pt x="297" y="106"/>
                </a:lnTo>
                <a:moveTo>
                  <a:pt x="577" y="5"/>
                </a:moveTo>
                <a:lnTo>
                  <a:pt x="577" y="106"/>
                </a:lnTo>
                <a:moveTo>
                  <a:pt x="869" y="5"/>
                </a:moveTo>
                <a:lnTo>
                  <a:pt x="869" y="106"/>
                </a:lnTo>
                <a:moveTo>
                  <a:pt x="1149" y="5"/>
                </a:moveTo>
                <a:lnTo>
                  <a:pt x="1149" y="207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6" name="path"/>
          <p:cNvSpPr/>
          <p:nvPr/>
        </p:nvSpPr>
        <p:spPr>
          <a:xfrm>
            <a:off x="2902882" y="3900191"/>
            <a:ext cx="733734" cy="135349"/>
          </a:xfrm>
          <a:custGeom>
            <a:avLst/>
            <a:gdLst/>
            <a:ahLst/>
            <a:cxnLst/>
            <a:rect l="0" t="0" r="0" b="0"/>
            <a:pathLst>
              <a:path w="1155" h="213">
                <a:moveTo>
                  <a:pt x="5" y="5"/>
                </a:moveTo>
                <a:lnTo>
                  <a:pt x="5" y="106"/>
                </a:lnTo>
                <a:moveTo>
                  <a:pt x="297" y="5"/>
                </a:moveTo>
                <a:lnTo>
                  <a:pt x="297" y="106"/>
                </a:lnTo>
                <a:moveTo>
                  <a:pt x="577" y="5"/>
                </a:moveTo>
                <a:lnTo>
                  <a:pt x="577" y="106"/>
                </a:lnTo>
                <a:moveTo>
                  <a:pt x="869" y="5"/>
                </a:moveTo>
                <a:lnTo>
                  <a:pt x="869" y="106"/>
                </a:lnTo>
                <a:moveTo>
                  <a:pt x="1149" y="5"/>
                </a:moveTo>
                <a:lnTo>
                  <a:pt x="1149" y="207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8" name="path"/>
          <p:cNvSpPr/>
          <p:nvPr/>
        </p:nvSpPr>
        <p:spPr>
          <a:xfrm>
            <a:off x="915387" y="3900191"/>
            <a:ext cx="3625931" cy="7123"/>
          </a:xfrm>
          <a:custGeom>
            <a:avLst/>
            <a:gdLst/>
            <a:ahLst/>
            <a:cxnLst/>
            <a:rect l="0" t="0" r="0" b="0"/>
            <a:pathLst>
              <a:path w="5710" h="11">
                <a:moveTo>
                  <a:pt x="5" y="5"/>
                </a:moveTo>
                <a:lnTo>
                  <a:pt x="5704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20" name="path"/>
          <p:cNvSpPr/>
          <p:nvPr/>
        </p:nvSpPr>
        <p:spPr>
          <a:xfrm>
            <a:off x="2026138" y="3693597"/>
            <a:ext cx="27319" cy="100369"/>
          </a:xfrm>
          <a:custGeom>
            <a:avLst/>
            <a:gdLst/>
            <a:ahLst/>
            <a:cxnLst/>
            <a:rect l="0" t="0" r="0" b="0"/>
            <a:pathLst>
              <a:path w="43" h="158">
                <a:moveTo>
                  <a:pt x="7" y="150"/>
                </a:moveTo>
                <a:lnTo>
                  <a:pt x="35" y="7"/>
                </a:lnTo>
              </a:path>
            </a:pathLst>
          </a:custGeom>
          <a:noFill/>
          <a:ln w="9260" cap="rnd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22" name="path"/>
          <p:cNvSpPr/>
          <p:nvPr/>
        </p:nvSpPr>
        <p:spPr>
          <a:xfrm>
            <a:off x="2044196" y="941766"/>
            <a:ext cx="334312" cy="2777658"/>
          </a:xfrm>
          <a:custGeom>
            <a:avLst/>
            <a:gdLst/>
            <a:ahLst/>
            <a:cxnLst/>
            <a:rect l="0" t="0" r="0" b="0"/>
            <a:pathLst>
              <a:path w="526" h="4374">
                <a:moveTo>
                  <a:pt x="7" y="4340"/>
                </a:moveTo>
                <a:lnTo>
                  <a:pt x="35" y="4128"/>
                </a:lnTo>
                <a:lnTo>
                  <a:pt x="64" y="4019"/>
                </a:lnTo>
                <a:lnTo>
                  <a:pt x="92" y="3677"/>
                </a:lnTo>
                <a:lnTo>
                  <a:pt x="121" y="3462"/>
                </a:lnTo>
                <a:lnTo>
                  <a:pt x="149" y="3248"/>
                </a:lnTo>
                <a:lnTo>
                  <a:pt x="177" y="2907"/>
                </a:lnTo>
                <a:lnTo>
                  <a:pt x="206" y="2609"/>
                </a:lnTo>
                <a:lnTo>
                  <a:pt x="234" y="2063"/>
                </a:lnTo>
                <a:lnTo>
                  <a:pt x="263" y="1373"/>
                </a:lnTo>
                <a:lnTo>
                  <a:pt x="291" y="633"/>
                </a:lnTo>
                <a:lnTo>
                  <a:pt x="320" y="7"/>
                </a:lnTo>
                <a:lnTo>
                  <a:pt x="348" y="118"/>
                </a:lnTo>
                <a:lnTo>
                  <a:pt x="376" y="1000"/>
                </a:lnTo>
                <a:lnTo>
                  <a:pt x="405" y="2118"/>
                </a:lnTo>
                <a:lnTo>
                  <a:pt x="433" y="3023"/>
                </a:lnTo>
                <a:lnTo>
                  <a:pt x="462" y="3664"/>
                </a:lnTo>
                <a:lnTo>
                  <a:pt x="490" y="4094"/>
                </a:lnTo>
                <a:lnTo>
                  <a:pt x="519" y="4366"/>
                </a:lnTo>
              </a:path>
            </a:pathLst>
          </a:custGeom>
          <a:noFill/>
          <a:ln w="9260" cap="rnd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pic>
        <p:nvPicPr>
          <p:cNvPr id="24" name="picture 2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1600000">
            <a:off x="929204" y="1388647"/>
            <a:ext cx="3611684" cy="2512500"/>
          </a:xfrm>
          <a:prstGeom prst="rect">
            <a:avLst/>
          </a:prstGeom>
        </p:spPr>
      </p:pic>
      <p:sp>
        <p:nvSpPr>
          <p:cNvPr id="26" name="textbox 26"/>
          <p:cNvSpPr/>
          <p:nvPr/>
        </p:nvSpPr>
        <p:spPr>
          <a:xfrm>
            <a:off x="5148708" y="463314"/>
            <a:ext cx="2123439" cy="3308984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76000"/>
              </a:lnSpc>
            </a:pPr>
            <a:endParaRPr lang="en-US" altLang="en-US" sz="100" dirty="0"/>
          </a:p>
          <a:p>
            <a:pPr marL="21590" algn="l" rtl="0" eaLnBrk="0">
              <a:lnSpc>
                <a:spcPct val="10200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ile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nalyzed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231222</a:t>
            </a:r>
            <a:r>
              <a:rPr sz="900" u="sng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9</a:t>
            </a:r>
            <a:r>
              <a:rPr sz="900" u="sng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09.fcs        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ate analyzed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7-Dec-20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3</a:t>
            </a:r>
            <a:endParaRPr lang="en-US" altLang="en-US" sz="1000" dirty="0"/>
          </a:p>
          <a:p>
            <a:pPr marL="2159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l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nn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n_DSD</a:t>
            </a:r>
            <a:endParaRPr lang="en-US" altLang="en-US" sz="900" dirty="0"/>
          </a:p>
          <a:p>
            <a:pPr marL="12700" algn="l" rtl="0" eaLnBrk="0">
              <a:lnSpc>
                <a:spcPts val="1230"/>
              </a:lnSpc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nalysis type:</a:t>
            </a:r>
            <a:r>
              <a:rPr sz="10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anual analy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is</a:t>
            </a:r>
            <a:endParaRPr lang="en-US" altLang="en-US" sz="1000" dirty="0"/>
          </a:p>
          <a:p>
            <a:pPr marL="12700" algn="l" rtl="0" eaLnBrk="0">
              <a:lnSpc>
                <a:spcPct val="87000"/>
              </a:lnSpc>
              <a:spcBef>
                <a:spcPts val="7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uto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Linearity:</a:t>
            </a:r>
            <a:r>
              <a:rPr sz="10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o</a:t>
            </a:r>
            <a:endParaRPr lang="en-US" altLang="en-US" sz="1000" dirty="0"/>
          </a:p>
          <a:p>
            <a:pPr marL="21590" algn="l" rtl="0" eaLnBrk="0">
              <a:lnSpc>
                <a:spcPts val="1270"/>
              </a:lnSpc>
              <a:spcBef>
                <a:spcPts val="94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loidy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</a:t>
            </a:r>
            <a:r>
              <a:rPr sz="900" kern="0" spc="1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irst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ycle</a:t>
            </a:r>
            <a:r>
              <a:rPr sz="9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is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loid</a:t>
            </a:r>
            <a:endParaRPr lang="en-US" altLang="en-US" sz="900" dirty="0"/>
          </a:p>
          <a:p>
            <a:pPr marL="21590" algn="l" rtl="0" eaLnBrk="0">
              <a:lnSpc>
                <a:spcPts val="1195"/>
              </a:lnSpc>
              <a:spcBef>
                <a:spcPts val="97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loid:</a:t>
            </a:r>
            <a:r>
              <a:rPr sz="900" kern="0" spc="1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.00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lang="en-US" altLang="en-US" sz="900" dirty="0"/>
          </a:p>
          <a:p>
            <a:pPr marL="12827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G1: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7.52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t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2.</a:t>
            </a:r>
            <a:r>
              <a:rPr sz="900" kern="0" spc="-1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1</a:t>
            </a:r>
            <a:endParaRPr lang="en-US" altLang="en-US" sz="900" dirty="0"/>
          </a:p>
          <a:p>
            <a:pPr marL="12827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G2: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.50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t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40.62</a:t>
            </a:r>
            <a:endParaRPr lang="en-US" altLang="en-US" sz="900" dirty="0"/>
          </a:p>
          <a:p>
            <a:pPr marL="128270" algn="l" rtl="0" eaLnBrk="0">
              <a:lnSpc>
                <a:spcPts val="123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S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3.98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2/G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:</a:t>
            </a:r>
            <a:r>
              <a:rPr sz="900" kern="0" spc="1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.95</a:t>
            </a:r>
            <a:endParaRPr lang="en-US" altLang="en-US" sz="900" dirty="0"/>
          </a:p>
          <a:p>
            <a:pPr marL="126365" algn="l" rtl="0" eaLnBrk="0">
              <a:lnSpc>
                <a:spcPts val="1230"/>
              </a:lnSpc>
              <a:spcBef>
                <a:spcPts val="70"/>
              </a:spcBef>
            </a:pPr>
            <a:r>
              <a:rPr sz="1000" kern="0" spc="-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CV:</a:t>
            </a:r>
            <a:r>
              <a:rPr sz="1000" kern="0" spc="1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5.03</a:t>
            </a:r>
            <a:endParaRPr lang="en-US" altLang="en-US" sz="1000" dirty="0"/>
          </a:p>
          <a:p>
            <a:pPr marL="15240" algn="l" rtl="0" eaLnBrk="0">
              <a:lnSpc>
                <a:spcPts val="1195"/>
              </a:lnSpc>
              <a:spcBef>
                <a:spcPts val="760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Total S-Phase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3.98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lang="en-US" altLang="en-US" sz="900" dirty="0"/>
          </a:p>
          <a:p>
            <a:pPr marL="15240" algn="l" rtl="0" eaLnBrk="0">
              <a:lnSpc>
                <a:spcPts val="1195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Total B.A.D.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.00 %    no debris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o aggs</a:t>
            </a:r>
            <a:endParaRPr lang="en-US" altLang="en-US" sz="900" dirty="0"/>
          </a:p>
          <a:p>
            <a:pPr marL="21590" algn="l" rtl="0" eaLnBrk="0">
              <a:lnSpc>
                <a:spcPct val="100000"/>
              </a:lnSpc>
              <a:spcBef>
                <a:spcPts val="970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ebris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lang="en-US" altLang="en-US" sz="1000" dirty="0"/>
          </a:p>
          <a:p>
            <a:pPr marL="12700" algn="l" rtl="0" eaLnBrk="0">
              <a:lnSpc>
                <a:spcPct val="93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ggregates:</a:t>
            </a:r>
            <a:r>
              <a:rPr sz="10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lang="en-US" altLang="en-US" sz="1000" dirty="0"/>
          </a:p>
          <a:p>
            <a:pPr marL="2159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led event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: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8198</a:t>
            </a:r>
            <a:endParaRPr lang="en-US" altLang="en-US" sz="900" dirty="0"/>
          </a:p>
          <a:p>
            <a:pPr marL="12700" algn="l" rtl="0" eaLnBrk="0">
              <a:lnSpc>
                <a:spcPct val="93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ll cycle events:</a:t>
            </a:r>
            <a:r>
              <a:rPr sz="10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8198</a:t>
            </a:r>
            <a:endParaRPr lang="en-US" altLang="en-US" sz="1000" dirty="0"/>
          </a:p>
          <a:p>
            <a:pPr marL="18415" algn="l" rtl="0" eaLnBrk="0">
              <a:lnSpc>
                <a:spcPts val="1225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ycle</a:t>
            </a:r>
            <a:r>
              <a:rPr sz="900" kern="0" spc="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events</a:t>
            </a:r>
            <a:r>
              <a:rPr sz="900" kern="0" spc="1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er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hannel</a:t>
            </a:r>
            <a:r>
              <a:rPr sz="900" kern="0" spc="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 406</a:t>
            </a:r>
            <a:endParaRPr lang="en-US" altLang="en-US" sz="900" dirty="0"/>
          </a:p>
          <a:p>
            <a:pPr marL="21590" algn="l" rtl="0" eaLnBrk="0">
              <a:lnSpc>
                <a:spcPct val="92000"/>
              </a:lnSpc>
              <a:spcBef>
                <a:spcPts val="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CS:</a:t>
            </a:r>
            <a:r>
              <a:rPr sz="900" kern="0" spc="10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9.315</a:t>
            </a:r>
            <a:endParaRPr lang="en-US" altLang="en-US" sz="900" dirty="0"/>
          </a:p>
        </p:txBody>
      </p:sp>
      <p:pic>
        <p:nvPicPr>
          <p:cNvPr id="28" name="picture 2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21600000">
            <a:off x="872645" y="7436918"/>
            <a:ext cx="1239083" cy="1301232"/>
          </a:xfrm>
          <a:prstGeom prst="rect">
            <a:avLst/>
          </a:prstGeom>
        </p:spPr>
      </p:pic>
      <p:pic>
        <p:nvPicPr>
          <p:cNvPr id="30" name="picture 3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21600000">
            <a:off x="5545751" y="7436918"/>
            <a:ext cx="1236350" cy="1301232"/>
          </a:xfrm>
          <a:prstGeom prst="rect">
            <a:avLst/>
          </a:prstGeom>
        </p:spPr>
      </p:pic>
      <p:pic>
        <p:nvPicPr>
          <p:cNvPr id="32" name="picture 3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21600000">
            <a:off x="3209198" y="7436918"/>
            <a:ext cx="1225214" cy="1301232"/>
          </a:xfrm>
          <a:prstGeom prst="rect">
            <a:avLst/>
          </a:prstGeom>
        </p:spPr>
      </p:pic>
      <p:sp>
        <p:nvSpPr>
          <p:cNvPr id="34" name="textbox 34"/>
          <p:cNvSpPr/>
          <p:nvPr/>
        </p:nvSpPr>
        <p:spPr>
          <a:xfrm>
            <a:off x="882499" y="4078020"/>
            <a:ext cx="3767454" cy="30352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lang="en-US" altLang="en-US" sz="100" dirty="0"/>
          </a:p>
          <a:p>
            <a:pPr marL="12700" algn="l" rtl="0" eaLnBrk="0">
              <a:lnSpc>
                <a:spcPct val="81000"/>
              </a:lnSpc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</a:t>
            </a:r>
            <a:r>
              <a:rPr sz="9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5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50                       200</a:t>
            </a:r>
            <a:endParaRPr lang="en-US" altLang="en-US" sz="900" dirty="0"/>
          </a:p>
          <a:p>
            <a:pPr algn="l" rtl="0" eaLnBrk="0">
              <a:lnSpc>
                <a:spcPct val="105000"/>
              </a:lnSpc>
            </a:pPr>
            <a:endParaRPr lang="en-US" altLang="en-US" sz="300" dirty="0"/>
          </a:p>
          <a:p>
            <a:pPr marL="1741170" algn="l" rtl="0" eaLnBrk="0">
              <a:lnSpc>
                <a:spcPct val="78000"/>
              </a:lnSpc>
              <a:spcBef>
                <a:spcPts val="0"/>
              </a:spcBef>
            </a:pPr>
            <a:r>
              <a:rPr sz="1000" kern="0" spc="-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I-A</a:t>
            </a:r>
            <a:endParaRPr lang="en-US" altLang="en-US" sz="1000" dirty="0"/>
          </a:p>
        </p:txBody>
      </p:sp>
      <p:sp>
        <p:nvSpPr>
          <p:cNvPr id="36" name="path"/>
          <p:cNvSpPr/>
          <p:nvPr/>
        </p:nvSpPr>
        <p:spPr>
          <a:xfrm>
            <a:off x="5766746" y="7963434"/>
            <a:ext cx="675964" cy="598187"/>
          </a:xfrm>
          <a:custGeom>
            <a:avLst/>
            <a:gdLst/>
            <a:ahLst/>
            <a:cxnLst/>
            <a:rect l="0" t="0" r="0" b="0"/>
            <a:pathLst>
              <a:path w="1064" h="942">
                <a:moveTo>
                  <a:pt x="928" y="21"/>
                </a:moveTo>
                <a:lnTo>
                  <a:pt x="986" y="72"/>
                </a:lnTo>
                <a:lnTo>
                  <a:pt x="1047" y="132"/>
                </a:lnTo>
                <a:moveTo>
                  <a:pt x="400" y="925"/>
                </a:moveTo>
                <a:lnTo>
                  <a:pt x="329" y="916"/>
                </a:lnTo>
                <a:lnTo>
                  <a:pt x="259" y="895"/>
                </a:lnTo>
                <a:lnTo>
                  <a:pt x="193" y="860"/>
                </a:lnTo>
                <a:lnTo>
                  <a:pt x="140" y="813"/>
                </a:lnTo>
                <a:lnTo>
                  <a:pt x="78" y="766"/>
                </a:lnTo>
                <a:lnTo>
                  <a:pt x="30" y="706"/>
                </a:lnTo>
                <a:lnTo>
                  <a:pt x="16" y="638"/>
                </a:lnTo>
                <a:lnTo>
                  <a:pt x="21" y="569"/>
                </a:lnTo>
                <a:lnTo>
                  <a:pt x="43" y="501"/>
                </a:lnTo>
                <a:lnTo>
                  <a:pt x="69" y="436"/>
                </a:lnTo>
                <a:lnTo>
                  <a:pt x="100" y="372"/>
                </a:lnTo>
                <a:lnTo>
                  <a:pt x="144" y="312"/>
                </a:lnTo>
                <a:lnTo>
                  <a:pt x="201" y="248"/>
                </a:lnTo>
                <a:lnTo>
                  <a:pt x="259" y="205"/>
                </a:lnTo>
                <a:lnTo>
                  <a:pt x="316" y="162"/>
                </a:lnTo>
                <a:lnTo>
                  <a:pt x="382" y="132"/>
                </a:lnTo>
                <a:lnTo>
                  <a:pt x="452" y="98"/>
                </a:lnTo>
                <a:lnTo>
                  <a:pt x="519" y="68"/>
                </a:lnTo>
                <a:lnTo>
                  <a:pt x="589" y="42"/>
                </a:lnTo>
                <a:lnTo>
                  <a:pt x="660" y="21"/>
                </a:lnTo>
                <a:lnTo>
                  <a:pt x="673" y="16"/>
                </a:lnTo>
                <a:lnTo>
                  <a:pt x="737" y="17"/>
                </a:lnTo>
                <a:lnTo>
                  <a:pt x="800" y="18"/>
                </a:lnTo>
                <a:lnTo>
                  <a:pt x="864" y="20"/>
                </a:lnTo>
                <a:lnTo>
                  <a:pt x="928" y="21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grpSp>
        <p:nvGrpSpPr>
          <p:cNvPr id="3" name="group 2"/>
          <p:cNvGrpSpPr/>
          <p:nvPr/>
        </p:nvGrpSpPr>
        <p:grpSpPr>
          <a:xfrm rot="21600000">
            <a:off x="758667" y="8053271"/>
            <a:ext cx="1059227" cy="327687"/>
            <a:chOff x="0" y="0"/>
            <a:chExt cx="1059227" cy="327687"/>
          </a:xfrm>
        </p:grpSpPr>
        <p:sp>
          <p:nvSpPr>
            <p:cNvPr id="38" name="path"/>
            <p:cNvSpPr/>
            <p:nvPr/>
          </p:nvSpPr>
          <p:spPr>
            <a:xfrm>
              <a:off x="0" y="0"/>
              <a:ext cx="121101" cy="327687"/>
            </a:xfrm>
            <a:custGeom>
              <a:avLst/>
              <a:gdLst/>
              <a:ahLst/>
              <a:cxnLst/>
              <a:rect l="0" t="0" r="0" b="0"/>
              <a:pathLst>
                <a:path w="190" h="516">
                  <a:moveTo>
                    <a:pt x="185" y="510"/>
                  </a:moveTo>
                  <a:lnTo>
                    <a:pt x="95" y="510"/>
                  </a:lnTo>
                  <a:moveTo>
                    <a:pt x="185" y="443"/>
                  </a:moveTo>
                  <a:lnTo>
                    <a:pt x="95" y="443"/>
                  </a:lnTo>
                  <a:moveTo>
                    <a:pt x="185" y="364"/>
                  </a:moveTo>
                  <a:lnTo>
                    <a:pt x="95" y="364"/>
                  </a:lnTo>
                  <a:moveTo>
                    <a:pt x="185" y="297"/>
                  </a:moveTo>
                  <a:lnTo>
                    <a:pt x="5" y="297"/>
                  </a:lnTo>
                  <a:moveTo>
                    <a:pt x="185" y="218"/>
                  </a:moveTo>
                  <a:lnTo>
                    <a:pt x="95" y="218"/>
                  </a:lnTo>
                  <a:moveTo>
                    <a:pt x="185" y="151"/>
                  </a:moveTo>
                  <a:lnTo>
                    <a:pt x="95" y="151"/>
                  </a:lnTo>
                  <a:moveTo>
                    <a:pt x="185" y="72"/>
                  </a:moveTo>
                  <a:lnTo>
                    <a:pt x="95" y="72"/>
                  </a:lnTo>
                  <a:moveTo>
                    <a:pt x="185" y="5"/>
                  </a:moveTo>
                  <a:lnTo>
                    <a:pt x="5" y="5"/>
                  </a:lnTo>
                </a:path>
              </a:pathLst>
            </a:custGeom>
            <a:noFill/>
            <a:ln w="7123" cap="sq">
              <a:solidFill>
                <a:srgbClr val="000000">
                  <a:alpha val="100000"/>
                </a:srgbClr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40" name="path"/>
            <p:cNvSpPr/>
            <p:nvPr/>
          </p:nvSpPr>
          <p:spPr>
            <a:xfrm>
              <a:off x="407932" y="382"/>
              <a:ext cx="651294" cy="325403"/>
            </a:xfrm>
            <a:custGeom>
              <a:avLst/>
              <a:gdLst/>
              <a:ahLst/>
              <a:cxnLst/>
              <a:rect l="0" t="0" r="0" b="0"/>
              <a:pathLst>
                <a:path w="1025" h="512">
                  <a:moveTo>
                    <a:pt x="663" y="35"/>
                  </a:moveTo>
                  <a:lnTo>
                    <a:pt x="732" y="25"/>
                  </a:lnTo>
                  <a:lnTo>
                    <a:pt x="822" y="16"/>
                  </a:lnTo>
                  <a:lnTo>
                    <a:pt x="902" y="20"/>
                  </a:lnTo>
                  <a:lnTo>
                    <a:pt x="964" y="42"/>
                  </a:lnTo>
                  <a:lnTo>
                    <a:pt x="995" y="96"/>
                  </a:lnTo>
                  <a:lnTo>
                    <a:pt x="1008" y="159"/>
                  </a:lnTo>
                  <a:lnTo>
                    <a:pt x="1006" y="225"/>
                  </a:lnTo>
                  <a:lnTo>
                    <a:pt x="962" y="281"/>
                  </a:lnTo>
                  <a:lnTo>
                    <a:pt x="904" y="320"/>
                  </a:lnTo>
                  <a:lnTo>
                    <a:pt x="849" y="350"/>
                  </a:lnTo>
                  <a:lnTo>
                    <a:pt x="782" y="375"/>
                  </a:lnTo>
                  <a:lnTo>
                    <a:pt x="709" y="397"/>
                  </a:lnTo>
                  <a:lnTo>
                    <a:pt x="626" y="420"/>
                  </a:lnTo>
                  <a:lnTo>
                    <a:pt x="557" y="441"/>
                  </a:lnTo>
                  <a:lnTo>
                    <a:pt x="493" y="458"/>
                  </a:lnTo>
                  <a:lnTo>
                    <a:pt x="432" y="474"/>
                  </a:lnTo>
                  <a:lnTo>
                    <a:pt x="366" y="484"/>
                  </a:lnTo>
                  <a:lnTo>
                    <a:pt x="296" y="493"/>
                  </a:lnTo>
                  <a:lnTo>
                    <a:pt x="229" y="495"/>
                  </a:lnTo>
                  <a:lnTo>
                    <a:pt x="160" y="486"/>
                  </a:lnTo>
                  <a:lnTo>
                    <a:pt x="99" y="471"/>
                  </a:lnTo>
                  <a:lnTo>
                    <a:pt x="49" y="424"/>
                  </a:lnTo>
                  <a:lnTo>
                    <a:pt x="21" y="367"/>
                  </a:lnTo>
                  <a:lnTo>
                    <a:pt x="16" y="306"/>
                  </a:lnTo>
                  <a:lnTo>
                    <a:pt x="47" y="241"/>
                  </a:lnTo>
                  <a:lnTo>
                    <a:pt x="100" y="195"/>
                  </a:lnTo>
                  <a:lnTo>
                    <a:pt x="154" y="160"/>
                  </a:lnTo>
                  <a:lnTo>
                    <a:pt x="222" y="135"/>
                  </a:lnTo>
                  <a:lnTo>
                    <a:pt x="286" y="111"/>
                  </a:lnTo>
                  <a:lnTo>
                    <a:pt x="347" y="98"/>
                  </a:lnTo>
                  <a:lnTo>
                    <a:pt x="410" y="86"/>
                  </a:lnTo>
                  <a:lnTo>
                    <a:pt x="473" y="73"/>
                  </a:lnTo>
                  <a:lnTo>
                    <a:pt x="536" y="60"/>
                  </a:lnTo>
                  <a:lnTo>
                    <a:pt x="599" y="48"/>
                  </a:lnTo>
                  <a:lnTo>
                    <a:pt x="663" y="35"/>
                  </a:lnTo>
                </a:path>
              </a:pathLst>
            </a:custGeom>
            <a:noFill/>
            <a:ln w="21370" cap="sq">
              <a:solidFill>
                <a:srgbClr val="000000">
                  <a:alpha val="100000"/>
                </a:srgbClr>
              </a:solidFill>
              <a:prstDash val="solid"/>
              <a:miter lim="1000000"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</p:grpSp>
      <p:sp>
        <p:nvSpPr>
          <p:cNvPr id="42" name="textbox 42"/>
          <p:cNvSpPr/>
          <p:nvPr/>
        </p:nvSpPr>
        <p:spPr>
          <a:xfrm>
            <a:off x="846353" y="8760429"/>
            <a:ext cx="1303019" cy="287020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lang="en-US" altLang="en-US" sz="100" dirty="0"/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lang="en-US" altLang="en-US" sz="700" dirty="0"/>
          </a:p>
          <a:p>
            <a:pPr algn="l" rtl="0" eaLnBrk="0">
              <a:lnSpc>
                <a:spcPct val="148000"/>
              </a:lnSpc>
            </a:pPr>
            <a:endParaRPr lang="en-US" altLang="en-US" sz="200" dirty="0"/>
          </a:p>
          <a:p>
            <a:pPr marL="47371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A</a:t>
            </a:r>
            <a:endParaRPr lang="en-US" altLang="en-US" sz="1000" dirty="0"/>
          </a:p>
        </p:txBody>
      </p:sp>
      <p:sp>
        <p:nvSpPr>
          <p:cNvPr id="44" name="textbox 44"/>
          <p:cNvSpPr/>
          <p:nvPr/>
        </p:nvSpPr>
        <p:spPr>
          <a:xfrm>
            <a:off x="3182906" y="8760429"/>
            <a:ext cx="1303019" cy="287020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lang="en-US" altLang="en-US" sz="100" dirty="0"/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lang="en-US" altLang="en-US" sz="700" dirty="0"/>
          </a:p>
          <a:p>
            <a:pPr algn="l" rtl="0" eaLnBrk="0">
              <a:lnSpc>
                <a:spcPct val="148000"/>
              </a:lnSpc>
            </a:pPr>
            <a:endParaRPr lang="en-US" altLang="en-US" sz="200" dirty="0"/>
          </a:p>
          <a:p>
            <a:pPr marL="47371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A</a:t>
            </a:r>
            <a:endParaRPr lang="en-US" altLang="en-US" sz="1000" dirty="0"/>
          </a:p>
        </p:txBody>
      </p:sp>
      <p:sp>
        <p:nvSpPr>
          <p:cNvPr id="46" name="textbox 46"/>
          <p:cNvSpPr/>
          <p:nvPr/>
        </p:nvSpPr>
        <p:spPr>
          <a:xfrm>
            <a:off x="5519459" y="8760429"/>
            <a:ext cx="1303019" cy="287654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lang="en-US" altLang="en-US" sz="100" dirty="0"/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lang="en-US" altLang="en-US" sz="700" dirty="0"/>
          </a:p>
          <a:p>
            <a:pPr algn="l" rtl="0" eaLnBrk="0">
              <a:lnSpc>
                <a:spcPct val="102000"/>
              </a:lnSpc>
            </a:pPr>
            <a:endParaRPr lang="en-US" altLang="en-US" sz="300" dirty="0"/>
          </a:p>
          <a:p>
            <a:pPr marL="537845" algn="l" rtl="0" eaLnBrk="0">
              <a:lnSpc>
                <a:spcPct val="78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I-A</a:t>
            </a:r>
            <a:endParaRPr lang="en-US" altLang="en-US" sz="1000" dirty="0"/>
          </a:p>
        </p:txBody>
      </p:sp>
      <p:grpSp>
        <p:nvGrpSpPr>
          <p:cNvPr id="5" name="group 4"/>
          <p:cNvGrpSpPr/>
          <p:nvPr/>
        </p:nvGrpSpPr>
        <p:grpSpPr>
          <a:xfrm rot="21600000">
            <a:off x="3095220" y="8053271"/>
            <a:ext cx="1097580" cy="266195"/>
            <a:chOff x="0" y="0"/>
            <a:chExt cx="1097580" cy="266195"/>
          </a:xfrm>
        </p:grpSpPr>
        <p:sp>
          <p:nvSpPr>
            <p:cNvPr id="48" name="path"/>
            <p:cNvSpPr/>
            <p:nvPr/>
          </p:nvSpPr>
          <p:spPr>
            <a:xfrm>
              <a:off x="0" y="0"/>
              <a:ext cx="121101" cy="235080"/>
            </a:xfrm>
            <a:custGeom>
              <a:avLst/>
              <a:gdLst/>
              <a:ahLst/>
              <a:cxnLst/>
              <a:rect l="0" t="0" r="0" b="0"/>
              <a:pathLst>
                <a:path w="190" h="370">
                  <a:moveTo>
                    <a:pt x="185" y="364"/>
                  </a:moveTo>
                  <a:lnTo>
                    <a:pt x="95" y="364"/>
                  </a:lnTo>
                  <a:moveTo>
                    <a:pt x="185" y="297"/>
                  </a:moveTo>
                  <a:lnTo>
                    <a:pt x="5" y="297"/>
                  </a:lnTo>
                  <a:moveTo>
                    <a:pt x="185" y="218"/>
                  </a:moveTo>
                  <a:lnTo>
                    <a:pt x="95" y="218"/>
                  </a:lnTo>
                  <a:moveTo>
                    <a:pt x="185" y="151"/>
                  </a:moveTo>
                  <a:lnTo>
                    <a:pt x="95" y="151"/>
                  </a:lnTo>
                  <a:moveTo>
                    <a:pt x="185" y="72"/>
                  </a:moveTo>
                  <a:lnTo>
                    <a:pt x="95" y="72"/>
                  </a:lnTo>
                  <a:moveTo>
                    <a:pt x="185" y="5"/>
                  </a:moveTo>
                  <a:lnTo>
                    <a:pt x="5" y="5"/>
                  </a:lnTo>
                </a:path>
              </a:pathLst>
            </a:custGeom>
            <a:noFill/>
            <a:ln w="7123" cap="sq">
              <a:solidFill>
                <a:srgbClr val="000000">
                  <a:alpha val="100000"/>
                </a:srgbClr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50" name="path"/>
            <p:cNvSpPr/>
            <p:nvPr/>
          </p:nvSpPr>
          <p:spPr>
            <a:xfrm>
              <a:off x="418818" y="8112"/>
              <a:ext cx="678762" cy="258083"/>
            </a:xfrm>
            <a:custGeom>
              <a:avLst/>
              <a:gdLst/>
              <a:ahLst/>
              <a:cxnLst/>
              <a:rect l="0" t="0" r="0" b="0"/>
              <a:pathLst>
                <a:path w="1068" h="406">
                  <a:moveTo>
                    <a:pt x="1016" y="76"/>
                  </a:moveTo>
                  <a:lnTo>
                    <a:pt x="1038" y="153"/>
                  </a:lnTo>
                  <a:lnTo>
                    <a:pt x="1052" y="222"/>
                  </a:lnTo>
                  <a:lnTo>
                    <a:pt x="1052" y="267"/>
                  </a:lnTo>
                  <a:lnTo>
                    <a:pt x="1052" y="312"/>
                  </a:lnTo>
                  <a:lnTo>
                    <a:pt x="1047" y="389"/>
                  </a:lnTo>
                  <a:moveTo>
                    <a:pt x="16" y="381"/>
                  </a:moveTo>
                  <a:lnTo>
                    <a:pt x="60" y="312"/>
                  </a:lnTo>
                  <a:lnTo>
                    <a:pt x="104" y="256"/>
                  </a:lnTo>
                  <a:lnTo>
                    <a:pt x="157" y="205"/>
                  </a:lnTo>
                  <a:lnTo>
                    <a:pt x="228" y="145"/>
                  </a:lnTo>
                  <a:lnTo>
                    <a:pt x="294" y="102"/>
                  </a:lnTo>
                  <a:lnTo>
                    <a:pt x="360" y="68"/>
                  </a:lnTo>
                  <a:lnTo>
                    <a:pt x="426" y="38"/>
                  </a:lnTo>
                  <a:lnTo>
                    <a:pt x="514" y="21"/>
                  </a:lnTo>
                  <a:lnTo>
                    <a:pt x="593" y="16"/>
                  </a:lnTo>
                  <a:lnTo>
                    <a:pt x="664" y="16"/>
                  </a:lnTo>
                  <a:lnTo>
                    <a:pt x="739" y="21"/>
                  </a:lnTo>
                  <a:lnTo>
                    <a:pt x="765" y="25"/>
                  </a:lnTo>
                  <a:lnTo>
                    <a:pt x="828" y="38"/>
                  </a:lnTo>
                  <a:lnTo>
                    <a:pt x="891" y="51"/>
                  </a:lnTo>
                  <a:lnTo>
                    <a:pt x="954" y="63"/>
                  </a:lnTo>
                  <a:lnTo>
                    <a:pt x="1016" y="76"/>
                  </a:lnTo>
                </a:path>
              </a:pathLst>
            </a:custGeom>
            <a:noFill/>
            <a:ln w="21370" cap="sq">
              <a:solidFill>
                <a:srgbClr val="000000">
                  <a:alpha val="100000"/>
                </a:srgbClr>
              </a:solidFill>
              <a:prstDash val="solid"/>
              <a:miter lim="1000000"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</p:grpSp>
      <p:sp>
        <p:nvSpPr>
          <p:cNvPr id="52" name="textbox 52"/>
          <p:cNvSpPr/>
          <p:nvPr/>
        </p:nvSpPr>
        <p:spPr>
          <a:xfrm rot="16200000">
            <a:off x="-952306" y="2214200"/>
            <a:ext cx="3289934" cy="162560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26000"/>
              </a:lnSpc>
            </a:pPr>
            <a:endParaRPr lang="en-US" altLang="en-US" sz="200" dirty="0"/>
          </a:p>
          <a:p>
            <a:pPr marL="12700" algn="l" rtl="0" eaLnBrk="0">
              <a:lnSpc>
                <a:spcPct val="81000"/>
              </a:lnSpc>
              <a:spcBef>
                <a:spcPts val="0"/>
              </a:spcBef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5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0</a:t>
            </a:r>
            <a:r>
              <a:rPr sz="900" kern="0" spc="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5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00</a:t>
            </a:r>
            <a:r>
              <a:rPr sz="900" kern="0" spc="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5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00</a:t>
            </a:r>
            <a:r>
              <a:rPr sz="900" kern="0" spc="-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endParaRPr lang="en-US" altLang="en-US" sz="900" dirty="0"/>
          </a:p>
        </p:txBody>
      </p:sp>
      <p:sp>
        <p:nvSpPr>
          <p:cNvPr id="54" name="path"/>
          <p:cNvSpPr/>
          <p:nvPr/>
        </p:nvSpPr>
        <p:spPr>
          <a:xfrm>
            <a:off x="3650863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6" name="path"/>
          <p:cNvSpPr/>
          <p:nvPr/>
        </p:nvSpPr>
        <p:spPr>
          <a:xfrm>
            <a:off x="3259063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8" name="path"/>
          <p:cNvSpPr/>
          <p:nvPr/>
        </p:nvSpPr>
        <p:spPr>
          <a:xfrm>
            <a:off x="3843202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0" name="path"/>
          <p:cNvSpPr/>
          <p:nvPr/>
        </p:nvSpPr>
        <p:spPr>
          <a:xfrm>
            <a:off x="4042664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51" y="5"/>
                </a:moveTo>
                <a:lnTo>
                  <a:pt x="151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2" name="path"/>
          <p:cNvSpPr/>
          <p:nvPr/>
        </p:nvSpPr>
        <p:spPr>
          <a:xfrm>
            <a:off x="4235002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4" name="path"/>
          <p:cNvSpPr/>
          <p:nvPr/>
        </p:nvSpPr>
        <p:spPr>
          <a:xfrm>
            <a:off x="3451402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6" name="path"/>
          <p:cNvSpPr/>
          <p:nvPr/>
        </p:nvSpPr>
        <p:spPr>
          <a:xfrm>
            <a:off x="3209198" y="8608915"/>
            <a:ext cx="1239512" cy="64112"/>
          </a:xfrm>
          <a:custGeom>
            <a:avLst/>
            <a:gdLst/>
            <a:ahLst/>
            <a:cxnLst/>
            <a:rect l="0" t="0" r="0" b="0"/>
            <a:pathLst>
              <a:path w="1951" h="100">
                <a:moveTo>
                  <a:pt x="1935" y="5"/>
                </a:moveTo>
                <a:lnTo>
                  <a:pt x="1935" y="95"/>
                </a:lnTo>
                <a:moveTo>
                  <a:pt x="5" y="5"/>
                </a:moveTo>
                <a:lnTo>
                  <a:pt x="1946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8" name="path"/>
          <p:cNvSpPr/>
          <p:nvPr/>
        </p:nvSpPr>
        <p:spPr>
          <a:xfrm>
            <a:off x="3472077" y="8292655"/>
            <a:ext cx="505323" cy="323383"/>
          </a:xfrm>
          <a:custGeom>
            <a:avLst/>
            <a:gdLst/>
            <a:ahLst/>
            <a:cxnLst/>
            <a:rect l="0" t="0" r="0" b="0"/>
            <a:pathLst>
              <a:path w="795" h="509">
                <a:moveTo>
                  <a:pt x="778" y="436"/>
                </a:moveTo>
                <a:lnTo>
                  <a:pt x="699" y="466"/>
                </a:lnTo>
                <a:lnTo>
                  <a:pt x="615" y="479"/>
                </a:lnTo>
                <a:moveTo>
                  <a:pt x="474" y="488"/>
                </a:moveTo>
                <a:lnTo>
                  <a:pt x="400" y="492"/>
                </a:lnTo>
                <a:lnTo>
                  <a:pt x="325" y="492"/>
                </a:lnTo>
                <a:moveTo>
                  <a:pt x="254" y="492"/>
                </a:moveTo>
                <a:lnTo>
                  <a:pt x="175" y="466"/>
                </a:lnTo>
                <a:moveTo>
                  <a:pt x="47" y="385"/>
                </a:moveTo>
                <a:lnTo>
                  <a:pt x="21" y="303"/>
                </a:lnTo>
                <a:lnTo>
                  <a:pt x="16" y="231"/>
                </a:lnTo>
                <a:moveTo>
                  <a:pt x="38" y="89"/>
                </a:moveTo>
                <a:lnTo>
                  <a:pt x="82" y="16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0" name="path"/>
          <p:cNvSpPr/>
          <p:nvPr/>
        </p:nvSpPr>
        <p:spPr>
          <a:xfrm>
            <a:off x="3491659" y="8406930"/>
            <a:ext cx="659180" cy="209108"/>
          </a:xfrm>
          <a:custGeom>
            <a:avLst/>
            <a:gdLst/>
            <a:ahLst/>
            <a:cxnLst/>
            <a:rect l="0" t="0" r="0" b="0"/>
            <a:pathLst>
              <a:path w="1038" h="329">
                <a:moveTo>
                  <a:pt x="1021" y="16"/>
                </a:moveTo>
                <a:lnTo>
                  <a:pt x="981" y="81"/>
                </a:lnTo>
                <a:lnTo>
                  <a:pt x="928" y="132"/>
                </a:lnTo>
                <a:lnTo>
                  <a:pt x="875" y="179"/>
                </a:lnTo>
                <a:lnTo>
                  <a:pt x="809" y="222"/>
                </a:lnTo>
                <a:lnTo>
                  <a:pt x="748" y="256"/>
                </a:lnTo>
                <a:moveTo>
                  <a:pt x="585" y="299"/>
                </a:moveTo>
                <a:lnTo>
                  <a:pt x="514" y="308"/>
                </a:lnTo>
                <a:lnTo>
                  <a:pt x="444" y="308"/>
                </a:lnTo>
                <a:moveTo>
                  <a:pt x="294" y="312"/>
                </a:moveTo>
                <a:lnTo>
                  <a:pt x="223" y="312"/>
                </a:lnTo>
                <a:moveTo>
                  <a:pt x="144" y="286"/>
                </a:moveTo>
                <a:lnTo>
                  <a:pt x="74" y="256"/>
                </a:lnTo>
                <a:lnTo>
                  <a:pt x="16" y="205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2" name="textbox 72"/>
          <p:cNvSpPr/>
          <p:nvPr/>
        </p:nvSpPr>
        <p:spPr>
          <a:xfrm>
            <a:off x="468099" y="9566299"/>
            <a:ext cx="949325" cy="16128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lang="en-US" altLang="en-US" sz="100" dirty="0"/>
          </a:p>
          <a:p>
            <a:pPr marL="12700" algn="l" rtl="0" eaLnBrk="0">
              <a:lnSpc>
                <a:spcPts val="1065"/>
              </a:lnSpc>
            </a:pPr>
            <a:r>
              <a:rPr sz="800" kern="0" spc="-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Fit</a:t>
            </a:r>
            <a:r>
              <a:rPr sz="8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800" kern="0" spc="-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LTV4.1.</a:t>
            </a:r>
            <a:r>
              <a:rPr sz="8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(Win)</a:t>
            </a:r>
            <a:endParaRPr lang="en-US" altLang="en-US" sz="800" dirty="0"/>
          </a:p>
        </p:txBody>
      </p:sp>
      <p:sp>
        <p:nvSpPr>
          <p:cNvPr id="74" name="textbox 74"/>
          <p:cNvSpPr/>
          <p:nvPr/>
        </p:nvSpPr>
        <p:spPr>
          <a:xfrm rot="16200000">
            <a:off x="2389390" y="7948715"/>
            <a:ext cx="1245869" cy="141604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lang="en-US" altLang="en-US" sz="200" dirty="0"/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lang="en-US" altLang="en-US" sz="700" dirty="0"/>
          </a:p>
        </p:txBody>
      </p:sp>
      <p:sp>
        <p:nvSpPr>
          <p:cNvPr id="76" name="textbox 76"/>
          <p:cNvSpPr/>
          <p:nvPr/>
        </p:nvSpPr>
        <p:spPr>
          <a:xfrm rot="16200000">
            <a:off x="52837" y="7948715"/>
            <a:ext cx="1245869" cy="141604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lang="en-US" altLang="en-US" sz="200" dirty="0"/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lang="en-US" altLang="en-US" sz="700" dirty="0"/>
          </a:p>
        </p:txBody>
      </p:sp>
      <p:sp>
        <p:nvSpPr>
          <p:cNvPr id="78" name="textbox 78"/>
          <p:cNvSpPr/>
          <p:nvPr/>
        </p:nvSpPr>
        <p:spPr>
          <a:xfrm rot="16200000">
            <a:off x="4725942" y="7948715"/>
            <a:ext cx="1245869" cy="141604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lang="en-US" altLang="en-US" sz="200" dirty="0"/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lang="en-US" altLang="en-US" sz="700" dirty="0"/>
          </a:p>
        </p:txBody>
      </p:sp>
      <p:sp>
        <p:nvSpPr>
          <p:cNvPr id="80" name="path"/>
          <p:cNvSpPr/>
          <p:nvPr/>
        </p:nvSpPr>
        <p:spPr>
          <a:xfrm>
            <a:off x="9225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2" name="path"/>
          <p:cNvSpPr/>
          <p:nvPr/>
        </p:nvSpPr>
        <p:spPr>
          <a:xfrm>
            <a:off x="17061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51" y="5"/>
                </a:moveTo>
                <a:lnTo>
                  <a:pt x="151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4" name="path"/>
          <p:cNvSpPr/>
          <p:nvPr/>
        </p:nvSpPr>
        <p:spPr>
          <a:xfrm>
            <a:off x="1898449" y="8608915"/>
            <a:ext cx="156720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6" name="path"/>
          <p:cNvSpPr/>
          <p:nvPr/>
        </p:nvSpPr>
        <p:spPr>
          <a:xfrm>
            <a:off x="1114849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8" name="path"/>
          <p:cNvSpPr/>
          <p:nvPr/>
        </p:nvSpPr>
        <p:spPr>
          <a:xfrm>
            <a:off x="13143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0" name="path"/>
          <p:cNvSpPr/>
          <p:nvPr/>
        </p:nvSpPr>
        <p:spPr>
          <a:xfrm>
            <a:off x="1506649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2" name="path"/>
          <p:cNvSpPr/>
          <p:nvPr/>
        </p:nvSpPr>
        <p:spPr>
          <a:xfrm>
            <a:off x="872645" y="8608915"/>
            <a:ext cx="1239512" cy="64112"/>
          </a:xfrm>
          <a:custGeom>
            <a:avLst/>
            <a:gdLst/>
            <a:ahLst/>
            <a:cxnLst/>
            <a:rect l="0" t="0" r="0" b="0"/>
            <a:pathLst>
              <a:path w="1951" h="100">
                <a:moveTo>
                  <a:pt x="1935" y="5"/>
                </a:moveTo>
                <a:lnTo>
                  <a:pt x="1935" y="95"/>
                </a:lnTo>
                <a:moveTo>
                  <a:pt x="5" y="5"/>
                </a:moveTo>
                <a:lnTo>
                  <a:pt x="1946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4" name="path"/>
          <p:cNvSpPr/>
          <p:nvPr/>
        </p:nvSpPr>
        <p:spPr>
          <a:xfrm>
            <a:off x="6179754" y="8608915"/>
            <a:ext cx="156720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6" name="path"/>
          <p:cNvSpPr/>
          <p:nvPr/>
        </p:nvSpPr>
        <p:spPr>
          <a:xfrm>
            <a:off x="5595616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8" name="path"/>
          <p:cNvSpPr/>
          <p:nvPr/>
        </p:nvSpPr>
        <p:spPr>
          <a:xfrm>
            <a:off x="6379216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51" y="5"/>
                </a:moveTo>
                <a:lnTo>
                  <a:pt x="151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0" name="path"/>
          <p:cNvSpPr/>
          <p:nvPr/>
        </p:nvSpPr>
        <p:spPr>
          <a:xfrm>
            <a:off x="5787955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2" name="path"/>
          <p:cNvSpPr/>
          <p:nvPr/>
        </p:nvSpPr>
        <p:spPr>
          <a:xfrm>
            <a:off x="5987417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4" name="path"/>
          <p:cNvSpPr/>
          <p:nvPr/>
        </p:nvSpPr>
        <p:spPr>
          <a:xfrm>
            <a:off x="6571555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6" name="path"/>
          <p:cNvSpPr/>
          <p:nvPr/>
        </p:nvSpPr>
        <p:spPr>
          <a:xfrm>
            <a:off x="5545751" y="8608915"/>
            <a:ext cx="1239512" cy="64112"/>
          </a:xfrm>
          <a:custGeom>
            <a:avLst/>
            <a:gdLst/>
            <a:ahLst/>
            <a:cxnLst/>
            <a:rect l="0" t="0" r="0" b="0"/>
            <a:pathLst>
              <a:path w="1951" h="100">
                <a:moveTo>
                  <a:pt x="1935" y="5"/>
                </a:moveTo>
                <a:lnTo>
                  <a:pt x="1935" y="95"/>
                </a:lnTo>
                <a:moveTo>
                  <a:pt x="5" y="5"/>
                </a:moveTo>
                <a:lnTo>
                  <a:pt x="1946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8" name="path"/>
          <p:cNvSpPr/>
          <p:nvPr/>
        </p:nvSpPr>
        <p:spPr>
          <a:xfrm>
            <a:off x="758667" y="8608915"/>
            <a:ext cx="121101" cy="7123"/>
          </a:xfrm>
          <a:custGeom>
            <a:avLst/>
            <a:gdLst/>
            <a:ahLst/>
            <a:cxnLst/>
            <a:rect l="0" t="0" r="0" b="0"/>
            <a:pathLst>
              <a:path w="190" h="11"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10" name="path"/>
          <p:cNvSpPr/>
          <p:nvPr/>
        </p:nvSpPr>
        <p:spPr>
          <a:xfrm>
            <a:off x="758667" y="8423700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12" name="path"/>
          <p:cNvSpPr/>
          <p:nvPr/>
        </p:nvSpPr>
        <p:spPr>
          <a:xfrm>
            <a:off x="758667" y="7675719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14" name="path"/>
          <p:cNvSpPr/>
          <p:nvPr/>
        </p:nvSpPr>
        <p:spPr>
          <a:xfrm>
            <a:off x="758667" y="7860933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62"/>
                </a:moveTo>
                <a:lnTo>
                  <a:pt x="95" y="162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16" name="path"/>
          <p:cNvSpPr/>
          <p:nvPr/>
        </p:nvSpPr>
        <p:spPr>
          <a:xfrm>
            <a:off x="758667" y="7490504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18" name="path"/>
          <p:cNvSpPr/>
          <p:nvPr/>
        </p:nvSpPr>
        <p:spPr>
          <a:xfrm>
            <a:off x="815656" y="7426391"/>
            <a:ext cx="64112" cy="1189647"/>
          </a:xfrm>
          <a:custGeom>
            <a:avLst/>
            <a:gdLst/>
            <a:ahLst/>
            <a:cxnLst/>
            <a:rect l="0" t="0" r="0" b="0"/>
            <a:pathLst>
              <a:path w="100" h="1873">
                <a:moveTo>
                  <a:pt x="95" y="39"/>
                </a:moveTo>
                <a:lnTo>
                  <a:pt x="5" y="39"/>
                </a:lnTo>
                <a:moveTo>
                  <a:pt x="95" y="1867"/>
                </a:moveTo>
                <a:lnTo>
                  <a:pt x="9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20" name="path"/>
          <p:cNvSpPr/>
          <p:nvPr/>
        </p:nvSpPr>
        <p:spPr>
          <a:xfrm>
            <a:off x="3095220" y="7860933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62"/>
                </a:moveTo>
                <a:lnTo>
                  <a:pt x="95" y="162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22" name="path"/>
          <p:cNvSpPr/>
          <p:nvPr/>
        </p:nvSpPr>
        <p:spPr>
          <a:xfrm>
            <a:off x="3095220" y="8608915"/>
            <a:ext cx="121101" cy="7123"/>
          </a:xfrm>
          <a:custGeom>
            <a:avLst/>
            <a:gdLst/>
            <a:ahLst/>
            <a:cxnLst/>
            <a:rect l="0" t="0" r="0" b="0"/>
            <a:pathLst>
              <a:path w="190" h="11"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24" name="path"/>
          <p:cNvSpPr/>
          <p:nvPr/>
        </p:nvSpPr>
        <p:spPr>
          <a:xfrm>
            <a:off x="3152209" y="8331093"/>
            <a:ext cx="64112" cy="49865"/>
          </a:xfrm>
          <a:custGeom>
            <a:avLst/>
            <a:gdLst/>
            <a:ahLst/>
            <a:cxnLst/>
            <a:rect l="0" t="0" r="0" b="0"/>
            <a:pathLst>
              <a:path w="100" h="78">
                <a:moveTo>
                  <a:pt x="95" y="72"/>
                </a:moveTo>
                <a:lnTo>
                  <a:pt x="5" y="72"/>
                </a:lnTo>
                <a:moveTo>
                  <a:pt x="9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26" name="path"/>
          <p:cNvSpPr/>
          <p:nvPr/>
        </p:nvSpPr>
        <p:spPr>
          <a:xfrm>
            <a:off x="3095220" y="8423700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28" name="path"/>
          <p:cNvSpPr/>
          <p:nvPr/>
        </p:nvSpPr>
        <p:spPr>
          <a:xfrm>
            <a:off x="3095220" y="7675719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30" name="path"/>
          <p:cNvSpPr/>
          <p:nvPr/>
        </p:nvSpPr>
        <p:spPr>
          <a:xfrm>
            <a:off x="3095220" y="7490504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32" name="path"/>
          <p:cNvSpPr/>
          <p:nvPr/>
        </p:nvSpPr>
        <p:spPr>
          <a:xfrm>
            <a:off x="3152209" y="7426391"/>
            <a:ext cx="64112" cy="1189647"/>
          </a:xfrm>
          <a:custGeom>
            <a:avLst/>
            <a:gdLst/>
            <a:ahLst/>
            <a:cxnLst/>
            <a:rect l="0" t="0" r="0" b="0"/>
            <a:pathLst>
              <a:path w="100" h="1873">
                <a:moveTo>
                  <a:pt x="95" y="39"/>
                </a:moveTo>
                <a:lnTo>
                  <a:pt x="5" y="39"/>
                </a:lnTo>
                <a:moveTo>
                  <a:pt x="95" y="1867"/>
                </a:moveTo>
                <a:lnTo>
                  <a:pt x="9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34" name="textbox 134"/>
          <p:cNvSpPr/>
          <p:nvPr/>
        </p:nvSpPr>
        <p:spPr>
          <a:xfrm>
            <a:off x="3991524" y="454610"/>
            <a:ext cx="309245" cy="286384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4000"/>
              </a:lnSpc>
            </a:pPr>
            <a:endParaRPr lang="en-US" altLang="en-US" sz="100" dirty="0"/>
          </a:p>
          <a:p>
            <a:pPr marL="12700" algn="l" rtl="0" eaLnBrk="0">
              <a:lnSpc>
                <a:spcPct val="122000"/>
              </a:lnSpc>
            </a:pP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</a:t>
            </a:r>
            <a:endParaRPr lang="en-US" altLang="en-US" sz="700" dirty="0"/>
          </a:p>
        </p:txBody>
      </p:sp>
      <p:sp>
        <p:nvSpPr>
          <p:cNvPr id="136" name="path"/>
          <p:cNvSpPr/>
          <p:nvPr/>
        </p:nvSpPr>
        <p:spPr>
          <a:xfrm>
            <a:off x="6203142" y="8289934"/>
            <a:ext cx="270340" cy="247200"/>
          </a:xfrm>
          <a:custGeom>
            <a:avLst/>
            <a:gdLst/>
            <a:ahLst/>
            <a:cxnLst/>
            <a:rect l="0" t="0" r="0" b="0"/>
            <a:pathLst>
              <a:path w="425" h="389">
                <a:moveTo>
                  <a:pt x="408" y="16"/>
                </a:moveTo>
                <a:lnTo>
                  <a:pt x="364" y="76"/>
                </a:lnTo>
                <a:lnTo>
                  <a:pt x="311" y="128"/>
                </a:lnTo>
                <a:lnTo>
                  <a:pt x="254" y="188"/>
                </a:lnTo>
                <a:lnTo>
                  <a:pt x="193" y="243"/>
                </a:lnTo>
                <a:lnTo>
                  <a:pt x="135" y="291"/>
                </a:lnTo>
                <a:lnTo>
                  <a:pt x="78" y="333"/>
                </a:lnTo>
                <a:lnTo>
                  <a:pt x="16" y="372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38" name="textbox 138"/>
          <p:cNvSpPr/>
          <p:nvPr/>
        </p:nvSpPr>
        <p:spPr>
          <a:xfrm rot="16200000">
            <a:off x="310755" y="2249794"/>
            <a:ext cx="421640" cy="18668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lang="en-US" altLang="en-US" sz="100" dirty="0"/>
          </a:p>
          <a:p>
            <a:pPr marL="12700" algn="l" rtl="0" eaLnBrk="0">
              <a:lnSpc>
                <a:spcPts val="1270"/>
              </a:lnSpc>
            </a:pPr>
            <a:r>
              <a:rPr sz="900" kern="0" spc="-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umber</a:t>
            </a:r>
            <a:endParaRPr lang="en-US" altLang="en-US" sz="900" dirty="0"/>
          </a:p>
        </p:txBody>
      </p:sp>
      <p:sp>
        <p:nvSpPr>
          <p:cNvPr id="140" name="path"/>
          <p:cNvSpPr/>
          <p:nvPr/>
        </p:nvSpPr>
        <p:spPr>
          <a:xfrm>
            <a:off x="787161" y="2860140"/>
            <a:ext cx="135349" cy="427418"/>
          </a:xfrm>
          <a:custGeom>
            <a:avLst/>
            <a:gdLst/>
            <a:ahLst/>
            <a:cxnLst/>
            <a:rect l="0" t="0" r="0" b="0"/>
            <a:pathLst>
              <a:path w="213" h="673">
                <a:moveTo>
                  <a:pt x="207" y="667"/>
                </a:moveTo>
                <a:lnTo>
                  <a:pt x="106" y="667"/>
                </a:lnTo>
                <a:moveTo>
                  <a:pt x="207" y="499"/>
                </a:moveTo>
                <a:lnTo>
                  <a:pt x="106" y="499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73"/>
                </a:moveTo>
                <a:lnTo>
                  <a:pt x="106" y="173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42" name="path"/>
          <p:cNvSpPr/>
          <p:nvPr/>
        </p:nvSpPr>
        <p:spPr>
          <a:xfrm>
            <a:off x="5431773" y="7447762"/>
            <a:ext cx="121101" cy="470159"/>
          </a:xfrm>
          <a:custGeom>
            <a:avLst/>
            <a:gdLst/>
            <a:ahLst/>
            <a:cxnLst/>
            <a:rect l="0" t="0" r="0" b="0"/>
            <a:pathLst>
              <a:path w="190" h="740">
                <a:moveTo>
                  <a:pt x="185" y="734"/>
                </a:moveTo>
                <a:lnTo>
                  <a:pt x="95" y="734"/>
                </a:lnTo>
                <a:moveTo>
                  <a:pt x="185" y="656"/>
                </a:moveTo>
                <a:lnTo>
                  <a:pt x="5" y="656"/>
                </a:lnTo>
                <a:moveTo>
                  <a:pt x="185" y="588"/>
                </a:moveTo>
                <a:lnTo>
                  <a:pt x="95" y="588"/>
                </a:lnTo>
                <a:moveTo>
                  <a:pt x="185" y="510"/>
                </a:moveTo>
                <a:lnTo>
                  <a:pt x="95" y="510"/>
                </a:lnTo>
                <a:moveTo>
                  <a:pt x="185" y="443"/>
                </a:moveTo>
                <a:lnTo>
                  <a:pt x="95" y="443"/>
                </a:lnTo>
                <a:moveTo>
                  <a:pt x="185" y="364"/>
                </a:moveTo>
                <a:lnTo>
                  <a:pt x="5" y="364"/>
                </a:lnTo>
                <a:moveTo>
                  <a:pt x="185" y="297"/>
                </a:moveTo>
                <a:lnTo>
                  <a:pt x="95" y="297"/>
                </a:lnTo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5" y="72"/>
                </a:lnTo>
                <a:moveTo>
                  <a:pt x="185" y="5"/>
                </a:moveTo>
                <a:lnTo>
                  <a:pt x="9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44" name="path"/>
          <p:cNvSpPr/>
          <p:nvPr/>
        </p:nvSpPr>
        <p:spPr>
          <a:xfrm>
            <a:off x="787161" y="2347238"/>
            <a:ext cx="135349" cy="420294"/>
          </a:xfrm>
          <a:custGeom>
            <a:avLst/>
            <a:gdLst/>
            <a:ahLst/>
            <a:cxnLst/>
            <a:rect l="0" t="0" r="0" b="0"/>
            <a:pathLst>
              <a:path w="213" h="661">
                <a:moveTo>
                  <a:pt x="207" y="656"/>
                </a:moveTo>
                <a:lnTo>
                  <a:pt x="106" y="656"/>
                </a:lnTo>
                <a:moveTo>
                  <a:pt x="207" y="487"/>
                </a:moveTo>
                <a:lnTo>
                  <a:pt x="106" y="487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62"/>
                </a:moveTo>
                <a:lnTo>
                  <a:pt x="106" y="162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46" name="path"/>
          <p:cNvSpPr/>
          <p:nvPr/>
        </p:nvSpPr>
        <p:spPr>
          <a:xfrm>
            <a:off x="787161" y="1307187"/>
            <a:ext cx="135349" cy="420294"/>
          </a:xfrm>
          <a:custGeom>
            <a:avLst/>
            <a:gdLst/>
            <a:ahLst/>
            <a:cxnLst/>
            <a:rect l="0" t="0" r="0" b="0"/>
            <a:pathLst>
              <a:path w="213" h="661">
                <a:moveTo>
                  <a:pt x="207" y="656"/>
                </a:moveTo>
                <a:lnTo>
                  <a:pt x="106" y="656"/>
                </a:lnTo>
                <a:moveTo>
                  <a:pt x="207" y="499"/>
                </a:moveTo>
                <a:lnTo>
                  <a:pt x="106" y="499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62"/>
                </a:moveTo>
                <a:lnTo>
                  <a:pt x="106" y="162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48" name="path"/>
          <p:cNvSpPr/>
          <p:nvPr/>
        </p:nvSpPr>
        <p:spPr>
          <a:xfrm>
            <a:off x="787161" y="787162"/>
            <a:ext cx="135349" cy="420294"/>
          </a:xfrm>
          <a:custGeom>
            <a:avLst/>
            <a:gdLst/>
            <a:ahLst/>
            <a:cxnLst/>
            <a:rect l="0" t="0" r="0" b="0"/>
            <a:pathLst>
              <a:path w="213" h="661">
                <a:moveTo>
                  <a:pt x="207" y="656"/>
                </a:moveTo>
                <a:lnTo>
                  <a:pt x="106" y="656"/>
                </a:lnTo>
                <a:moveTo>
                  <a:pt x="207" y="499"/>
                </a:moveTo>
                <a:lnTo>
                  <a:pt x="106" y="499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73"/>
                </a:moveTo>
                <a:lnTo>
                  <a:pt x="106" y="173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50" name="path"/>
          <p:cNvSpPr/>
          <p:nvPr/>
        </p:nvSpPr>
        <p:spPr>
          <a:xfrm>
            <a:off x="787161" y="1827213"/>
            <a:ext cx="135349" cy="420294"/>
          </a:xfrm>
          <a:custGeom>
            <a:avLst/>
            <a:gdLst/>
            <a:ahLst/>
            <a:cxnLst/>
            <a:rect l="0" t="0" r="0" b="0"/>
            <a:pathLst>
              <a:path w="213" h="661">
                <a:moveTo>
                  <a:pt x="207" y="656"/>
                </a:moveTo>
                <a:lnTo>
                  <a:pt x="106" y="656"/>
                </a:lnTo>
                <a:moveTo>
                  <a:pt x="207" y="487"/>
                </a:moveTo>
                <a:lnTo>
                  <a:pt x="106" y="487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62"/>
                </a:moveTo>
                <a:lnTo>
                  <a:pt x="106" y="162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52" name="textbox 152"/>
          <p:cNvSpPr/>
          <p:nvPr/>
        </p:nvSpPr>
        <p:spPr>
          <a:xfrm>
            <a:off x="3805569" y="696814"/>
            <a:ext cx="434975" cy="16128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lang="en-US" altLang="en-US" sz="100" dirty="0"/>
          </a:p>
          <a:p>
            <a:pPr marL="133350" algn="l" rtl="0" eaLnBrk="0">
              <a:lnSpc>
                <a:spcPts val="1065"/>
              </a:lnSpc>
              <a:tabLst>
                <a:tab pos="198120" algn="l"/>
              </a:tabLst>
            </a:pPr>
            <a:r>
              <a:rPr sz="8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8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S</a:t>
            </a:r>
            <a:endParaRPr lang="en-US" altLang="en-US" sz="800" dirty="0"/>
          </a:p>
        </p:txBody>
      </p:sp>
      <p:pic>
        <p:nvPicPr>
          <p:cNvPr id="154" name="picture 15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21600000">
            <a:off x="3818269" y="719487"/>
            <a:ext cx="121101" cy="99731"/>
          </a:xfrm>
          <a:prstGeom prst="rect">
            <a:avLst/>
          </a:prstGeom>
        </p:spPr>
      </p:pic>
      <p:sp>
        <p:nvSpPr>
          <p:cNvPr id="156" name="textbox 156"/>
          <p:cNvSpPr/>
          <p:nvPr/>
        </p:nvSpPr>
        <p:spPr>
          <a:xfrm rot="16200000">
            <a:off x="315261" y="7933009"/>
            <a:ext cx="407034" cy="174625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34000"/>
              </a:lnSpc>
            </a:pPr>
            <a:endParaRPr lang="en-US" altLang="en-US" sz="200" dirty="0"/>
          </a:p>
          <a:p>
            <a:pPr marL="1270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W</a:t>
            </a:r>
            <a:endParaRPr lang="en-US" altLang="en-US" sz="1000" dirty="0"/>
          </a:p>
        </p:txBody>
      </p:sp>
      <p:sp>
        <p:nvSpPr>
          <p:cNvPr id="158" name="textbox 158"/>
          <p:cNvSpPr/>
          <p:nvPr/>
        </p:nvSpPr>
        <p:spPr>
          <a:xfrm rot="16200000">
            <a:off x="2662193" y="7926484"/>
            <a:ext cx="386079" cy="174625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34000"/>
              </a:lnSpc>
            </a:pPr>
            <a:endParaRPr lang="en-US" altLang="en-US" sz="200" dirty="0"/>
          </a:p>
          <a:p>
            <a:pPr marL="1270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5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SC-A</a:t>
            </a:r>
            <a:endParaRPr lang="en-US" altLang="en-US" sz="1000" dirty="0"/>
          </a:p>
        </p:txBody>
      </p:sp>
      <p:sp>
        <p:nvSpPr>
          <p:cNvPr id="160" name="path"/>
          <p:cNvSpPr/>
          <p:nvPr/>
        </p:nvSpPr>
        <p:spPr>
          <a:xfrm>
            <a:off x="787161" y="3380165"/>
            <a:ext cx="135349" cy="213709"/>
          </a:xfrm>
          <a:custGeom>
            <a:avLst/>
            <a:gdLst/>
            <a:ahLst/>
            <a:cxnLst/>
            <a:rect l="0" t="0" r="0" b="0"/>
            <a:pathLst>
              <a:path w="213" h="336">
                <a:moveTo>
                  <a:pt x="207" y="330"/>
                </a:moveTo>
                <a:lnTo>
                  <a:pt x="106" y="330"/>
                </a:lnTo>
                <a:moveTo>
                  <a:pt x="207" y="173"/>
                </a:moveTo>
                <a:lnTo>
                  <a:pt x="106" y="173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pic>
        <p:nvPicPr>
          <p:cNvPr id="162" name="picture 16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21600000">
            <a:off x="3818269" y="477284"/>
            <a:ext cx="121101" cy="220832"/>
          </a:xfrm>
          <a:prstGeom prst="rect">
            <a:avLst/>
          </a:prstGeom>
        </p:spPr>
      </p:pic>
      <p:sp>
        <p:nvSpPr>
          <p:cNvPr id="164" name="path"/>
          <p:cNvSpPr/>
          <p:nvPr/>
        </p:nvSpPr>
        <p:spPr>
          <a:xfrm>
            <a:off x="851274" y="3793336"/>
            <a:ext cx="71236" cy="7123"/>
          </a:xfrm>
          <a:custGeom>
            <a:avLst/>
            <a:gdLst/>
            <a:ahLst/>
            <a:cxnLst/>
            <a:rect l="0" t="0" r="0" b="0"/>
            <a:pathLst>
              <a:path w="112" h="11">
                <a:moveTo>
                  <a:pt x="106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66" name="path"/>
          <p:cNvSpPr/>
          <p:nvPr/>
        </p:nvSpPr>
        <p:spPr>
          <a:xfrm>
            <a:off x="787161" y="3900191"/>
            <a:ext cx="135349" cy="7123"/>
          </a:xfrm>
          <a:custGeom>
            <a:avLst/>
            <a:gdLst/>
            <a:ahLst/>
            <a:cxnLst/>
            <a:rect l="0" t="0" r="0" b="0"/>
            <a:pathLst>
              <a:path w="213" h="11"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68" name="rect"/>
          <p:cNvSpPr/>
          <p:nvPr/>
        </p:nvSpPr>
        <p:spPr>
          <a:xfrm>
            <a:off x="851274" y="3693605"/>
            <a:ext cx="71236" cy="7123"/>
          </a:xfrm>
          <a:prstGeom prst="rect">
            <a:avLst/>
          </a:prstGeom>
          <a:solidFill>
            <a:srgbClr val="000000">
              <a:alpha val="100000"/>
            </a:srgbClr>
          </a:solidFill>
          <a:ln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70" name="path"/>
          <p:cNvSpPr/>
          <p:nvPr/>
        </p:nvSpPr>
        <p:spPr>
          <a:xfrm>
            <a:off x="915387" y="787162"/>
            <a:ext cx="7123" cy="3120152"/>
          </a:xfrm>
          <a:custGeom>
            <a:avLst/>
            <a:gdLst/>
            <a:ahLst/>
            <a:cxnLst/>
            <a:rect l="0" t="0" r="0" b="0"/>
            <a:pathLst>
              <a:path w="11" h="4913">
                <a:moveTo>
                  <a:pt x="5" y="4908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72" name="textbox 172"/>
          <p:cNvSpPr/>
          <p:nvPr/>
        </p:nvSpPr>
        <p:spPr>
          <a:xfrm rot="16200000">
            <a:off x="5062046" y="7924598"/>
            <a:ext cx="259715" cy="168910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32000"/>
              </a:lnSpc>
            </a:pPr>
            <a:endParaRPr lang="en-US" altLang="en-US" sz="200" dirty="0"/>
          </a:p>
          <a:p>
            <a:pPr marL="12700" algn="l" rtl="0" eaLnBrk="0">
              <a:lnSpc>
                <a:spcPct val="84000"/>
              </a:lnSpc>
              <a:spcBef>
                <a:spcPts val="0"/>
              </a:spcBef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</a:t>
            </a:r>
            <a:r>
              <a:rPr sz="900" kern="0" spc="-1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I-H</a:t>
            </a:r>
            <a:endParaRPr lang="en-US" altLang="en-US" sz="900" dirty="0"/>
          </a:p>
        </p:txBody>
      </p:sp>
      <p:sp>
        <p:nvSpPr>
          <p:cNvPr id="174" name="path"/>
          <p:cNvSpPr/>
          <p:nvPr/>
        </p:nvSpPr>
        <p:spPr>
          <a:xfrm>
            <a:off x="6421340" y="8036897"/>
            <a:ext cx="74521" cy="274408"/>
          </a:xfrm>
          <a:custGeom>
            <a:avLst/>
            <a:gdLst/>
            <a:ahLst/>
            <a:cxnLst/>
            <a:rect l="0" t="0" r="0" b="0"/>
            <a:pathLst>
              <a:path w="117" h="432">
                <a:moveTo>
                  <a:pt x="16" y="16"/>
                </a:moveTo>
                <a:lnTo>
                  <a:pt x="60" y="98"/>
                </a:lnTo>
                <a:lnTo>
                  <a:pt x="91" y="183"/>
                </a:lnTo>
                <a:lnTo>
                  <a:pt x="100" y="256"/>
                </a:lnTo>
                <a:moveTo>
                  <a:pt x="100" y="333"/>
                </a:moveTo>
                <a:lnTo>
                  <a:pt x="65" y="415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76" name="rect"/>
          <p:cNvSpPr/>
          <p:nvPr/>
        </p:nvSpPr>
        <p:spPr>
          <a:xfrm>
            <a:off x="3381900" y="7613574"/>
            <a:ext cx="142473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78" name="rect"/>
          <p:cNvSpPr/>
          <p:nvPr/>
        </p:nvSpPr>
        <p:spPr>
          <a:xfrm>
            <a:off x="1098199" y="7602667"/>
            <a:ext cx="142472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80" name="rect"/>
          <p:cNvSpPr/>
          <p:nvPr/>
        </p:nvSpPr>
        <p:spPr>
          <a:xfrm>
            <a:off x="5716958" y="7534850"/>
            <a:ext cx="142472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82" name="path"/>
          <p:cNvSpPr/>
          <p:nvPr/>
        </p:nvSpPr>
        <p:spPr>
          <a:xfrm>
            <a:off x="5431773" y="8423700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84" name="path"/>
          <p:cNvSpPr/>
          <p:nvPr/>
        </p:nvSpPr>
        <p:spPr>
          <a:xfrm>
            <a:off x="5431773" y="8053271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86" name="path"/>
          <p:cNvSpPr/>
          <p:nvPr/>
        </p:nvSpPr>
        <p:spPr>
          <a:xfrm>
            <a:off x="5431773" y="8238486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88" name="textbox 188"/>
          <p:cNvSpPr/>
          <p:nvPr/>
        </p:nvSpPr>
        <p:spPr>
          <a:xfrm>
            <a:off x="5713715" y="7540575"/>
            <a:ext cx="161289" cy="144145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lang="en-US" altLang="en-US" sz="100" dirty="0"/>
          </a:p>
          <a:p>
            <a:pPr algn="r" rtl="0" eaLnBrk="0">
              <a:lnSpc>
                <a:spcPct val="78000"/>
              </a:lnSpc>
            </a:pPr>
            <a:r>
              <a:rPr sz="1000" kern="0" spc="-9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</a:t>
            </a:r>
            <a:r>
              <a:rPr sz="1000" kern="0" spc="-5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</a:t>
            </a:r>
            <a:endParaRPr lang="en-US" altLang="en-US" sz="1000" dirty="0"/>
          </a:p>
        </p:txBody>
      </p:sp>
      <p:sp>
        <p:nvSpPr>
          <p:cNvPr id="190" name="textbox 190"/>
          <p:cNvSpPr/>
          <p:nvPr/>
        </p:nvSpPr>
        <p:spPr>
          <a:xfrm>
            <a:off x="1094927" y="7608361"/>
            <a:ext cx="161289" cy="14477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lang="en-US" altLang="en-US" sz="100" dirty="0"/>
          </a:p>
          <a:p>
            <a:pPr algn="r" rtl="0" eaLnBrk="0">
              <a:lnSpc>
                <a:spcPct val="78000"/>
              </a:lnSpc>
            </a:pPr>
            <a:r>
              <a:rPr sz="1000" kern="0" spc="-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1</a:t>
            </a:r>
            <a:endParaRPr lang="en-US" altLang="en-US" sz="1000" dirty="0"/>
          </a:p>
        </p:txBody>
      </p:sp>
      <p:sp>
        <p:nvSpPr>
          <p:cNvPr id="192" name="textbox 192"/>
          <p:cNvSpPr/>
          <p:nvPr/>
        </p:nvSpPr>
        <p:spPr>
          <a:xfrm>
            <a:off x="3378609" y="7619269"/>
            <a:ext cx="161289" cy="14477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lang="en-US" altLang="en-US" sz="100" dirty="0"/>
          </a:p>
          <a:p>
            <a:pPr algn="r" rtl="0" eaLnBrk="0">
              <a:lnSpc>
                <a:spcPct val="78000"/>
              </a:lnSpc>
            </a:pPr>
            <a:r>
              <a:rPr sz="1000" kern="0" spc="-8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</a:t>
            </a: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</a:t>
            </a:r>
            <a:endParaRPr lang="en-US" altLang="en-US" sz="1000" dirty="0"/>
          </a:p>
        </p:txBody>
      </p:sp>
      <p:sp>
        <p:nvSpPr>
          <p:cNvPr id="194" name="path"/>
          <p:cNvSpPr/>
          <p:nvPr/>
        </p:nvSpPr>
        <p:spPr>
          <a:xfrm>
            <a:off x="6010120" y="8515763"/>
            <a:ext cx="214392" cy="45858"/>
          </a:xfrm>
          <a:custGeom>
            <a:avLst/>
            <a:gdLst/>
            <a:ahLst/>
            <a:cxnLst/>
            <a:rect l="0" t="0" r="0" b="0"/>
            <a:pathLst>
              <a:path w="337" h="72">
                <a:moveTo>
                  <a:pt x="320" y="16"/>
                </a:moveTo>
                <a:lnTo>
                  <a:pt x="245" y="38"/>
                </a:lnTo>
                <a:lnTo>
                  <a:pt x="171" y="51"/>
                </a:lnTo>
                <a:lnTo>
                  <a:pt x="91" y="55"/>
                </a:lnTo>
                <a:lnTo>
                  <a:pt x="16" y="55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96" name="path"/>
          <p:cNvSpPr/>
          <p:nvPr/>
        </p:nvSpPr>
        <p:spPr>
          <a:xfrm>
            <a:off x="5488762" y="7960664"/>
            <a:ext cx="64112" cy="49865"/>
          </a:xfrm>
          <a:custGeom>
            <a:avLst/>
            <a:gdLst/>
            <a:ahLst/>
            <a:cxnLst/>
            <a:rect l="0" t="0" r="0" b="0"/>
            <a:pathLst>
              <a:path w="100" h="78">
                <a:moveTo>
                  <a:pt x="95" y="72"/>
                </a:moveTo>
                <a:lnTo>
                  <a:pt x="5" y="72"/>
                </a:lnTo>
                <a:moveTo>
                  <a:pt x="9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98" name="path"/>
          <p:cNvSpPr/>
          <p:nvPr/>
        </p:nvSpPr>
        <p:spPr>
          <a:xfrm>
            <a:off x="5431773" y="8608915"/>
            <a:ext cx="121101" cy="7123"/>
          </a:xfrm>
          <a:custGeom>
            <a:avLst/>
            <a:gdLst/>
            <a:ahLst/>
            <a:cxnLst/>
            <a:rect l="0" t="0" r="0" b="0"/>
            <a:pathLst>
              <a:path w="190" h="11"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200" name="path"/>
          <p:cNvSpPr/>
          <p:nvPr/>
        </p:nvSpPr>
        <p:spPr>
          <a:xfrm>
            <a:off x="5545751" y="7426391"/>
            <a:ext cx="7123" cy="1189647"/>
          </a:xfrm>
          <a:custGeom>
            <a:avLst/>
            <a:gdLst/>
            <a:ahLst/>
            <a:cxnLst/>
            <a:rect l="0" t="0" r="0" b="0"/>
            <a:pathLst>
              <a:path w="11" h="1873">
                <a:moveTo>
                  <a:pt x="5" y="1867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202" name="path"/>
          <p:cNvSpPr/>
          <p:nvPr/>
        </p:nvSpPr>
        <p:spPr>
          <a:xfrm>
            <a:off x="4129468" y="8298096"/>
            <a:ext cx="60534" cy="130204"/>
          </a:xfrm>
          <a:custGeom>
            <a:avLst/>
            <a:gdLst/>
            <a:ahLst/>
            <a:cxnLst/>
            <a:rect l="0" t="0" r="0" b="0"/>
            <a:pathLst>
              <a:path w="95" h="205">
                <a:moveTo>
                  <a:pt x="78" y="16"/>
                </a:moveTo>
                <a:lnTo>
                  <a:pt x="52" y="111"/>
                </a:lnTo>
                <a:lnTo>
                  <a:pt x="16" y="188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204" name="path"/>
          <p:cNvSpPr/>
          <p:nvPr/>
        </p:nvSpPr>
        <p:spPr>
          <a:xfrm>
            <a:off x="3472077" y="8338908"/>
            <a:ext cx="35358" cy="111158"/>
          </a:xfrm>
          <a:custGeom>
            <a:avLst/>
            <a:gdLst/>
            <a:ahLst/>
            <a:cxnLst/>
            <a:rect l="0" t="0" r="0" b="0"/>
            <a:pathLst>
              <a:path w="55" h="175">
                <a:moveTo>
                  <a:pt x="16" y="158"/>
                </a:moveTo>
                <a:lnTo>
                  <a:pt x="16" y="121"/>
                </a:lnTo>
                <a:lnTo>
                  <a:pt x="16" y="85"/>
                </a:lnTo>
                <a:lnTo>
                  <a:pt x="38" y="16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206" name="path"/>
          <p:cNvSpPr/>
          <p:nvPr/>
        </p:nvSpPr>
        <p:spPr>
          <a:xfrm>
            <a:off x="6474490" y="8189262"/>
            <a:ext cx="21371" cy="70345"/>
          </a:xfrm>
          <a:custGeom>
            <a:avLst/>
            <a:gdLst/>
            <a:ahLst/>
            <a:cxnLst/>
            <a:rect l="0" t="0" r="0" b="0"/>
            <a:pathLst>
              <a:path w="33" h="110">
                <a:moveTo>
                  <a:pt x="16" y="16"/>
                </a:moveTo>
                <a:lnTo>
                  <a:pt x="16" y="55"/>
                </a:lnTo>
                <a:lnTo>
                  <a:pt x="16" y="93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ath"/>
          <p:cNvSpPr/>
          <p:nvPr/>
        </p:nvSpPr>
        <p:spPr>
          <a:xfrm>
            <a:off x="2387306" y="3644939"/>
            <a:ext cx="45377" cy="130391"/>
          </a:xfrm>
          <a:custGeom>
            <a:avLst/>
            <a:gdLst/>
            <a:ahLst/>
            <a:cxnLst/>
            <a:rect l="0" t="0" r="0" b="0"/>
            <a:pathLst>
              <a:path w="71" h="205">
                <a:moveTo>
                  <a:pt x="7" y="7"/>
                </a:moveTo>
                <a:lnTo>
                  <a:pt x="35" y="101"/>
                </a:lnTo>
                <a:lnTo>
                  <a:pt x="64" y="198"/>
                </a:lnTo>
              </a:path>
            </a:pathLst>
          </a:custGeom>
          <a:noFill/>
          <a:ln w="9260" cap="rnd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pic>
        <p:nvPicPr>
          <p:cNvPr id="4" name="picture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rot="21600000">
            <a:off x="2206777" y="3899554"/>
            <a:ext cx="117499" cy="116283"/>
          </a:xfrm>
          <a:prstGeom prst="rect">
            <a:avLst/>
          </a:prstGeom>
        </p:spPr>
      </p:pic>
      <p:sp>
        <p:nvSpPr>
          <p:cNvPr id="6" name="path"/>
          <p:cNvSpPr/>
          <p:nvPr/>
        </p:nvSpPr>
        <p:spPr>
          <a:xfrm>
            <a:off x="924574" y="3668751"/>
            <a:ext cx="3620944" cy="237028"/>
          </a:xfrm>
          <a:custGeom>
            <a:avLst/>
            <a:gdLst/>
            <a:ahLst/>
            <a:cxnLst/>
            <a:rect l="0" t="0" r="0" b="0"/>
            <a:pathLst>
              <a:path w="5702" h="373">
                <a:moveTo>
                  <a:pt x="7" y="365"/>
                </a:moveTo>
                <a:lnTo>
                  <a:pt x="35" y="365"/>
                </a:lnTo>
                <a:lnTo>
                  <a:pt x="64" y="365"/>
                </a:lnTo>
                <a:lnTo>
                  <a:pt x="92" y="365"/>
                </a:lnTo>
                <a:lnTo>
                  <a:pt x="121" y="365"/>
                </a:lnTo>
                <a:lnTo>
                  <a:pt x="149" y="365"/>
                </a:lnTo>
                <a:lnTo>
                  <a:pt x="177" y="365"/>
                </a:lnTo>
                <a:lnTo>
                  <a:pt x="206" y="365"/>
                </a:lnTo>
                <a:lnTo>
                  <a:pt x="234" y="365"/>
                </a:lnTo>
                <a:lnTo>
                  <a:pt x="263" y="365"/>
                </a:lnTo>
                <a:lnTo>
                  <a:pt x="291" y="365"/>
                </a:lnTo>
                <a:lnTo>
                  <a:pt x="320" y="365"/>
                </a:lnTo>
                <a:lnTo>
                  <a:pt x="348" y="365"/>
                </a:lnTo>
                <a:lnTo>
                  <a:pt x="376" y="365"/>
                </a:lnTo>
                <a:lnTo>
                  <a:pt x="405" y="365"/>
                </a:lnTo>
                <a:lnTo>
                  <a:pt x="433" y="365"/>
                </a:lnTo>
                <a:lnTo>
                  <a:pt x="462" y="365"/>
                </a:lnTo>
                <a:lnTo>
                  <a:pt x="490" y="365"/>
                </a:lnTo>
                <a:lnTo>
                  <a:pt x="519" y="365"/>
                </a:lnTo>
                <a:lnTo>
                  <a:pt x="547" y="365"/>
                </a:lnTo>
                <a:lnTo>
                  <a:pt x="576" y="365"/>
                </a:lnTo>
                <a:lnTo>
                  <a:pt x="604" y="365"/>
                </a:lnTo>
                <a:lnTo>
                  <a:pt x="632" y="365"/>
                </a:lnTo>
                <a:lnTo>
                  <a:pt x="661" y="365"/>
                </a:lnTo>
                <a:lnTo>
                  <a:pt x="689" y="365"/>
                </a:lnTo>
                <a:lnTo>
                  <a:pt x="718" y="365"/>
                </a:lnTo>
                <a:lnTo>
                  <a:pt x="746" y="365"/>
                </a:lnTo>
                <a:lnTo>
                  <a:pt x="775" y="365"/>
                </a:lnTo>
                <a:lnTo>
                  <a:pt x="803" y="365"/>
                </a:lnTo>
                <a:lnTo>
                  <a:pt x="832" y="365"/>
                </a:lnTo>
                <a:lnTo>
                  <a:pt x="860" y="365"/>
                </a:lnTo>
                <a:lnTo>
                  <a:pt x="888" y="365"/>
                </a:lnTo>
                <a:lnTo>
                  <a:pt x="917" y="365"/>
                </a:lnTo>
                <a:lnTo>
                  <a:pt x="945" y="365"/>
                </a:lnTo>
                <a:lnTo>
                  <a:pt x="974" y="365"/>
                </a:lnTo>
                <a:lnTo>
                  <a:pt x="1002" y="365"/>
                </a:lnTo>
                <a:lnTo>
                  <a:pt x="1031" y="365"/>
                </a:lnTo>
                <a:lnTo>
                  <a:pt x="1059" y="365"/>
                </a:lnTo>
                <a:lnTo>
                  <a:pt x="1087" y="365"/>
                </a:lnTo>
                <a:lnTo>
                  <a:pt x="1116" y="365"/>
                </a:lnTo>
                <a:lnTo>
                  <a:pt x="1144" y="365"/>
                </a:lnTo>
                <a:lnTo>
                  <a:pt x="1173" y="365"/>
                </a:lnTo>
                <a:lnTo>
                  <a:pt x="1201" y="365"/>
                </a:lnTo>
                <a:lnTo>
                  <a:pt x="1230" y="365"/>
                </a:lnTo>
                <a:lnTo>
                  <a:pt x="1258" y="365"/>
                </a:lnTo>
                <a:lnTo>
                  <a:pt x="1287" y="365"/>
                </a:lnTo>
                <a:lnTo>
                  <a:pt x="1315" y="365"/>
                </a:lnTo>
                <a:lnTo>
                  <a:pt x="1343" y="365"/>
                </a:lnTo>
                <a:lnTo>
                  <a:pt x="1372" y="365"/>
                </a:lnTo>
                <a:lnTo>
                  <a:pt x="1400" y="364"/>
                </a:lnTo>
                <a:lnTo>
                  <a:pt x="1429" y="359"/>
                </a:lnTo>
                <a:lnTo>
                  <a:pt x="1457" y="359"/>
                </a:lnTo>
                <a:lnTo>
                  <a:pt x="1486" y="364"/>
                </a:lnTo>
                <a:lnTo>
                  <a:pt x="1514" y="354"/>
                </a:lnTo>
                <a:lnTo>
                  <a:pt x="1542" y="354"/>
                </a:lnTo>
                <a:lnTo>
                  <a:pt x="1571" y="357"/>
                </a:lnTo>
                <a:lnTo>
                  <a:pt x="1599" y="356"/>
                </a:lnTo>
                <a:lnTo>
                  <a:pt x="1628" y="343"/>
                </a:lnTo>
                <a:lnTo>
                  <a:pt x="1656" y="356"/>
                </a:lnTo>
                <a:lnTo>
                  <a:pt x="1685" y="338"/>
                </a:lnTo>
                <a:lnTo>
                  <a:pt x="1713" y="326"/>
                </a:lnTo>
                <a:lnTo>
                  <a:pt x="1742" y="317"/>
                </a:lnTo>
                <a:lnTo>
                  <a:pt x="1770" y="271"/>
                </a:lnTo>
                <a:moveTo>
                  <a:pt x="2367" y="160"/>
                </a:moveTo>
                <a:lnTo>
                  <a:pt x="2396" y="202"/>
                </a:lnTo>
                <a:lnTo>
                  <a:pt x="2424" y="232"/>
                </a:lnTo>
                <a:lnTo>
                  <a:pt x="2452" y="261"/>
                </a:lnTo>
                <a:lnTo>
                  <a:pt x="2481" y="261"/>
                </a:lnTo>
                <a:lnTo>
                  <a:pt x="2509" y="243"/>
                </a:lnTo>
                <a:lnTo>
                  <a:pt x="2538" y="274"/>
                </a:lnTo>
                <a:lnTo>
                  <a:pt x="2566" y="271"/>
                </a:lnTo>
                <a:lnTo>
                  <a:pt x="2595" y="269"/>
                </a:lnTo>
                <a:lnTo>
                  <a:pt x="2623" y="290"/>
                </a:lnTo>
                <a:lnTo>
                  <a:pt x="2652" y="289"/>
                </a:lnTo>
                <a:lnTo>
                  <a:pt x="2680" y="277"/>
                </a:lnTo>
                <a:lnTo>
                  <a:pt x="2708" y="282"/>
                </a:lnTo>
                <a:lnTo>
                  <a:pt x="2737" y="294"/>
                </a:lnTo>
                <a:lnTo>
                  <a:pt x="2765" y="295"/>
                </a:lnTo>
                <a:lnTo>
                  <a:pt x="2794" y="302"/>
                </a:lnTo>
                <a:lnTo>
                  <a:pt x="2822" y="289"/>
                </a:lnTo>
                <a:lnTo>
                  <a:pt x="2851" y="274"/>
                </a:lnTo>
                <a:lnTo>
                  <a:pt x="2879" y="289"/>
                </a:lnTo>
                <a:lnTo>
                  <a:pt x="2908" y="312"/>
                </a:lnTo>
                <a:lnTo>
                  <a:pt x="2936" y="279"/>
                </a:lnTo>
                <a:lnTo>
                  <a:pt x="2964" y="269"/>
                </a:lnTo>
                <a:lnTo>
                  <a:pt x="2993" y="286"/>
                </a:lnTo>
                <a:lnTo>
                  <a:pt x="3021" y="287"/>
                </a:lnTo>
                <a:lnTo>
                  <a:pt x="3050" y="281"/>
                </a:lnTo>
                <a:lnTo>
                  <a:pt x="3078" y="297"/>
                </a:lnTo>
                <a:lnTo>
                  <a:pt x="3107" y="289"/>
                </a:lnTo>
                <a:lnTo>
                  <a:pt x="3135" y="287"/>
                </a:lnTo>
                <a:lnTo>
                  <a:pt x="3163" y="281"/>
                </a:lnTo>
                <a:lnTo>
                  <a:pt x="3192" y="273"/>
                </a:lnTo>
                <a:lnTo>
                  <a:pt x="3220" y="273"/>
                </a:lnTo>
                <a:lnTo>
                  <a:pt x="3249" y="299"/>
                </a:lnTo>
                <a:lnTo>
                  <a:pt x="3277" y="295"/>
                </a:lnTo>
                <a:lnTo>
                  <a:pt x="3306" y="277"/>
                </a:lnTo>
                <a:lnTo>
                  <a:pt x="3334" y="282"/>
                </a:lnTo>
                <a:lnTo>
                  <a:pt x="3363" y="276"/>
                </a:lnTo>
                <a:lnTo>
                  <a:pt x="3391" y="273"/>
                </a:lnTo>
                <a:lnTo>
                  <a:pt x="3419" y="261"/>
                </a:lnTo>
                <a:lnTo>
                  <a:pt x="3448" y="260"/>
                </a:lnTo>
                <a:lnTo>
                  <a:pt x="3476" y="266"/>
                </a:lnTo>
                <a:lnTo>
                  <a:pt x="3505" y="273"/>
                </a:lnTo>
                <a:lnTo>
                  <a:pt x="3533" y="271"/>
                </a:lnTo>
                <a:lnTo>
                  <a:pt x="3562" y="243"/>
                </a:lnTo>
                <a:lnTo>
                  <a:pt x="3590" y="263"/>
                </a:lnTo>
                <a:lnTo>
                  <a:pt x="3618" y="230"/>
                </a:lnTo>
                <a:lnTo>
                  <a:pt x="3647" y="264"/>
                </a:lnTo>
                <a:lnTo>
                  <a:pt x="3675" y="237"/>
                </a:lnTo>
                <a:lnTo>
                  <a:pt x="3704" y="235"/>
                </a:lnTo>
                <a:lnTo>
                  <a:pt x="3732" y="227"/>
                </a:lnTo>
                <a:lnTo>
                  <a:pt x="3761" y="186"/>
                </a:lnTo>
                <a:lnTo>
                  <a:pt x="3789" y="207"/>
                </a:lnTo>
                <a:lnTo>
                  <a:pt x="3818" y="198"/>
                </a:lnTo>
                <a:lnTo>
                  <a:pt x="3846" y="165"/>
                </a:lnTo>
                <a:lnTo>
                  <a:pt x="3874" y="162"/>
                </a:lnTo>
                <a:lnTo>
                  <a:pt x="3903" y="163"/>
                </a:lnTo>
                <a:lnTo>
                  <a:pt x="3931" y="139"/>
                </a:lnTo>
                <a:lnTo>
                  <a:pt x="3960" y="103"/>
                </a:lnTo>
                <a:lnTo>
                  <a:pt x="3988" y="108"/>
                </a:lnTo>
                <a:lnTo>
                  <a:pt x="4017" y="79"/>
                </a:lnTo>
                <a:lnTo>
                  <a:pt x="4045" y="72"/>
                </a:lnTo>
                <a:lnTo>
                  <a:pt x="4073" y="17"/>
                </a:lnTo>
                <a:lnTo>
                  <a:pt x="4102" y="48"/>
                </a:lnTo>
                <a:lnTo>
                  <a:pt x="4130" y="28"/>
                </a:lnTo>
                <a:lnTo>
                  <a:pt x="4159" y="7"/>
                </a:lnTo>
                <a:lnTo>
                  <a:pt x="4187" y="75"/>
                </a:lnTo>
                <a:lnTo>
                  <a:pt x="4216" y="137"/>
                </a:lnTo>
                <a:lnTo>
                  <a:pt x="4244" y="173"/>
                </a:lnTo>
                <a:lnTo>
                  <a:pt x="4273" y="186"/>
                </a:lnTo>
                <a:lnTo>
                  <a:pt x="4301" y="230"/>
                </a:lnTo>
                <a:lnTo>
                  <a:pt x="4329" y="273"/>
                </a:lnTo>
                <a:lnTo>
                  <a:pt x="4358" y="277"/>
                </a:lnTo>
                <a:lnTo>
                  <a:pt x="4386" y="317"/>
                </a:lnTo>
                <a:lnTo>
                  <a:pt x="4415" y="325"/>
                </a:lnTo>
                <a:lnTo>
                  <a:pt x="4443" y="335"/>
                </a:lnTo>
                <a:lnTo>
                  <a:pt x="4472" y="343"/>
                </a:lnTo>
                <a:lnTo>
                  <a:pt x="4500" y="341"/>
                </a:lnTo>
                <a:lnTo>
                  <a:pt x="4529" y="352"/>
                </a:lnTo>
                <a:lnTo>
                  <a:pt x="4557" y="361"/>
                </a:lnTo>
                <a:lnTo>
                  <a:pt x="4585" y="361"/>
                </a:lnTo>
                <a:lnTo>
                  <a:pt x="4614" y="362"/>
                </a:lnTo>
                <a:lnTo>
                  <a:pt x="4642" y="364"/>
                </a:lnTo>
                <a:lnTo>
                  <a:pt x="4671" y="359"/>
                </a:lnTo>
                <a:lnTo>
                  <a:pt x="4699" y="364"/>
                </a:lnTo>
                <a:lnTo>
                  <a:pt x="4728" y="357"/>
                </a:lnTo>
                <a:lnTo>
                  <a:pt x="4756" y="356"/>
                </a:lnTo>
                <a:lnTo>
                  <a:pt x="4784" y="364"/>
                </a:lnTo>
                <a:lnTo>
                  <a:pt x="4813" y="364"/>
                </a:lnTo>
                <a:lnTo>
                  <a:pt x="4841" y="362"/>
                </a:lnTo>
                <a:lnTo>
                  <a:pt x="4870" y="361"/>
                </a:lnTo>
                <a:lnTo>
                  <a:pt x="4898" y="361"/>
                </a:lnTo>
                <a:lnTo>
                  <a:pt x="4927" y="362"/>
                </a:lnTo>
                <a:lnTo>
                  <a:pt x="4955" y="362"/>
                </a:lnTo>
                <a:lnTo>
                  <a:pt x="4984" y="362"/>
                </a:lnTo>
                <a:lnTo>
                  <a:pt x="5012" y="364"/>
                </a:lnTo>
                <a:lnTo>
                  <a:pt x="5040" y="361"/>
                </a:lnTo>
                <a:lnTo>
                  <a:pt x="5069" y="359"/>
                </a:lnTo>
                <a:lnTo>
                  <a:pt x="5097" y="362"/>
                </a:lnTo>
                <a:lnTo>
                  <a:pt x="5126" y="365"/>
                </a:lnTo>
                <a:lnTo>
                  <a:pt x="5154" y="365"/>
                </a:lnTo>
                <a:lnTo>
                  <a:pt x="5183" y="362"/>
                </a:lnTo>
                <a:lnTo>
                  <a:pt x="5211" y="365"/>
                </a:lnTo>
                <a:lnTo>
                  <a:pt x="5239" y="362"/>
                </a:lnTo>
                <a:lnTo>
                  <a:pt x="5268" y="364"/>
                </a:lnTo>
                <a:lnTo>
                  <a:pt x="5296" y="365"/>
                </a:lnTo>
                <a:lnTo>
                  <a:pt x="5325" y="364"/>
                </a:lnTo>
                <a:lnTo>
                  <a:pt x="5353" y="364"/>
                </a:lnTo>
                <a:lnTo>
                  <a:pt x="5382" y="364"/>
                </a:lnTo>
                <a:lnTo>
                  <a:pt x="5410" y="365"/>
                </a:lnTo>
                <a:lnTo>
                  <a:pt x="5439" y="365"/>
                </a:lnTo>
                <a:lnTo>
                  <a:pt x="5467" y="365"/>
                </a:lnTo>
                <a:lnTo>
                  <a:pt x="5495" y="365"/>
                </a:lnTo>
                <a:lnTo>
                  <a:pt x="5524" y="365"/>
                </a:lnTo>
                <a:lnTo>
                  <a:pt x="5552" y="365"/>
                </a:lnTo>
                <a:lnTo>
                  <a:pt x="5581" y="365"/>
                </a:lnTo>
                <a:lnTo>
                  <a:pt x="5609" y="365"/>
                </a:lnTo>
                <a:lnTo>
                  <a:pt x="5638" y="365"/>
                </a:lnTo>
                <a:lnTo>
                  <a:pt x="5666" y="365"/>
                </a:lnTo>
                <a:lnTo>
                  <a:pt x="5694" y="365"/>
                </a:lnTo>
              </a:path>
            </a:pathLst>
          </a:custGeom>
          <a:noFill/>
          <a:ln w="9260" cap="rnd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" name="path"/>
          <p:cNvSpPr/>
          <p:nvPr/>
        </p:nvSpPr>
        <p:spPr>
          <a:xfrm>
            <a:off x="3807583" y="3900191"/>
            <a:ext cx="733734" cy="135349"/>
          </a:xfrm>
          <a:custGeom>
            <a:avLst/>
            <a:gdLst/>
            <a:ahLst/>
            <a:cxnLst/>
            <a:rect l="0" t="0" r="0" b="0"/>
            <a:pathLst>
              <a:path w="1155" h="213">
                <a:moveTo>
                  <a:pt x="5" y="5"/>
                </a:moveTo>
                <a:lnTo>
                  <a:pt x="5" y="106"/>
                </a:lnTo>
                <a:moveTo>
                  <a:pt x="297" y="5"/>
                </a:moveTo>
                <a:lnTo>
                  <a:pt x="297" y="106"/>
                </a:lnTo>
                <a:moveTo>
                  <a:pt x="577" y="5"/>
                </a:moveTo>
                <a:lnTo>
                  <a:pt x="577" y="106"/>
                </a:lnTo>
                <a:moveTo>
                  <a:pt x="869" y="5"/>
                </a:moveTo>
                <a:lnTo>
                  <a:pt x="869" y="106"/>
                </a:lnTo>
                <a:moveTo>
                  <a:pt x="1149" y="5"/>
                </a:moveTo>
                <a:lnTo>
                  <a:pt x="1149" y="207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" name="path"/>
          <p:cNvSpPr/>
          <p:nvPr/>
        </p:nvSpPr>
        <p:spPr>
          <a:xfrm>
            <a:off x="1093478" y="3900191"/>
            <a:ext cx="733734" cy="135349"/>
          </a:xfrm>
          <a:custGeom>
            <a:avLst/>
            <a:gdLst/>
            <a:ahLst/>
            <a:cxnLst/>
            <a:rect l="0" t="0" r="0" b="0"/>
            <a:pathLst>
              <a:path w="1155" h="213">
                <a:moveTo>
                  <a:pt x="5" y="5"/>
                </a:moveTo>
                <a:lnTo>
                  <a:pt x="5" y="106"/>
                </a:lnTo>
                <a:moveTo>
                  <a:pt x="297" y="5"/>
                </a:moveTo>
                <a:lnTo>
                  <a:pt x="297" y="106"/>
                </a:lnTo>
                <a:moveTo>
                  <a:pt x="577" y="5"/>
                </a:moveTo>
                <a:lnTo>
                  <a:pt x="577" y="106"/>
                </a:lnTo>
                <a:moveTo>
                  <a:pt x="869" y="5"/>
                </a:moveTo>
                <a:lnTo>
                  <a:pt x="869" y="106"/>
                </a:lnTo>
                <a:moveTo>
                  <a:pt x="1149" y="5"/>
                </a:moveTo>
                <a:lnTo>
                  <a:pt x="1149" y="207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2" name="path"/>
          <p:cNvSpPr/>
          <p:nvPr/>
        </p:nvSpPr>
        <p:spPr>
          <a:xfrm>
            <a:off x="2902882" y="3900191"/>
            <a:ext cx="733734" cy="135349"/>
          </a:xfrm>
          <a:custGeom>
            <a:avLst/>
            <a:gdLst/>
            <a:ahLst/>
            <a:cxnLst/>
            <a:rect l="0" t="0" r="0" b="0"/>
            <a:pathLst>
              <a:path w="1155" h="213">
                <a:moveTo>
                  <a:pt x="5" y="5"/>
                </a:moveTo>
                <a:lnTo>
                  <a:pt x="5" y="106"/>
                </a:lnTo>
                <a:moveTo>
                  <a:pt x="297" y="5"/>
                </a:moveTo>
                <a:lnTo>
                  <a:pt x="297" y="106"/>
                </a:lnTo>
                <a:moveTo>
                  <a:pt x="577" y="5"/>
                </a:moveTo>
                <a:lnTo>
                  <a:pt x="577" y="106"/>
                </a:lnTo>
                <a:moveTo>
                  <a:pt x="869" y="5"/>
                </a:moveTo>
                <a:lnTo>
                  <a:pt x="869" y="106"/>
                </a:lnTo>
                <a:moveTo>
                  <a:pt x="1149" y="5"/>
                </a:moveTo>
                <a:lnTo>
                  <a:pt x="1149" y="207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4" name="path"/>
          <p:cNvSpPr/>
          <p:nvPr/>
        </p:nvSpPr>
        <p:spPr>
          <a:xfrm>
            <a:off x="915387" y="3900191"/>
            <a:ext cx="7123" cy="135349"/>
          </a:xfrm>
          <a:custGeom>
            <a:avLst/>
            <a:gdLst/>
            <a:ahLst/>
            <a:cxnLst/>
            <a:rect l="0" t="0" r="0" b="0"/>
            <a:pathLst>
              <a:path w="11" h="213">
                <a:moveTo>
                  <a:pt x="5" y="5"/>
                </a:moveTo>
                <a:lnTo>
                  <a:pt x="5" y="207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pic>
        <p:nvPicPr>
          <p:cNvPr id="16" name="picture 1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600000">
            <a:off x="3506983" y="3899554"/>
            <a:ext cx="117500" cy="116283"/>
          </a:xfrm>
          <a:prstGeom prst="rect">
            <a:avLst/>
          </a:prstGeom>
        </p:spPr>
      </p:pic>
      <p:sp>
        <p:nvSpPr>
          <p:cNvPr id="18" name="path"/>
          <p:cNvSpPr/>
          <p:nvPr/>
        </p:nvSpPr>
        <p:spPr>
          <a:xfrm>
            <a:off x="1998180" y="3900191"/>
            <a:ext cx="733734" cy="135349"/>
          </a:xfrm>
          <a:custGeom>
            <a:avLst/>
            <a:gdLst/>
            <a:ahLst/>
            <a:cxnLst/>
            <a:rect l="0" t="0" r="0" b="0"/>
            <a:pathLst>
              <a:path w="1155" h="213">
                <a:moveTo>
                  <a:pt x="5" y="5"/>
                </a:moveTo>
                <a:lnTo>
                  <a:pt x="5" y="106"/>
                </a:lnTo>
                <a:moveTo>
                  <a:pt x="297" y="5"/>
                </a:moveTo>
                <a:lnTo>
                  <a:pt x="297" y="106"/>
                </a:lnTo>
                <a:moveTo>
                  <a:pt x="577" y="5"/>
                </a:moveTo>
                <a:lnTo>
                  <a:pt x="577" y="106"/>
                </a:lnTo>
                <a:moveTo>
                  <a:pt x="869" y="5"/>
                </a:moveTo>
                <a:lnTo>
                  <a:pt x="869" y="106"/>
                </a:lnTo>
                <a:moveTo>
                  <a:pt x="1149" y="5"/>
                </a:moveTo>
                <a:lnTo>
                  <a:pt x="1149" y="207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20" name="path"/>
          <p:cNvSpPr/>
          <p:nvPr/>
        </p:nvSpPr>
        <p:spPr>
          <a:xfrm>
            <a:off x="915387" y="3900191"/>
            <a:ext cx="3625931" cy="7123"/>
          </a:xfrm>
          <a:custGeom>
            <a:avLst/>
            <a:gdLst/>
            <a:ahLst/>
            <a:cxnLst/>
            <a:rect l="0" t="0" r="0" b="0"/>
            <a:pathLst>
              <a:path w="5710" h="11">
                <a:moveTo>
                  <a:pt x="5" y="5"/>
                </a:moveTo>
                <a:lnTo>
                  <a:pt x="5704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22" name="path"/>
          <p:cNvSpPr/>
          <p:nvPr/>
        </p:nvSpPr>
        <p:spPr>
          <a:xfrm>
            <a:off x="2080313" y="894142"/>
            <a:ext cx="316253" cy="2812859"/>
          </a:xfrm>
          <a:custGeom>
            <a:avLst/>
            <a:gdLst/>
            <a:ahLst/>
            <a:cxnLst/>
            <a:rect l="0" t="0" r="0" b="0"/>
            <a:pathLst>
              <a:path w="498" h="4429">
                <a:moveTo>
                  <a:pt x="7" y="4422"/>
                </a:moveTo>
                <a:lnTo>
                  <a:pt x="35" y="4285"/>
                </a:lnTo>
                <a:lnTo>
                  <a:pt x="64" y="4107"/>
                </a:lnTo>
                <a:lnTo>
                  <a:pt x="92" y="3913"/>
                </a:lnTo>
                <a:lnTo>
                  <a:pt x="121" y="3662"/>
                </a:lnTo>
                <a:lnTo>
                  <a:pt x="149" y="3382"/>
                </a:lnTo>
                <a:lnTo>
                  <a:pt x="177" y="2769"/>
                </a:lnTo>
                <a:lnTo>
                  <a:pt x="206" y="2097"/>
                </a:lnTo>
                <a:lnTo>
                  <a:pt x="234" y="1389"/>
                </a:lnTo>
                <a:lnTo>
                  <a:pt x="263" y="264"/>
                </a:lnTo>
                <a:lnTo>
                  <a:pt x="291" y="7"/>
                </a:lnTo>
                <a:lnTo>
                  <a:pt x="320" y="154"/>
                </a:lnTo>
                <a:lnTo>
                  <a:pt x="348" y="727"/>
                </a:lnTo>
                <a:lnTo>
                  <a:pt x="376" y="1790"/>
                </a:lnTo>
                <a:lnTo>
                  <a:pt x="405" y="2852"/>
                </a:lnTo>
                <a:lnTo>
                  <a:pt x="433" y="3507"/>
                </a:lnTo>
                <a:lnTo>
                  <a:pt x="462" y="3987"/>
                </a:lnTo>
                <a:lnTo>
                  <a:pt x="490" y="4339"/>
                </a:lnTo>
              </a:path>
            </a:pathLst>
          </a:custGeom>
          <a:noFill/>
          <a:ln w="9260" cap="rnd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24" name="path"/>
          <p:cNvSpPr/>
          <p:nvPr/>
        </p:nvSpPr>
        <p:spPr>
          <a:xfrm>
            <a:off x="2044196" y="3697740"/>
            <a:ext cx="45377" cy="147990"/>
          </a:xfrm>
          <a:custGeom>
            <a:avLst/>
            <a:gdLst/>
            <a:ahLst/>
            <a:cxnLst/>
            <a:rect l="0" t="0" r="0" b="0"/>
            <a:pathLst>
              <a:path w="71" h="233">
                <a:moveTo>
                  <a:pt x="7" y="225"/>
                </a:moveTo>
                <a:lnTo>
                  <a:pt x="35" y="123"/>
                </a:lnTo>
                <a:lnTo>
                  <a:pt x="64" y="7"/>
                </a:lnTo>
              </a:path>
            </a:pathLst>
          </a:custGeom>
          <a:noFill/>
          <a:ln w="9260" cap="rnd">
            <a:solidFill>
              <a:srgbClr val="000000">
                <a:alpha val="100000"/>
              </a:srgbClr>
            </a:solidFill>
            <a:prstDash val="solid"/>
            <a:round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pic>
        <p:nvPicPr>
          <p:cNvPr id="26" name="picture 2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1600000">
            <a:off x="929204" y="1148760"/>
            <a:ext cx="3611684" cy="2752387"/>
          </a:xfrm>
          <a:prstGeom prst="rect">
            <a:avLst/>
          </a:prstGeom>
        </p:spPr>
      </p:pic>
      <p:sp>
        <p:nvSpPr>
          <p:cNvPr id="28" name="textbox 28"/>
          <p:cNvSpPr/>
          <p:nvPr/>
        </p:nvSpPr>
        <p:spPr>
          <a:xfrm>
            <a:off x="5148708" y="463314"/>
            <a:ext cx="2123439" cy="3309620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76000"/>
              </a:lnSpc>
            </a:pPr>
            <a:endParaRPr lang="en-US" altLang="en-US" sz="100" dirty="0"/>
          </a:p>
          <a:p>
            <a:pPr marL="21590" algn="l" rtl="0" eaLnBrk="0">
              <a:lnSpc>
                <a:spcPct val="10200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ile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nalyzed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231222</a:t>
            </a:r>
            <a:r>
              <a:rPr sz="900" u="sng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</a:t>
            </a:r>
            <a:r>
              <a:rPr sz="900" u="sng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08.fcs        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ate analyzed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7-Dec-20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3</a:t>
            </a:r>
            <a:endParaRPr lang="en-US" altLang="en-US" sz="1000" dirty="0"/>
          </a:p>
          <a:p>
            <a:pPr marL="2159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l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nn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n_DSD</a:t>
            </a:r>
            <a:endParaRPr lang="en-US" altLang="en-US" sz="900" dirty="0"/>
          </a:p>
          <a:p>
            <a:pPr marL="12700" algn="l" rtl="0" eaLnBrk="0">
              <a:lnSpc>
                <a:spcPts val="1230"/>
              </a:lnSpc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nalysis type:</a:t>
            </a:r>
            <a:r>
              <a:rPr sz="10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anual analy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is</a:t>
            </a:r>
            <a:endParaRPr lang="en-US" altLang="en-US" sz="1000" dirty="0"/>
          </a:p>
          <a:p>
            <a:pPr marL="12700" algn="l" rtl="0" eaLnBrk="0">
              <a:lnSpc>
                <a:spcPct val="87000"/>
              </a:lnSpc>
              <a:spcBef>
                <a:spcPts val="7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uto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Linearity:</a:t>
            </a:r>
            <a:r>
              <a:rPr sz="10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o</a:t>
            </a:r>
            <a:endParaRPr lang="en-US" altLang="en-US" sz="1000" dirty="0"/>
          </a:p>
          <a:p>
            <a:pPr marL="21590" algn="l" rtl="0" eaLnBrk="0">
              <a:lnSpc>
                <a:spcPts val="1270"/>
              </a:lnSpc>
              <a:spcBef>
                <a:spcPts val="94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loidy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</a:t>
            </a:r>
            <a:r>
              <a:rPr sz="900" kern="0" spc="1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irst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ycle</a:t>
            </a:r>
            <a:r>
              <a:rPr sz="9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is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loid</a:t>
            </a:r>
            <a:endParaRPr lang="en-US" altLang="en-US" sz="900" dirty="0"/>
          </a:p>
          <a:p>
            <a:pPr marL="21590" algn="l" rtl="0" eaLnBrk="0">
              <a:lnSpc>
                <a:spcPts val="1195"/>
              </a:lnSpc>
              <a:spcBef>
                <a:spcPts val="97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loid:</a:t>
            </a:r>
            <a:r>
              <a:rPr sz="900" kern="0" spc="1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.00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lang="en-US" altLang="en-US" sz="900" dirty="0"/>
          </a:p>
          <a:p>
            <a:pPr marL="12827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G1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7.98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t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3.73</a:t>
            </a:r>
            <a:endParaRPr lang="en-US" altLang="en-US" sz="900" dirty="0"/>
          </a:p>
          <a:p>
            <a:pPr marL="12827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G2: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.86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t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43.78</a:t>
            </a:r>
            <a:endParaRPr lang="en-US" altLang="en-US" sz="900" dirty="0"/>
          </a:p>
          <a:p>
            <a:pPr marL="128270" algn="l" rtl="0" eaLnBrk="0">
              <a:lnSpc>
                <a:spcPts val="1230"/>
              </a:lnSpc>
            </a:pP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S:</a:t>
            </a:r>
            <a:r>
              <a:rPr sz="900" kern="0" spc="1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3.</a:t>
            </a:r>
            <a:r>
              <a:rPr sz="900" kern="0" spc="-1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7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2/G1:</a:t>
            </a:r>
            <a:r>
              <a:rPr sz="900" kern="0" spc="1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.95</a:t>
            </a:r>
            <a:endParaRPr lang="en-US" altLang="en-US" sz="900" dirty="0"/>
          </a:p>
          <a:p>
            <a:pPr marL="126365" algn="l" rtl="0" eaLnBrk="0">
              <a:lnSpc>
                <a:spcPts val="1230"/>
              </a:lnSpc>
              <a:spcBef>
                <a:spcPts val="70"/>
              </a:spcBef>
            </a:pP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CV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.58</a:t>
            </a:r>
            <a:endParaRPr lang="en-US" altLang="en-US" sz="1000" dirty="0"/>
          </a:p>
          <a:p>
            <a:pPr marL="15240" algn="l" rtl="0" eaLnBrk="0">
              <a:lnSpc>
                <a:spcPts val="1195"/>
              </a:lnSpc>
              <a:spcBef>
                <a:spcPts val="760"/>
              </a:spcBef>
            </a:pP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Total S-Phase:</a:t>
            </a:r>
            <a:r>
              <a:rPr sz="900" kern="0" spc="1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3.</a:t>
            </a:r>
            <a:r>
              <a:rPr sz="900" kern="0" spc="-1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7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lang="en-US" altLang="en-US" sz="900" dirty="0"/>
          </a:p>
          <a:p>
            <a:pPr marL="15240" algn="l" rtl="0" eaLnBrk="0">
              <a:lnSpc>
                <a:spcPts val="1195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Total B.A.D.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.00 %    no debris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o aggs</a:t>
            </a:r>
            <a:endParaRPr lang="en-US" altLang="en-US" sz="900" dirty="0"/>
          </a:p>
          <a:p>
            <a:pPr marL="21590" algn="l" rtl="0" eaLnBrk="0">
              <a:lnSpc>
                <a:spcPct val="100000"/>
              </a:lnSpc>
              <a:spcBef>
                <a:spcPts val="970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ebris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lang="en-US" altLang="en-US" sz="1000" dirty="0"/>
          </a:p>
          <a:p>
            <a:pPr marL="12700" algn="l" rtl="0" eaLnBrk="0">
              <a:lnSpc>
                <a:spcPct val="93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ggregates:</a:t>
            </a:r>
            <a:r>
              <a:rPr sz="10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lang="en-US" altLang="en-US" sz="1000" dirty="0"/>
          </a:p>
          <a:p>
            <a:pPr marL="2159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led event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: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8712</a:t>
            </a:r>
            <a:endParaRPr lang="en-US" altLang="en-US" sz="900" dirty="0"/>
          </a:p>
          <a:p>
            <a:pPr marL="12700" algn="l" rtl="0" eaLnBrk="0">
              <a:lnSpc>
                <a:spcPct val="93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ll cycle events:</a:t>
            </a:r>
            <a:r>
              <a:rPr sz="10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8712</a:t>
            </a:r>
            <a:endParaRPr lang="en-US" altLang="en-US" sz="1000" dirty="0"/>
          </a:p>
          <a:p>
            <a:pPr marL="18415" algn="l" rtl="0" eaLnBrk="0">
              <a:lnSpc>
                <a:spcPts val="1225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ycle</a:t>
            </a:r>
            <a:r>
              <a:rPr sz="900" kern="0" spc="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events</a:t>
            </a:r>
            <a:r>
              <a:rPr sz="900" kern="0" spc="1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er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hannel</a:t>
            </a:r>
            <a:r>
              <a:rPr sz="900" kern="0" spc="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 404</a:t>
            </a:r>
            <a:endParaRPr lang="en-US" altLang="en-US" sz="900" dirty="0"/>
          </a:p>
          <a:p>
            <a:pPr marL="21590" algn="l" rtl="0" eaLnBrk="0">
              <a:lnSpc>
                <a:spcPct val="92000"/>
              </a:lnSpc>
              <a:spcBef>
                <a:spcPts val="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CS:</a:t>
            </a:r>
            <a:r>
              <a:rPr sz="900" kern="0" spc="10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5.800</a:t>
            </a:r>
            <a:endParaRPr lang="en-US" altLang="en-US" sz="900" dirty="0"/>
          </a:p>
        </p:txBody>
      </p:sp>
      <p:pic>
        <p:nvPicPr>
          <p:cNvPr id="30" name="picture 3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21600000">
            <a:off x="872645" y="7436918"/>
            <a:ext cx="1239083" cy="1301232"/>
          </a:xfrm>
          <a:prstGeom prst="rect">
            <a:avLst/>
          </a:prstGeom>
        </p:spPr>
      </p:pic>
      <p:pic>
        <p:nvPicPr>
          <p:cNvPr id="32" name="picture 3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21600000">
            <a:off x="3209198" y="7436918"/>
            <a:ext cx="1225214" cy="1301232"/>
          </a:xfrm>
          <a:prstGeom prst="rect">
            <a:avLst/>
          </a:prstGeom>
        </p:spPr>
      </p:pic>
      <p:pic>
        <p:nvPicPr>
          <p:cNvPr id="34" name="picture 3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21600000">
            <a:off x="5545751" y="7436918"/>
            <a:ext cx="1223862" cy="1301232"/>
          </a:xfrm>
          <a:prstGeom prst="rect">
            <a:avLst/>
          </a:prstGeom>
        </p:spPr>
      </p:pic>
      <p:sp>
        <p:nvSpPr>
          <p:cNvPr id="36" name="textbox 36"/>
          <p:cNvSpPr/>
          <p:nvPr/>
        </p:nvSpPr>
        <p:spPr>
          <a:xfrm>
            <a:off x="882499" y="4078020"/>
            <a:ext cx="3767454" cy="30352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lang="en-US" altLang="en-US" sz="100" dirty="0"/>
          </a:p>
          <a:p>
            <a:pPr marL="12700" algn="l" rtl="0" eaLnBrk="0">
              <a:lnSpc>
                <a:spcPct val="81000"/>
              </a:lnSpc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</a:t>
            </a:r>
            <a:r>
              <a:rPr sz="9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5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50                       200</a:t>
            </a:r>
            <a:endParaRPr lang="en-US" altLang="en-US" sz="900" dirty="0"/>
          </a:p>
          <a:p>
            <a:pPr algn="l" rtl="0" eaLnBrk="0">
              <a:lnSpc>
                <a:spcPct val="105000"/>
              </a:lnSpc>
            </a:pPr>
            <a:endParaRPr lang="en-US" altLang="en-US" sz="300" dirty="0"/>
          </a:p>
          <a:p>
            <a:pPr marL="1741170" algn="l" rtl="0" eaLnBrk="0">
              <a:lnSpc>
                <a:spcPct val="78000"/>
              </a:lnSpc>
              <a:spcBef>
                <a:spcPts val="0"/>
              </a:spcBef>
            </a:pPr>
            <a:r>
              <a:rPr sz="1000" kern="0" spc="-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I-A</a:t>
            </a:r>
            <a:endParaRPr lang="en-US" altLang="en-US" sz="1000" dirty="0"/>
          </a:p>
        </p:txBody>
      </p:sp>
      <p:sp>
        <p:nvSpPr>
          <p:cNvPr id="38" name="path"/>
          <p:cNvSpPr/>
          <p:nvPr/>
        </p:nvSpPr>
        <p:spPr>
          <a:xfrm>
            <a:off x="5766746" y="7963434"/>
            <a:ext cx="675964" cy="598187"/>
          </a:xfrm>
          <a:custGeom>
            <a:avLst/>
            <a:gdLst/>
            <a:ahLst/>
            <a:cxnLst/>
            <a:rect l="0" t="0" r="0" b="0"/>
            <a:pathLst>
              <a:path w="1064" h="942">
                <a:moveTo>
                  <a:pt x="928" y="21"/>
                </a:moveTo>
                <a:lnTo>
                  <a:pt x="986" y="72"/>
                </a:lnTo>
                <a:lnTo>
                  <a:pt x="1047" y="132"/>
                </a:lnTo>
                <a:moveTo>
                  <a:pt x="400" y="925"/>
                </a:moveTo>
                <a:lnTo>
                  <a:pt x="329" y="916"/>
                </a:lnTo>
                <a:lnTo>
                  <a:pt x="259" y="895"/>
                </a:lnTo>
                <a:lnTo>
                  <a:pt x="193" y="860"/>
                </a:lnTo>
                <a:lnTo>
                  <a:pt x="140" y="813"/>
                </a:lnTo>
                <a:lnTo>
                  <a:pt x="78" y="766"/>
                </a:lnTo>
                <a:lnTo>
                  <a:pt x="30" y="706"/>
                </a:lnTo>
                <a:lnTo>
                  <a:pt x="16" y="638"/>
                </a:lnTo>
                <a:lnTo>
                  <a:pt x="21" y="569"/>
                </a:lnTo>
                <a:lnTo>
                  <a:pt x="43" y="501"/>
                </a:lnTo>
                <a:lnTo>
                  <a:pt x="69" y="436"/>
                </a:lnTo>
                <a:lnTo>
                  <a:pt x="100" y="372"/>
                </a:lnTo>
                <a:lnTo>
                  <a:pt x="144" y="312"/>
                </a:lnTo>
                <a:lnTo>
                  <a:pt x="201" y="248"/>
                </a:lnTo>
                <a:lnTo>
                  <a:pt x="259" y="205"/>
                </a:lnTo>
                <a:lnTo>
                  <a:pt x="316" y="162"/>
                </a:lnTo>
                <a:lnTo>
                  <a:pt x="382" y="132"/>
                </a:lnTo>
                <a:lnTo>
                  <a:pt x="452" y="98"/>
                </a:lnTo>
                <a:lnTo>
                  <a:pt x="519" y="68"/>
                </a:lnTo>
                <a:lnTo>
                  <a:pt x="589" y="42"/>
                </a:lnTo>
                <a:lnTo>
                  <a:pt x="660" y="21"/>
                </a:lnTo>
                <a:lnTo>
                  <a:pt x="673" y="16"/>
                </a:lnTo>
                <a:lnTo>
                  <a:pt x="737" y="17"/>
                </a:lnTo>
                <a:lnTo>
                  <a:pt x="800" y="18"/>
                </a:lnTo>
                <a:lnTo>
                  <a:pt x="864" y="20"/>
                </a:lnTo>
                <a:lnTo>
                  <a:pt x="928" y="21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grpSp>
        <p:nvGrpSpPr>
          <p:cNvPr id="3" name="group 2"/>
          <p:cNvGrpSpPr/>
          <p:nvPr/>
        </p:nvGrpSpPr>
        <p:grpSpPr>
          <a:xfrm rot="21600000">
            <a:off x="758667" y="8053271"/>
            <a:ext cx="1059227" cy="327687"/>
            <a:chOff x="0" y="0"/>
            <a:chExt cx="1059227" cy="327687"/>
          </a:xfrm>
        </p:grpSpPr>
        <p:sp>
          <p:nvSpPr>
            <p:cNvPr id="40" name="path"/>
            <p:cNvSpPr/>
            <p:nvPr/>
          </p:nvSpPr>
          <p:spPr>
            <a:xfrm>
              <a:off x="0" y="0"/>
              <a:ext cx="121101" cy="327687"/>
            </a:xfrm>
            <a:custGeom>
              <a:avLst/>
              <a:gdLst/>
              <a:ahLst/>
              <a:cxnLst/>
              <a:rect l="0" t="0" r="0" b="0"/>
              <a:pathLst>
                <a:path w="190" h="516">
                  <a:moveTo>
                    <a:pt x="185" y="510"/>
                  </a:moveTo>
                  <a:lnTo>
                    <a:pt x="95" y="510"/>
                  </a:lnTo>
                  <a:moveTo>
                    <a:pt x="185" y="443"/>
                  </a:moveTo>
                  <a:lnTo>
                    <a:pt x="95" y="443"/>
                  </a:lnTo>
                  <a:moveTo>
                    <a:pt x="185" y="364"/>
                  </a:moveTo>
                  <a:lnTo>
                    <a:pt x="95" y="364"/>
                  </a:lnTo>
                  <a:moveTo>
                    <a:pt x="185" y="297"/>
                  </a:moveTo>
                  <a:lnTo>
                    <a:pt x="5" y="297"/>
                  </a:lnTo>
                  <a:moveTo>
                    <a:pt x="185" y="218"/>
                  </a:moveTo>
                  <a:lnTo>
                    <a:pt x="95" y="218"/>
                  </a:lnTo>
                  <a:moveTo>
                    <a:pt x="185" y="151"/>
                  </a:moveTo>
                  <a:lnTo>
                    <a:pt x="95" y="151"/>
                  </a:lnTo>
                  <a:moveTo>
                    <a:pt x="185" y="72"/>
                  </a:moveTo>
                  <a:lnTo>
                    <a:pt x="95" y="72"/>
                  </a:lnTo>
                  <a:moveTo>
                    <a:pt x="185" y="5"/>
                  </a:moveTo>
                  <a:lnTo>
                    <a:pt x="5" y="5"/>
                  </a:lnTo>
                </a:path>
              </a:pathLst>
            </a:custGeom>
            <a:noFill/>
            <a:ln w="7123" cap="sq">
              <a:solidFill>
                <a:srgbClr val="000000">
                  <a:alpha val="100000"/>
                </a:srgbClr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42" name="path"/>
            <p:cNvSpPr/>
            <p:nvPr/>
          </p:nvSpPr>
          <p:spPr>
            <a:xfrm>
              <a:off x="407932" y="382"/>
              <a:ext cx="651294" cy="325403"/>
            </a:xfrm>
            <a:custGeom>
              <a:avLst/>
              <a:gdLst/>
              <a:ahLst/>
              <a:cxnLst/>
              <a:rect l="0" t="0" r="0" b="0"/>
              <a:pathLst>
                <a:path w="1025" h="512">
                  <a:moveTo>
                    <a:pt x="663" y="35"/>
                  </a:moveTo>
                  <a:lnTo>
                    <a:pt x="732" y="25"/>
                  </a:lnTo>
                  <a:lnTo>
                    <a:pt x="822" y="16"/>
                  </a:lnTo>
                  <a:lnTo>
                    <a:pt x="902" y="20"/>
                  </a:lnTo>
                  <a:lnTo>
                    <a:pt x="964" y="42"/>
                  </a:lnTo>
                  <a:lnTo>
                    <a:pt x="995" y="96"/>
                  </a:lnTo>
                  <a:lnTo>
                    <a:pt x="1008" y="159"/>
                  </a:lnTo>
                  <a:lnTo>
                    <a:pt x="1006" y="225"/>
                  </a:lnTo>
                  <a:lnTo>
                    <a:pt x="962" y="281"/>
                  </a:lnTo>
                  <a:lnTo>
                    <a:pt x="904" y="320"/>
                  </a:lnTo>
                  <a:lnTo>
                    <a:pt x="849" y="350"/>
                  </a:lnTo>
                  <a:lnTo>
                    <a:pt x="782" y="375"/>
                  </a:lnTo>
                  <a:lnTo>
                    <a:pt x="709" y="397"/>
                  </a:lnTo>
                  <a:lnTo>
                    <a:pt x="626" y="420"/>
                  </a:lnTo>
                  <a:lnTo>
                    <a:pt x="557" y="441"/>
                  </a:lnTo>
                  <a:lnTo>
                    <a:pt x="493" y="458"/>
                  </a:lnTo>
                  <a:lnTo>
                    <a:pt x="432" y="474"/>
                  </a:lnTo>
                  <a:lnTo>
                    <a:pt x="366" y="484"/>
                  </a:lnTo>
                  <a:lnTo>
                    <a:pt x="296" y="493"/>
                  </a:lnTo>
                  <a:lnTo>
                    <a:pt x="229" y="495"/>
                  </a:lnTo>
                  <a:lnTo>
                    <a:pt x="160" y="486"/>
                  </a:lnTo>
                  <a:lnTo>
                    <a:pt x="99" y="471"/>
                  </a:lnTo>
                  <a:lnTo>
                    <a:pt x="49" y="424"/>
                  </a:lnTo>
                  <a:lnTo>
                    <a:pt x="21" y="367"/>
                  </a:lnTo>
                  <a:lnTo>
                    <a:pt x="16" y="306"/>
                  </a:lnTo>
                  <a:lnTo>
                    <a:pt x="47" y="241"/>
                  </a:lnTo>
                  <a:lnTo>
                    <a:pt x="100" y="195"/>
                  </a:lnTo>
                  <a:lnTo>
                    <a:pt x="154" y="160"/>
                  </a:lnTo>
                  <a:lnTo>
                    <a:pt x="222" y="135"/>
                  </a:lnTo>
                  <a:lnTo>
                    <a:pt x="286" y="111"/>
                  </a:lnTo>
                  <a:lnTo>
                    <a:pt x="347" y="98"/>
                  </a:lnTo>
                  <a:lnTo>
                    <a:pt x="410" y="86"/>
                  </a:lnTo>
                  <a:lnTo>
                    <a:pt x="473" y="73"/>
                  </a:lnTo>
                  <a:lnTo>
                    <a:pt x="536" y="60"/>
                  </a:lnTo>
                  <a:lnTo>
                    <a:pt x="599" y="48"/>
                  </a:lnTo>
                  <a:lnTo>
                    <a:pt x="663" y="35"/>
                  </a:lnTo>
                </a:path>
              </a:pathLst>
            </a:custGeom>
            <a:noFill/>
            <a:ln w="21370" cap="sq">
              <a:solidFill>
                <a:srgbClr val="000000">
                  <a:alpha val="100000"/>
                </a:srgbClr>
              </a:solidFill>
              <a:prstDash val="solid"/>
              <a:miter lim="1000000"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</p:grpSp>
      <p:sp>
        <p:nvSpPr>
          <p:cNvPr id="44" name="textbox 44"/>
          <p:cNvSpPr/>
          <p:nvPr/>
        </p:nvSpPr>
        <p:spPr>
          <a:xfrm>
            <a:off x="846353" y="8760429"/>
            <a:ext cx="1303019" cy="287020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lang="en-US" altLang="en-US" sz="100" dirty="0"/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lang="en-US" altLang="en-US" sz="700" dirty="0"/>
          </a:p>
          <a:p>
            <a:pPr algn="l" rtl="0" eaLnBrk="0">
              <a:lnSpc>
                <a:spcPct val="148000"/>
              </a:lnSpc>
            </a:pPr>
            <a:endParaRPr lang="en-US" altLang="en-US" sz="200" dirty="0"/>
          </a:p>
          <a:p>
            <a:pPr marL="47371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A</a:t>
            </a:r>
            <a:endParaRPr lang="en-US" altLang="en-US" sz="1000" dirty="0"/>
          </a:p>
        </p:txBody>
      </p:sp>
      <p:sp>
        <p:nvSpPr>
          <p:cNvPr id="46" name="textbox 46"/>
          <p:cNvSpPr/>
          <p:nvPr/>
        </p:nvSpPr>
        <p:spPr>
          <a:xfrm>
            <a:off x="3182906" y="8760429"/>
            <a:ext cx="1303019" cy="287020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lang="en-US" altLang="en-US" sz="100" dirty="0"/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lang="en-US" altLang="en-US" sz="700" dirty="0"/>
          </a:p>
          <a:p>
            <a:pPr algn="l" rtl="0" eaLnBrk="0">
              <a:lnSpc>
                <a:spcPct val="148000"/>
              </a:lnSpc>
            </a:pPr>
            <a:endParaRPr lang="en-US" altLang="en-US" sz="200" dirty="0"/>
          </a:p>
          <a:p>
            <a:pPr marL="47371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A</a:t>
            </a:r>
            <a:endParaRPr lang="en-US" altLang="en-US" sz="1000" dirty="0"/>
          </a:p>
        </p:txBody>
      </p:sp>
      <p:sp>
        <p:nvSpPr>
          <p:cNvPr id="48" name="textbox 48"/>
          <p:cNvSpPr/>
          <p:nvPr/>
        </p:nvSpPr>
        <p:spPr>
          <a:xfrm>
            <a:off x="5519459" y="8760429"/>
            <a:ext cx="1303019" cy="287654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lang="en-US" altLang="en-US" sz="100" dirty="0"/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lang="en-US" altLang="en-US" sz="700" dirty="0"/>
          </a:p>
          <a:p>
            <a:pPr algn="l" rtl="0" eaLnBrk="0">
              <a:lnSpc>
                <a:spcPct val="102000"/>
              </a:lnSpc>
            </a:pPr>
            <a:endParaRPr lang="en-US" altLang="en-US" sz="300" dirty="0"/>
          </a:p>
          <a:p>
            <a:pPr marL="537845" algn="l" rtl="0" eaLnBrk="0">
              <a:lnSpc>
                <a:spcPct val="78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I-A</a:t>
            </a:r>
            <a:endParaRPr lang="en-US" altLang="en-US" sz="1000" dirty="0"/>
          </a:p>
        </p:txBody>
      </p:sp>
      <p:grpSp>
        <p:nvGrpSpPr>
          <p:cNvPr id="5" name="group 4"/>
          <p:cNvGrpSpPr/>
          <p:nvPr/>
        </p:nvGrpSpPr>
        <p:grpSpPr>
          <a:xfrm rot="21600000">
            <a:off x="3095220" y="8053271"/>
            <a:ext cx="1097580" cy="266195"/>
            <a:chOff x="0" y="0"/>
            <a:chExt cx="1097580" cy="266195"/>
          </a:xfrm>
        </p:grpSpPr>
        <p:sp>
          <p:nvSpPr>
            <p:cNvPr id="50" name="path"/>
            <p:cNvSpPr/>
            <p:nvPr/>
          </p:nvSpPr>
          <p:spPr>
            <a:xfrm>
              <a:off x="0" y="0"/>
              <a:ext cx="121101" cy="235080"/>
            </a:xfrm>
            <a:custGeom>
              <a:avLst/>
              <a:gdLst/>
              <a:ahLst/>
              <a:cxnLst/>
              <a:rect l="0" t="0" r="0" b="0"/>
              <a:pathLst>
                <a:path w="190" h="370">
                  <a:moveTo>
                    <a:pt x="185" y="364"/>
                  </a:moveTo>
                  <a:lnTo>
                    <a:pt x="95" y="364"/>
                  </a:lnTo>
                  <a:moveTo>
                    <a:pt x="185" y="297"/>
                  </a:moveTo>
                  <a:lnTo>
                    <a:pt x="5" y="297"/>
                  </a:lnTo>
                  <a:moveTo>
                    <a:pt x="185" y="218"/>
                  </a:moveTo>
                  <a:lnTo>
                    <a:pt x="95" y="218"/>
                  </a:lnTo>
                  <a:moveTo>
                    <a:pt x="185" y="151"/>
                  </a:moveTo>
                  <a:lnTo>
                    <a:pt x="95" y="151"/>
                  </a:lnTo>
                  <a:moveTo>
                    <a:pt x="185" y="72"/>
                  </a:moveTo>
                  <a:lnTo>
                    <a:pt x="95" y="72"/>
                  </a:lnTo>
                  <a:moveTo>
                    <a:pt x="185" y="5"/>
                  </a:moveTo>
                  <a:lnTo>
                    <a:pt x="5" y="5"/>
                  </a:lnTo>
                </a:path>
              </a:pathLst>
            </a:custGeom>
            <a:noFill/>
            <a:ln w="7123" cap="sq">
              <a:solidFill>
                <a:srgbClr val="000000">
                  <a:alpha val="100000"/>
                </a:srgbClr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52" name="path"/>
            <p:cNvSpPr/>
            <p:nvPr/>
          </p:nvSpPr>
          <p:spPr>
            <a:xfrm>
              <a:off x="418818" y="8112"/>
              <a:ext cx="678762" cy="258083"/>
            </a:xfrm>
            <a:custGeom>
              <a:avLst/>
              <a:gdLst/>
              <a:ahLst/>
              <a:cxnLst/>
              <a:rect l="0" t="0" r="0" b="0"/>
              <a:pathLst>
                <a:path w="1068" h="406">
                  <a:moveTo>
                    <a:pt x="1016" y="76"/>
                  </a:moveTo>
                  <a:lnTo>
                    <a:pt x="1038" y="153"/>
                  </a:lnTo>
                  <a:lnTo>
                    <a:pt x="1052" y="222"/>
                  </a:lnTo>
                  <a:lnTo>
                    <a:pt x="1052" y="267"/>
                  </a:lnTo>
                  <a:lnTo>
                    <a:pt x="1052" y="312"/>
                  </a:lnTo>
                  <a:lnTo>
                    <a:pt x="1047" y="389"/>
                  </a:lnTo>
                  <a:moveTo>
                    <a:pt x="16" y="381"/>
                  </a:moveTo>
                  <a:lnTo>
                    <a:pt x="60" y="312"/>
                  </a:lnTo>
                  <a:lnTo>
                    <a:pt x="104" y="256"/>
                  </a:lnTo>
                  <a:lnTo>
                    <a:pt x="157" y="205"/>
                  </a:lnTo>
                  <a:lnTo>
                    <a:pt x="228" y="145"/>
                  </a:lnTo>
                  <a:lnTo>
                    <a:pt x="294" y="102"/>
                  </a:lnTo>
                  <a:lnTo>
                    <a:pt x="360" y="68"/>
                  </a:lnTo>
                  <a:lnTo>
                    <a:pt x="426" y="38"/>
                  </a:lnTo>
                  <a:lnTo>
                    <a:pt x="514" y="21"/>
                  </a:lnTo>
                  <a:lnTo>
                    <a:pt x="593" y="16"/>
                  </a:lnTo>
                  <a:lnTo>
                    <a:pt x="664" y="16"/>
                  </a:lnTo>
                  <a:lnTo>
                    <a:pt x="739" y="21"/>
                  </a:lnTo>
                  <a:lnTo>
                    <a:pt x="765" y="25"/>
                  </a:lnTo>
                  <a:lnTo>
                    <a:pt x="828" y="38"/>
                  </a:lnTo>
                  <a:lnTo>
                    <a:pt x="891" y="51"/>
                  </a:lnTo>
                  <a:lnTo>
                    <a:pt x="954" y="63"/>
                  </a:lnTo>
                  <a:lnTo>
                    <a:pt x="1016" y="76"/>
                  </a:lnTo>
                </a:path>
              </a:pathLst>
            </a:custGeom>
            <a:noFill/>
            <a:ln w="21370" cap="sq">
              <a:solidFill>
                <a:srgbClr val="000000">
                  <a:alpha val="100000"/>
                </a:srgbClr>
              </a:solidFill>
              <a:prstDash val="solid"/>
              <a:miter lim="1000000"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</p:grpSp>
      <p:sp>
        <p:nvSpPr>
          <p:cNvPr id="54" name="textbox 54"/>
          <p:cNvSpPr/>
          <p:nvPr/>
        </p:nvSpPr>
        <p:spPr>
          <a:xfrm rot="16200000">
            <a:off x="-952306" y="2214200"/>
            <a:ext cx="3289934" cy="162560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26000"/>
              </a:lnSpc>
            </a:pPr>
            <a:endParaRPr lang="en-US" altLang="en-US" sz="200" dirty="0"/>
          </a:p>
          <a:p>
            <a:pPr marL="12700" algn="l" rtl="0" eaLnBrk="0">
              <a:lnSpc>
                <a:spcPct val="81000"/>
              </a:lnSpc>
              <a:spcBef>
                <a:spcPts val="0"/>
              </a:spcBef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5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0</a:t>
            </a:r>
            <a:r>
              <a:rPr sz="900" kern="0" spc="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5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00</a:t>
            </a:r>
            <a:r>
              <a:rPr sz="900" kern="0" spc="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5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00</a:t>
            </a:r>
            <a:r>
              <a:rPr sz="900" kern="0" spc="-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endParaRPr lang="en-US" altLang="en-US" sz="900" dirty="0"/>
          </a:p>
        </p:txBody>
      </p:sp>
      <p:sp>
        <p:nvSpPr>
          <p:cNvPr id="56" name="path"/>
          <p:cNvSpPr/>
          <p:nvPr/>
        </p:nvSpPr>
        <p:spPr>
          <a:xfrm>
            <a:off x="3451402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8" name="path"/>
          <p:cNvSpPr/>
          <p:nvPr/>
        </p:nvSpPr>
        <p:spPr>
          <a:xfrm>
            <a:off x="4235002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0" name="path"/>
          <p:cNvSpPr/>
          <p:nvPr/>
        </p:nvSpPr>
        <p:spPr>
          <a:xfrm>
            <a:off x="3259063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2" name="path"/>
          <p:cNvSpPr/>
          <p:nvPr/>
        </p:nvSpPr>
        <p:spPr>
          <a:xfrm>
            <a:off x="4042664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51" y="5"/>
                </a:moveTo>
                <a:lnTo>
                  <a:pt x="151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4" name="path"/>
          <p:cNvSpPr/>
          <p:nvPr/>
        </p:nvSpPr>
        <p:spPr>
          <a:xfrm>
            <a:off x="3843202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6" name="path"/>
          <p:cNvSpPr/>
          <p:nvPr/>
        </p:nvSpPr>
        <p:spPr>
          <a:xfrm>
            <a:off x="3650863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8" name="path"/>
          <p:cNvSpPr/>
          <p:nvPr/>
        </p:nvSpPr>
        <p:spPr>
          <a:xfrm>
            <a:off x="3209198" y="8608915"/>
            <a:ext cx="1239512" cy="64112"/>
          </a:xfrm>
          <a:custGeom>
            <a:avLst/>
            <a:gdLst/>
            <a:ahLst/>
            <a:cxnLst/>
            <a:rect l="0" t="0" r="0" b="0"/>
            <a:pathLst>
              <a:path w="1951" h="100">
                <a:moveTo>
                  <a:pt x="1935" y="5"/>
                </a:moveTo>
                <a:lnTo>
                  <a:pt x="1935" y="95"/>
                </a:lnTo>
                <a:moveTo>
                  <a:pt x="5" y="5"/>
                </a:moveTo>
                <a:lnTo>
                  <a:pt x="1946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0" name="path"/>
          <p:cNvSpPr/>
          <p:nvPr/>
        </p:nvSpPr>
        <p:spPr>
          <a:xfrm>
            <a:off x="3472077" y="8292655"/>
            <a:ext cx="505323" cy="323383"/>
          </a:xfrm>
          <a:custGeom>
            <a:avLst/>
            <a:gdLst/>
            <a:ahLst/>
            <a:cxnLst/>
            <a:rect l="0" t="0" r="0" b="0"/>
            <a:pathLst>
              <a:path w="795" h="509">
                <a:moveTo>
                  <a:pt x="778" y="436"/>
                </a:moveTo>
                <a:lnTo>
                  <a:pt x="699" y="466"/>
                </a:lnTo>
                <a:lnTo>
                  <a:pt x="615" y="479"/>
                </a:lnTo>
                <a:moveTo>
                  <a:pt x="474" y="488"/>
                </a:moveTo>
                <a:lnTo>
                  <a:pt x="400" y="492"/>
                </a:lnTo>
                <a:lnTo>
                  <a:pt x="325" y="492"/>
                </a:lnTo>
                <a:moveTo>
                  <a:pt x="254" y="492"/>
                </a:moveTo>
                <a:lnTo>
                  <a:pt x="175" y="466"/>
                </a:lnTo>
                <a:moveTo>
                  <a:pt x="47" y="385"/>
                </a:moveTo>
                <a:lnTo>
                  <a:pt x="21" y="303"/>
                </a:lnTo>
                <a:lnTo>
                  <a:pt x="16" y="231"/>
                </a:lnTo>
                <a:moveTo>
                  <a:pt x="38" y="89"/>
                </a:moveTo>
                <a:lnTo>
                  <a:pt x="82" y="16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2" name="path"/>
          <p:cNvSpPr/>
          <p:nvPr/>
        </p:nvSpPr>
        <p:spPr>
          <a:xfrm>
            <a:off x="3491659" y="8406930"/>
            <a:ext cx="659180" cy="209108"/>
          </a:xfrm>
          <a:custGeom>
            <a:avLst/>
            <a:gdLst/>
            <a:ahLst/>
            <a:cxnLst/>
            <a:rect l="0" t="0" r="0" b="0"/>
            <a:pathLst>
              <a:path w="1038" h="329">
                <a:moveTo>
                  <a:pt x="1021" y="16"/>
                </a:moveTo>
                <a:lnTo>
                  <a:pt x="981" y="81"/>
                </a:lnTo>
                <a:lnTo>
                  <a:pt x="928" y="132"/>
                </a:lnTo>
                <a:lnTo>
                  <a:pt x="875" y="179"/>
                </a:lnTo>
                <a:lnTo>
                  <a:pt x="809" y="222"/>
                </a:lnTo>
                <a:lnTo>
                  <a:pt x="748" y="256"/>
                </a:lnTo>
                <a:moveTo>
                  <a:pt x="585" y="299"/>
                </a:moveTo>
                <a:lnTo>
                  <a:pt x="514" y="308"/>
                </a:lnTo>
                <a:lnTo>
                  <a:pt x="444" y="308"/>
                </a:lnTo>
                <a:moveTo>
                  <a:pt x="294" y="312"/>
                </a:moveTo>
                <a:lnTo>
                  <a:pt x="223" y="312"/>
                </a:lnTo>
                <a:moveTo>
                  <a:pt x="144" y="286"/>
                </a:moveTo>
                <a:lnTo>
                  <a:pt x="74" y="256"/>
                </a:lnTo>
                <a:lnTo>
                  <a:pt x="16" y="205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4" name="textbox 74"/>
          <p:cNvSpPr/>
          <p:nvPr/>
        </p:nvSpPr>
        <p:spPr>
          <a:xfrm>
            <a:off x="468099" y="9566299"/>
            <a:ext cx="949325" cy="16128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lang="en-US" altLang="en-US" sz="100" dirty="0"/>
          </a:p>
          <a:p>
            <a:pPr marL="12700" algn="l" rtl="0" eaLnBrk="0">
              <a:lnSpc>
                <a:spcPts val="1065"/>
              </a:lnSpc>
            </a:pPr>
            <a:r>
              <a:rPr sz="800" kern="0" spc="-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Fit</a:t>
            </a:r>
            <a:r>
              <a:rPr sz="8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800" kern="0" spc="-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LTV4.1.</a:t>
            </a:r>
            <a:r>
              <a:rPr sz="8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(Win)</a:t>
            </a:r>
            <a:endParaRPr lang="en-US" altLang="en-US" sz="800" dirty="0"/>
          </a:p>
        </p:txBody>
      </p:sp>
      <p:sp>
        <p:nvSpPr>
          <p:cNvPr id="76" name="textbox 76"/>
          <p:cNvSpPr/>
          <p:nvPr/>
        </p:nvSpPr>
        <p:spPr>
          <a:xfrm rot="16200000">
            <a:off x="2389390" y="7948715"/>
            <a:ext cx="1245869" cy="141604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lang="en-US" altLang="en-US" sz="200" dirty="0"/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lang="en-US" altLang="en-US" sz="700" dirty="0"/>
          </a:p>
        </p:txBody>
      </p:sp>
      <p:sp>
        <p:nvSpPr>
          <p:cNvPr id="78" name="textbox 78"/>
          <p:cNvSpPr/>
          <p:nvPr/>
        </p:nvSpPr>
        <p:spPr>
          <a:xfrm rot="16200000">
            <a:off x="52837" y="7948715"/>
            <a:ext cx="1245869" cy="141604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lang="en-US" altLang="en-US" sz="200" dirty="0"/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lang="en-US" altLang="en-US" sz="700" dirty="0"/>
          </a:p>
        </p:txBody>
      </p:sp>
      <p:sp>
        <p:nvSpPr>
          <p:cNvPr id="80" name="textbox 80"/>
          <p:cNvSpPr/>
          <p:nvPr/>
        </p:nvSpPr>
        <p:spPr>
          <a:xfrm rot="16200000">
            <a:off x="4725942" y="7948715"/>
            <a:ext cx="1245869" cy="141604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lang="en-US" altLang="en-US" sz="200" dirty="0"/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lang="en-US" altLang="en-US" sz="700" dirty="0"/>
          </a:p>
        </p:txBody>
      </p:sp>
      <p:sp>
        <p:nvSpPr>
          <p:cNvPr id="82" name="path"/>
          <p:cNvSpPr/>
          <p:nvPr/>
        </p:nvSpPr>
        <p:spPr>
          <a:xfrm>
            <a:off x="1506649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4" name="path"/>
          <p:cNvSpPr/>
          <p:nvPr/>
        </p:nvSpPr>
        <p:spPr>
          <a:xfrm>
            <a:off x="1898449" y="8608915"/>
            <a:ext cx="156720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6" name="path"/>
          <p:cNvSpPr/>
          <p:nvPr/>
        </p:nvSpPr>
        <p:spPr>
          <a:xfrm>
            <a:off x="1114849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88" name="path"/>
          <p:cNvSpPr/>
          <p:nvPr/>
        </p:nvSpPr>
        <p:spPr>
          <a:xfrm>
            <a:off x="13143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0" name="path"/>
          <p:cNvSpPr/>
          <p:nvPr/>
        </p:nvSpPr>
        <p:spPr>
          <a:xfrm>
            <a:off x="17061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51" y="5"/>
                </a:moveTo>
                <a:lnTo>
                  <a:pt x="151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2" name="path"/>
          <p:cNvSpPr/>
          <p:nvPr/>
        </p:nvSpPr>
        <p:spPr>
          <a:xfrm>
            <a:off x="9225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4" name="path"/>
          <p:cNvSpPr/>
          <p:nvPr/>
        </p:nvSpPr>
        <p:spPr>
          <a:xfrm>
            <a:off x="872645" y="8608915"/>
            <a:ext cx="1239512" cy="64112"/>
          </a:xfrm>
          <a:custGeom>
            <a:avLst/>
            <a:gdLst/>
            <a:ahLst/>
            <a:cxnLst/>
            <a:rect l="0" t="0" r="0" b="0"/>
            <a:pathLst>
              <a:path w="1951" h="100">
                <a:moveTo>
                  <a:pt x="1935" y="5"/>
                </a:moveTo>
                <a:lnTo>
                  <a:pt x="1935" y="95"/>
                </a:lnTo>
                <a:moveTo>
                  <a:pt x="5" y="5"/>
                </a:moveTo>
                <a:lnTo>
                  <a:pt x="1946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6" name="path"/>
          <p:cNvSpPr/>
          <p:nvPr/>
        </p:nvSpPr>
        <p:spPr>
          <a:xfrm>
            <a:off x="5787955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8" name="path"/>
          <p:cNvSpPr/>
          <p:nvPr/>
        </p:nvSpPr>
        <p:spPr>
          <a:xfrm>
            <a:off x="5987417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0" name="path"/>
          <p:cNvSpPr/>
          <p:nvPr/>
        </p:nvSpPr>
        <p:spPr>
          <a:xfrm>
            <a:off x="6179754" y="8608915"/>
            <a:ext cx="156720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2" name="path"/>
          <p:cNvSpPr/>
          <p:nvPr/>
        </p:nvSpPr>
        <p:spPr>
          <a:xfrm>
            <a:off x="5595616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4" name="path"/>
          <p:cNvSpPr/>
          <p:nvPr/>
        </p:nvSpPr>
        <p:spPr>
          <a:xfrm>
            <a:off x="6571555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6" name="path"/>
          <p:cNvSpPr/>
          <p:nvPr/>
        </p:nvSpPr>
        <p:spPr>
          <a:xfrm>
            <a:off x="6379216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51" y="5"/>
                </a:moveTo>
                <a:lnTo>
                  <a:pt x="151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8" name="path"/>
          <p:cNvSpPr/>
          <p:nvPr/>
        </p:nvSpPr>
        <p:spPr>
          <a:xfrm>
            <a:off x="5545751" y="8608915"/>
            <a:ext cx="1239512" cy="64112"/>
          </a:xfrm>
          <a:custGeom>
            <a:avLst/>
            <a:gdLst/>
            <a:ahLst/>
            <a:cxnLst/>
            <a:rect l="0" t="0" r="0" b="0"/>
            <a:pathLst>
              <a:path w="1951" h="100">
                <a:moveTo>
                  <a:pt x="1935" y="5"/>
                </a:moveTo>
                <a:lnTo>
                  <a:pt x="1935" y="95"/>
                </a:lnTo>
                <a:moveTo>
                  <a:pt x="5" y="5"/>
                </a:moveTo>
                <a:lnTo>
                  <a:pt x="1946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10" name="path"/>
          <p:cNvSpPr/>
          <p:nvPr/>
        </p:nvSpPr>
        <p:spPr>
          <a:xfrm>
            <a:off x="758667" y="7490504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12" name="path"/>
          <p:cNvSpPr/>
          <p:nvPr/>
        </p:nvSpPr>
        <p:spPr>
          <a:xfrm>
            <a:off x="758667" y="8608915"/>
            <a:ext cx="121101" cy="7123"/>
          </a:xfrm>
          <a:custGeom>
            <a:avLst/>
            <a:gdLst/>
            <a:ahLst/>
            <a:cxnLst/>
            <a:rect l="0" t="0" r="0" b="0"/>
            <a:pathLst>
              <a:path w="190" h="11"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14" name="path"/>
          <p:cNvSpPr/>
          <p:nvPr/>
        </p:nvSpPr>
        <p:spPr>
          <a:xfrm>
            <a:off x="758667" y="8423700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16" name="path"/>
          <p:cNvSpPr/>
          <p:nvPr/>
        </p:nvSpPr>
        <p:spPr>
          <a:xfrm>
            <a:off x="758667" y="7860933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62"/>
                </a:moveTo>
                <a:lnTo>
                  <a:pt x="95" y="162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18" name="path"/>
          <p:cNvSpPr/>
          <p:nvPr/>
        </p:nvSpPr>
        <p:spPr>
          <a:xfrm>
            <a:off x="758667" y="7675719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20" name="path"/>
          <p:cNvSpPr/>
          <p:nvPr/>
        </p:nvSpPr>
        <p:spPr>
          <a:xfrm>
            <a:off x="815656" y="7426391"/>
            <a:ext cx="64112" cy="1189647"/>
          </a:xfrm>
          <a:custGeom>
            <a:avLst/>
            <a:gdLst/>
            <a:ahLst/>
            <a:cxnLst/>
            <a:rect l="0" t="0" r="0" b="0"/>
            <a:pathLst>
              <a:path w="100" h="1873">
                <a:moveTo>
                  <a:pt x="95" y="39"/>
                </a:moveTo>
                <a:lnTo>
                  <a:pt x="5" y="39"/>
                </a:lnTo>
                <a:moveTo>
                  <a:pt x="95" y="1867"/>
                </a:moveTo>
                <a:lnTo>
                  <a:pt x="9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22" name="path"/>
          <p:cNvSpPr/>
          <p:nvPr/>
        </p:nvSpPr>
        <p:spPr>
          <a:xfrm>
            <a:off x="3095220" y="8608915"/>
            <a:ext cx="121101" cy="7123"/>
          </a:xfrm>
          <a:custGeom>
            <a:avLst/>
            <a:gdLst/>
            <a:ahLst/>
            <a:cxnLst/>
            <a:rect l="0" t="0" r="0" b="0"/>
            <a:pathLst>
              <a:path w="190" h="11"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24" name="path"/>
          <p:cNvSpPr/>
          <p:nvPr/>
        </p:nvSpPr>
        <p:spPr>
          <a:xfrm>
            <a:off x="3095220" y="8423700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26" name="path"/>
          <p:cNvSpPr/>
          <p:nvPr/>
        </p:nvSpPr>
        <p:spPr>
          <a:xfrm>
            <a:off x="3095220" y="7860933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62"/>
                </a:moveTo>
                <a:lnTo>
                  <a:pt x="95" y="162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28" name="path"/>
          <p:cNvSpPr/>
          <p:nvPr/>
        </p:nvSpPr>
        <p:spPr>
          <a:xfrm>
            <a:off x="3152209" y="8331093"/>
            <a:ext cx="64112" cy="49865"/>
          </a:xfrm>
          <a:custGeom>
            <a:avLst/>
            <a:gdLst/>
            <a:ahLst/>
            <a:cxnLst/>
            <a:rect l="0" t="0" r="0" b="0"/>
            <a:pathLst>
              <a:path w="100" h="78">
                <a:moveTo>
                  <a:pt x="95" y="72"/>
                </a:moveTo>
                <a:lnTo>
                  <a:pt x="5" y="72"/>
                </a:lnTo>
                <a:moveTo>
                  <a:pt x="9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30" name="path"/>
          <p:cNvSpPr/>
          <p:nvPr/>
        </p:nvSpPr>
        <p:spPr>
          <a:xfrm>
            <a:off x="3095220" y="7490504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32" name="path"/>
          <p:cNvSpPr/>
          <p:nvPr/>
        </p:nvSpPr>
        <p:spPr>
          <a:xfrm>
            <a:off x="3095220" y="7675719"/>
            <a:ext cx="121101" cy="149596"/>
          </a:xfrm>
          <a:custGeom>
            <a:avLst/>
            <a:gdLst/>
            <a:ahLst/>
            <a:cxnLst/>
            <a:rect l="0" t="0" r="0" b="0"/>
            <a:pathLst>
              <a:path w="190" h="235">
                <a:moveTo>
                  <a:pt x="185" y="229"/>
                </a:moveTo>
                <a:lnTo>
                  <a:pt x="95" y="229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84"/>
                </a:moveTo>
                <a:lnTo>
                  <a:pt x="95" y="84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34" name="path"/>
          <p:cNvSpPr/>
          <p:nvPr/>
        </p:nvSpPr>
        <p:spPr>
          <a:xfrm>
            <a:off x="3152209" y="7426391"/>
            <a:ext cx="64112" cy="1189647"/>
          </a:xfrm>
          <a:custGeom>
            <a:avLst/>
            <a:gdLst/>
            <a:ahLst/>
            <a:cxnLst/>
            <a:rect l="0" t="0" r="0" b="0"/>
            <a:pathLst>
              <a:path w="100" h="1873">
                <a:moveTo>
                  <a:pt x="95" y="39"/>
                </a:moveTo>
                <a:lnTo>
                  <a:pt x="5" y="39"/>
                </a:lnTo>
                <a:moveTo>
                  <a:pt x="95" y="1867"/>
                </a:moveTo>
                <a:lnTo>
                  <a:pt x="9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36" name="textbox 136"/>
          <p:cNvSpPr/>
          <p:nvPr/>
        </p:nvSpPr>
        <p:spPr>
          <a:xfrm>
            <a:off x="3991524" y="454610"/>
            <a:ext cx="309245" cy="286384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4000"/>
              </a:lnSpc>
            </a:pPr>
            <a:endParaRPr lang="en-US" altLang="en-US" sz="100" dirty="0"/>
          </a:p>
          <a:p>
            <a:pPr marL="12700" algn="l" rtl="0" eaLnBrk="0">
              <a:lnSpc>
                <a:spcPct val="122000"/>
              </a:lnSpc>
            </a:pP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</a:t>
            </a:r>
            <a:endParaRPr lang="en-US" altLang="en-US" sz="700" dirty="0"/>
          </a:p>
        </p:txBody>
      </p:sp>
      <p:sp>
        <p:nvSpPr>
          <p:cNvPr id="138" name="path"/>
          <p:cNvSpPr/>
          <p:nvPr/>
        </p:nvSpPr>
        <p:spPr>
          <a:xfrm>
            <a:off x="6203142" y="8289934"/>
            <a:ext cx="270340" cy="247200"/>
          </a:xfrm>
          <a:custGeom>
            <a:avLst/>
            <a:gdLst/>
            <a:ahLst/>
            <a:cxnLst/>
            <a:rect l="0" t="0" r="0" b="0"/>
            <a:pathLst>
              <a:path w="425" h="389">
                <a:moveTo>
                  <a:pt x="408" y="16"/>
                </a:moveTo>
                <a:lnTo>
                  <a:pt x="364" y="76"/>
                </a:lnTo>
                <a:lnTo>
                  <a:pt x="311" y="128"/>
                </a:lnTo>
                <a:lnTo>
                  <a:pt x="254" y="188"/>
                </a:lnTo>
                <a:lnTo>
                  <a:pt x="193" y="243"/>
                </a:lnTo>
                <a:lnTo>
                  <a:pt x="135" y="291"/>
                </a:lnTo>
                <a:lnTo>
                  <a:pt x="78" y="333"/>
                </a:lnTo>
                <a:lnTo>
                  <a:pt x="16" y="372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40" name="textbox 140"/>
          <p:cNvSpPr/>
          <p:nvPr/>
        </p:nvSpPr>
        <p:spPr>
          <a:xfrm rot="16200000">
            <a:off x="310755" y="2249794"/>
            <a:ext cx="421640" cy="18668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lang="en-US" altLang="en-US" sz="100" dirty="0"/>
          </a:p>
          <a:p>
            <a:pPr marL="12700" algn="l" rtl="0" eaLnBrk="0">
              <a:lnSpc>
                <a:spcPts val="1270"/>
              </a:lnSpc>
            </a:pPr>
            <a:r>
              <a:rPr sz="900" kern="0" spc="-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umber</a:t>
            </a:r>
            <a:endParaRPr lang="en-US" altLang="en-US" sz="900" dirty="0"/>
          </a:p>
        </p:txBody>
      </p:sp>
      <p:sp>
        <p:nvSpPr>
          <p:cNvPr id="142" name="path"/>
          <p:cNvSpPr/>
          <p:nvPr/>
        </p:nvSpPr>
        <p:spPr>
          <a:xfrm>
            <a:off x="787161" y="2860140"/>
            <a:ext cx="135349" cy="427418"/>
          </a:xfrm>
          <a:custGeom>
            <a:avLst/>
            <a:gdLst/>
            <a:ahLst/>
            <a:cxnLst/>
            <a:rect l="0" t="0" r="0" b="0"/>
            <a:pathLst>
              <a:path w="213" h="673">
                <a:moveTo>
                  <a:pt x="207" y="667"/>
                </a:moveTo>
                <a:lnTo>
                  <a:pt x="106" y="667"/>
                </a:lnTo>
                <a:moveTo>
                  <a:pt x="207" y="499"/>
                </a:moveTo>
                <a:lnTo>
                  <a:pt x="106" y="499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73"/>
                </a:moveTo>
                <a:lnTo>
                  <a:pt x="106" y="173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44" name="path"/>
          <p:cNvSpPr/>
          <p:nvPr/>
        </p:nvSpPr>
        <p:spPr>
          <a:xfrm>
            <a:off x="5431773" y="7447762"/>
            <a:ext cx="121101" cy="470159"/>
          </a:xfrm>
          <a:custGeom>
            <a:avLst/>
            <a:gdLst/>
            <a:ahLst/>
            <a:cxnLst/>
            <a:rect l="0" t="0" r="0" b="0"/>
            <a:pathLst>
              <a:path w="190" h="740">
                <a:moveTo>
                  <a:pt x="185" y="734"/>
                </a:moveTo>
                <a:lnTo>
                  <a:pt x="95" y="734"/>
                </a:lnTo>
                <a:moveTo>
                  <a:pt x="185" y="656"/>
                </a:moveTo>
                <a:lnTo>
                  <a:pt x="5" y="656"/>
                </a:lnTo>
                <a:moveTo>
                  <a:pt x="185" y="588"/>
                </a:moveTo>
                <a:lnTo>
                  <a:pt x="95" y="588"/>
                </a:lnTo>
                <a:moveTo>
                  <a:pt x="185" y="510"/>
                </a:moveTo>
                <a:lnTo>
                  <a:pt x="95" y="510"/>
                </a:lnTo>
                <a:moveTo>
                  <a:pt x="185" y="443"/>
                </a:moveTo>
                <a:lnTo>
                  <a:pt x="95" y="443"/>
                </a:lnTo>
                <a:moveTo>
                  <a:pt x="185" y="364"/>
                </a:moveTo>
                <a:lnTo>
                  <a:pt x="5" y="364"/>
                </a:lnTo>
                <a:moveTo>
                  <a:pt x="185" y="297"/>
                </a:moveTo>
                <a:lnTo>
                  <a:pt x="95" y="297"/>
                </a:lnTo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5" y="72"/>
                </a:lnTo>
                <a:moveTo>
                  <a:pt x="185" y="5"/>
                </a:moveTo>
                <a:lnTo>
                  <a:pt x="9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46" name="path"/>
          <p:cNvSpPr/>
          <p:nvPr/>
        </p:nvSpPr>
        <p:spPr>
          <a:xfrm>
            <a:off x="787161" y="2347238"/>
            <a:ext cx="135349" cy="420294"/>
          </a:xfrm>
          <a:custGeom>
            <a:avLst/>
            <a:gdLst/>
            <a:ahLst/>
            <a:cxnLst/>
            <a:rect l="0" t="0" r="0" b="0"/>
            <a:pathLst>
              <a:path w="213" h="661">
                <a:moveTo>
                  <a:pt x="207" y="656"/>
                </a:moveTo>
                <a:lnTo>
                  <a:pt x="106" y="656"/>
                </a:lnTo>
                <a:moveTo>
                  <a:pt x="207" y="487"/>
                </a:moveTo>
                <a:lnTo>
                  <a:pt x="106" y="487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62"/>
                </a:moveTo>
                <a:lnTo>
                  <a:pt x="106" y="162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48" name="path"/>
          <p:cNvSpPr/>
          <p:nvPr/>
        </p:nvSpPr>
        <p:spPr>
          <a:xfrm>
            <a:off x="787161" y="787162"/>
            <a:ext cx="135349" cy="420294"/>
          </a:xfrm>
          <a:custGeom>
            <a:avLst/>
            <a:gdLst/>
            <a:ahLst/>
            <a:cxnLst/>
            <a:rect l="0" t="0" r="0" b="0"/>
            <a:pathLst>
              <a:path w="213" h="661">
                <a:moveTo>
                  <a:pt x="207" y="656"/>
                </a:moveTo>
                <a:lnTo>
                  <a:pt x="106" y="656"/>
                </a:lnTo>
                <a:moveTo>
                  <a:pt x="207" y="499"/>
                </a:moveTo>
                <a:lnTo>
                  <a:pt x="106" y="499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73"/>
                </a:moveTo>
                <a:lnTo>
                  <a:pt x="106" y="173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50" name="path"/>
          <p:cNvSpPr/>
          <p:nvPr/>
        </p:nvSpPr>
        <p:spPr>
          <a:xfrm>
            <a:off x="787161" y="1827213"/>
            <a:ext cx="135349" cy="420294"/>
          </a:xfrm>
          <a:custGeom>
            <a:avLst/>
            <a:gdLst/>
            <a:ahLst/>
            <a:cxnLst/>
            <a:rect l="0" t="0" r="0" b="0"/>
            <a:pathLst>
              <a:path w="213" h="661">
                <a:moveTo>
                  <a:pt x="207" y="656"/>
                </a:moveTo>
                <a:lnTo>
                  <a:pt x="106" y="656"/>
                </a:lnTo>
                <a:moveTo>
                  <a:pt x="207" y="487"/>
                </a:moveTo>
                <a:lnTo>
                  <a:pt x="106" y="487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62"/>
                </a:moveTo>
                <a:lnTo>
                  <a:pt x="106" y="162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52" name="path"/>
          <p:cNvSpPr/>
          <p:nvPr/>
        </p:nvSpPr>
        <p:spPr>
          <a:xfrm>
            <a:off x="787161" y="1307187"/>
            <a:ext cx="135349" cy="420294"/>
          </a:xfrm>
          <a:custGeom>
            <a:avLst/>
            <a:gdLst/>
            <a:ahLst/>
            <a:cxnLst/>
            <a:rect l="0" t="0" r="0" b="0"/>
            <a:pathLst>
              <a:path w="213" h="661">
                <a:moveTo>
                  <a:pt x="207" y="656"/>
                </a:moveTo>
                <a:lnTo>
                  <a:pt x="106" y="656"/>
                </a:lnTo>
                <a:moveTo>
                  <a:pt x="207" y="499"/>
                </a:moveTo>
                <a:lnTo>
                  <a:pt x="106" y="499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62"/>
                </a:moveTo>
                <a:lnTo>
                  <a:pt x="106" y="162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54" name="textbox 154"/>
          <p:cNvSpPr/>
          <p:nvPr/>
        </p:nvSpPr>
        <p:spPr>
          <a:xfrm>
            <a:off x="3805569" y="696814"/>
            <a:ext cx="434975" cy="16128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lang="en-US" altLang="en-US" sz="100" dirty="0"/>
          </a:p>
          <a:p>
            <a:pPr marL="133350" algn="l" rtl="0" eaLnBrk="0">
              <a:lnSpc>
                <a:spcPts val="1065"/>
              </a:lnSpc>
              <a:tabLst>
                <a:tab pos="198120" algn="l"/>
              </a:tabLst>
            </a:pPr>
            <a:r>
              <a:rPr sz="8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8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S</a:t>
            </a:r>
            <a:endParaRPr lang="en-US" altLang="en-US" sz="800" dirty="0"/>
          </a:p>
        </p:txBody>
      </p:sp>
      <p:pic>
        <p:nvPicPr>
          <p:cNvPr id="156" name="picture 15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21600000">
            <a:off x="3818269" y="719487"/>
            <a:ext cx="121101" cy="99731"/>
          </a:xfrm>
          <a:prstGeom prst="rect">
            <a:avLst/>
          </a:prstGeom>
        </p:spPr>
      </p:pic>
      <p:sp>
        <p:nvSpPr>
          <p:cNvPr id="158" name="textbox 158"/>
          <p:cNvSpPr/>
          <p:nvPr/>
        </p:nvSpPr>
        <p:spPr>
          <a:xfrm rot="16200000">
            <a:off x="315261" y="7933009"/>
            <a:ext cx="407034" cy="174625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34000"/>
              </a:lnSpc>
            </a:pPr>
            <a:endParaRPr lang="en-US" altLang="en-US" sz="200" dirty="0"/>
          </a:p>
          <a:p>
            <a:pPr marL="1270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W</a:t>
            </a:r>
            <a:endParaRPr lang="en-US" altLang="en-US" sz="1000" dirty="0"/>
          </a:p>
        </p:txBody>
      </p:sp>
      <p:sp>
        <p:nvSpPr>
          <p:cNvPr id="160" name="textbox 160"/>
          <p:cNvSpPr/>
          <p:nvPr/>
        </p:nvSpPr>
        <p:spPr>
          <a:xfrm rot="16200000">
            <a:off x="2662193" y="7926484"/>
            <a:ext cx="386079" cy="174625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34000"/>
              </a:lnSpc>
            </a:pPr>
            <a:endParaRPr lang="en-US" altLang="en-US" sz="200" dirty="0"/>
          </a:p>
          <a:p>
            <a:pPr marL="1270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5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SC-A</a:t>
            </a:r>
            <a:endParaRPr lang="en-US" altLang="en-US" sz="1000" dirty="0"/>
          </a:p>
        </p:txBody>
      </p:sp>
      <p:sp>
        <p:nvSpPr>
          <p:cNvPr id="162" name="path"/>
          <p:cNvSpPr/>
          <p:nvPr/>
        </p:nvSpPr>
        <p:spPr>
          <a:xfrm>
            <a:off x="787161" y="3380165"/>
            <a:ext cx="135349" cy="213709"/>
          </a:xfrm>
          <a:custGeom>
            <a:avLst/>
            <a:gdLst/>
            <a:ahLst/>
            <a:cxnLst/>
            <a:rect l="0" t="0" r="0" b="0"/>
            <a:pathLst>
              <a:path w="213" h="336">
                <a:moveTo>
                  <a:pt x="207" y="330"/>
                </a:moveTo>
                <a:lnTo>
                  <a:pt x="106" y="330"/>
                </a:lnTo>
                <a:moveTo>
                  <a:pt x="207" y="173"/>
                </a:moveTo>
                <a:lnTo>
                  <a:pt x="106" y="173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pic>
        <p:nvPicPr>
          <p:cNvPr id="164" name="picture 16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21600000">
            <a:off x="3818269" y="477284"/>
            <a:ext cx="121101" cy="220832"/>
          </a:xfrm>
          <a:prstGeom prst="rect">
            <a:avLst/>
          </a:prstGeom>
        </p:spPr>
      </p:pic>
      <p:sp>
        <p:nvSpPr>
          <p:cNvPr id="166" name="path"/>
          <p:cNvSpPr/>
          <p:nvPr/>
        </p:nvSpPr>
        <p:spPr>
          <a:xfrm>
            <a:off x="787161" y="3900191"/>
            <a:ext cx="135349" cy="7123"/>
          </a:xfrm>
          <a:custGeom>
            <a:avLst/>
            <a:gdLst/>
            <a:ahLst/>
            <a:cxnLst/>
            <a:rect l="0" t="0" r="0" b="0"/>
            <a:pathLst>
              <a:path w="213" h="11"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68" name="path"/>
          <p:cNvSpPr/>
          <p:nvPr/>
        </p:nvSpPr>
        <p:spPr>
          <a:xfrm>
            <a:off x="851274" y="3693605"/>
            <a:ext cx="71236" cy="106854"/>
          </a:xfrm>
          <a:custGeom>
            <a:avLst/>
            <a:gdLst/>
            <a:ahLst/>
            <a:cxnLst/>
            <a:rect l="0" t="0" r="0" b="0"/>
            <a:pathLst>
              <a:path w="112" h="168">
                <a:moveTo>
                  <a:pt x="106" y="162"/>
                </a:moveTo>
                <a:lnTo>
                  <a:pt x="5" y="162"/>
                </a:lnTo>
                <a:moveTo>
                  <a:pt x="106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70" name="path"/>
          <p:cNvSpPr/>
          <p:nvPr/>
        </p:nvSpPr>
        <p:spPr>
          <a:xfrm>
            <a:off x="915387" y="787162"/>
            <a:ext cx="7123" cy="3120152"/>
          </a:xfrm>
          <a:custGeom>
            <a:avLst/>
            <a:gdLst/>
            <a:ahLst/>
            <a:cxnLst/>
            <a:rect l="0" t="0" r="0" b="0"/>
            <a:pathLst>
              <a:path w="11" h="4913">
                <a:moveTo>
                  <a:pt x="5" y="4908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72" name="textbox 172"/>
          <p:cNvSpPr/>
          <p:nvPr/>
        </p:nvSpPr>
        <p:spPr>
          <a:xfrm rot="16200000">
            <a:off x="5062046" y="7924598"/>
            <a:ext cx="259715" cy="168910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132000"/>
              </a:lnSpc>
            </a:pPr>
            <a:endParaRPr lang="en-US" altLang="en-US" sz="200" dirty="0"/>
          </a:p>
          <a:p>
            <a:pPr marL="12700" algn="l" rtl="0" eaLnBrk="0">
              <a:lnSpc>
                <a:spcPct val="84000"/>
              </a:lnSpc>
              <a:spcBef>
                <a:spcPts val="0"/>
              </a:spcBef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</a:t>
            </a:r>
            <a:r>
              <a:rPr sz="900" kern="0" spc="-1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I-H</a:t>
            </a:r>
            <a:endParaRPr lang="en-US" altLang="en-US" sz="900" dirty="0"/>
          </a:p>
        </p:txBody>
      </p:sp>
      <p:sp>
        <p:nvSpPr>
          <p:cNvPr id="174" name="path"/>
          <p:cNvSpPr/>
          <p:nvPr/>
        </p:nvSpPr>
        <p:spPr>
          <a:xfrm>
            <a:off x="6421340" y="8036897"/>
            <a:ext cx="74521" cy="274408"/>
          </a:xfrm>
          <a:custGeom>
            <a:avLst/>
            <a:gdLst/>
            <a:ahLst/>
            <a:cxnLst/>
            <a:rect l="0" t="0" r="0" b="0"/>
            <a:pathLst>
              <a:path w="117" h="432">
                <a:moveTo>
                  <a:pt x="16" y="16"/>
                </a:moveTo>
                <a:lnTo>
                  <a:pt x="60" y="98"/>
                </a:lnTo>
                <a:lnTo>
                  <a:pt x="91" y="183"/>
                </a:lnTo>
                <a:lnTo>
                  <a:pt x="100" y="256"/>
                </a:lnTo>
                <a:moveTo>
                  <a:pt x="100" y="333"/>
                </a:moveTo>
                <a:lnTo>
                  <a:pt x="65" y="415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76" name="rect"/>
          <p:cNvSpPr/>
          <p:nvPr/>
        </p:nvSpPr>
        <p:spPr>
          <a:xfrm>
            <a:off x="3381900" y="7613574"/>
            <a:ext cx="142473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78" name="rect"/>
          <p:cNvSpPr/>
          <p:nvPr/>
        </p:nvSpPr>
        <p:spPr>
          <a:xfrm>
            <a:off x="5716958" y="7534850"/>
            <a:ext cx="142472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80" name="rect"/>
          <p:cNvSpPr/>
          <p:nvPr/>
        </p:nvSpPr>
        <p:spPr>
          <a:xfrm>
            <a:off x="1098199" y="7602667"/>
            <a:ext cx="142472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82" name="path"/>
          <p:cNvSpPr/>
          <p:nvPr/>
        </p:nvSpPr>
        <p:spPr>
          <a:xfrm>
            <a:off x="5431773" y="8423700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84" name="path"/>
          <p:cNvSpPr/>
          <p:nvPr/>
        </p:nvSpPr>
        <p:spPr>
          <a:xfrm>
            <a:off x="5431773" y="8053271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86" name="path"/>
          <p:cNvSpPr/>
          <p:nvPr/>
        </p:nvSpPr>
        <p:spPr>
          <a:xfrm>
            <a:off x="5431773" y="8238486"/>
            <a:ext cx="121101" cy="142472"/>
          </a:xfrm>
          <a:custGeom>
            <a:avLst/>
            <a:gdLst/>
            <a:ahLst/>
            <a:cxnLst/>
            <a:rect l="0" t="0" r="0" b="0"/>
            <a:pathLst>
              <a:path w="190" h="224"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95" y="72"/>
                </a:lnTo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88" name="textbox 188"/>
          <p:cNvSpPr/>
          <p:nvPr/>
        </p:nvSpPr>
        <p:spPr>
          <a:xfrm>
            <a:off x="5713715" y="7540575"/>
            <a:ext cx="161289" cy="144145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lang="en-US" altLang="en-US" sz="100" dirty="0"/>
          </a:p>
          <a:p>
            <a:pPr algn="r" rtl="0" eaLnBrk="0">
              <a:lnSpc>
                <a:spcPct val="78000"/>
              </a:lnSpc>
            </a:pPr>
            <a:r>
              <a:rPr sz="1000" kern="0" spc="-9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</a:t>
            </a:r>
            <a:r>
              <a:rPr sz="1000" kern="0" spc="-5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</a:t>
            </a:r>
            <a:endParaRPr lang="en-US" altLang="en-US" sz="1000" dirty="0"/>
          </a:p>
        </p:txBody>
      </p:sp>
      <p:sp>
        <p:nvSpPr>
          <p:cNvPr id="190" name="textbox 190"/>
          <p:cNvSpPr/>
          <p:nvPr/>
        </p:nvSpPr>
        <p:spPr>
          <a:xfrm>
            <a:off x="1094927" y="7608361"/>
            <a:ext cx="161289" cy="14477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lang="en-US" altLang="en-US" sz="100" dirty="0"/>
          </a:p>
          <a:p>
            <a:pPr algn="r" rtl="0" eaLnBrk="0">
              <a:lnSpc>
                <a:spcPct val="78000"/>
              </a:lnSpc>
            </a:pPr>
            <a:r>
              <a:rPr sz="1000" kern="0" spc="-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1</a:t>
            </a:r>
            <a:endParaRPr lang="en-US" altLang="en-US" sz="1000" dirty="0"/>
          </a:p>
        </p:txBody>
      </p:sp>
      <p:sp>
        <p:nvSpPr>
          <p:cNvPr id="192" name="textbox 192"/>
          <p:cNvSpPr/>
          <p:nvPr/>
        </p:nvSpPr>
        <p:spPr>
          <a:xfrm>
            <a:off x="3378609" y="7619269"/>
            <a:ext cx="161289" cy="144779"/>
          </a:xfrm>
          <a:prstGeom prst="rect">
            <a:avLst/>
          </a:prstGeom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lang="en-US" altLang="en-US" sz="100" dirty="0"/>
          </a:p>
          <a:p>
            <a:pPr algn="r" rtl="0" eaLnBrk="0">
              <a:lnSpc>
                <a:spcPct val="78000"/>
              </a:lnSpc>
            </a:pPr>
            <a:r>
              <a:rPr sz="1000" kern="0" spc="-8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</a:t>
            </a: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</a:t>
            </a:r>
            <a:endParaRPr lang="en-US" altLang="en-US" sz="1000" dirty="0"/>
          </a:p>
        </p:txBody>
      </p:sp>
      <p:sp>
        <p:nvSpPr>
          <p:cNvPr id="194" name="path"/>
          <p:cNvSpPr/>
          <p:nvPr/>
        </p:nvSpPr>
        <p:spPr>
          <a:xfrm>
            <a:off x="6010120" y="8515763"/>
            <a:ext cx="214392" cy="45858"/>
          </a:xfrm>
          <a:custGeom>
            <a:avLst/>
            <a:gdLst/>
            <a:ahLst/>
            <a:cxnLst/>
            <a:rect l="0" t="0" r="0" b="0"/>
            <a:pathLst>
              <a:path w="337" h="72">
                <a:moveTo>
                  <a:pt x="320" y="16"/>
                </a:moveTo>
                <a:lnTo>
                  <a:pt x="245" y="38"/>
                </a:lnTo>
                <a:lnTo>
                  <a:pt x="171" y="51"/>
                </a:lnTo>
                <a:lnTo>
                  <a:pt x="91" y="55"/>
                </a:lnTo>
                <a:lnTo>
                  <a:pt x="16" y="55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96" name="path"/>
          <p:cNvSpPr/>
          <p:nvPr/>
        </p:nvSpPr>
        <p:spPr>
          <a:xfrm>
            <a:off x="5488762" y="7960664"/>
            <a:ext cx="64112" cy="49865"/>
          </a:xfrm>
          <a:custGeom>
            <a:avLst/>
            <a:gdLst/>
            <a:ahLst/>
            <a:cxnLst/>
            <a:rect l="0" t="0" r="0" b="0"/>
            <a:pathLst>
              <a:path w="100" h="78">
                <a:moveTo>
                  <a:pt x="95" y="72"/>
                </a:moveTo>
                <a:lnTo>
                  <a:pt x="5" y="72"/>
                </a:lnTo>
                <a:moveTo>
                  <a:pt x="9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98" name="path"/>
          <p:cNvSpPr/>
          <p:nvPr/>
        </p:nvSpPr>
        <p:spPr>
          <a:xfrm>
            <a:off x="5431773" y="8608915"/>
            <a:ext cx="121101" cy="7123"/>
          </a:xfrm>
          <a:custGeom>
            <a:avLst/>
            <a:gdLst/>
            <a:ahLst/>
            <a:cxnLst/>
            <a:rect l="0" t="0" r="0" b="0"/>
            <a:pathLst>
              <a:path w="190" h="11"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200" name="path"/>
          <p:cNvSpPr/>
          <p:nvPr/>
        </p:nvSpPr>
        <p:spPr>
          <a:xfrm>
            <a:off x="5545751" y="7426391"/>
            <a:ext cx="7123" cy="1189647"/>
          </a:xfrm>
          <a:custGeom>
            <a:avLst/>
            <a:gdLst/>
            <a:ahLst/>
            <a:cxnLst/>
            <a:rect l="0" t="0" r="0" b="0"/>
            <a:pathLst>
              <a:path w="11" h="1873">
                <a:moveTo>
                  <a:pt x="5" y="1867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>
                <a:alpha val="100000"/>
              </a:srgbClr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202" name="path"/>
          <p:cNvSpPr/>
          <p:nvPr/>
        </p:nvSpPr>
        <p:spPr>
          <a:xfrm>
            <a:off x="4129468" y="8298096"/>
            <a:ext cx="60534" cy="130204"/>
          </a:xfrm>
          <a:custGeom>
            <a:avLst/>
            <a:gdLst/>
            <a:ahLst/>
            <a:cxnLst/>
            <a:rect l="0" t="0" r="0" b="0"/>
            <a:pathLst>
              <a:path w="95" h="205">
                <a:moveTo>
                  <a:pt x="78" y="16"/>
                </a:moveTo>
                <a:lnTo>
                  <a:pt x="52" y="111"/>
                </a:lnTo>
                <a:lnTo>
                  <a:pt x="16" y="188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204" name="path"/>
          <p:cNvSpPr/>
          <p:nvPr/>
        </p:nvSpPr>
        <p:spPr>
          <a:xfrm>
            <a:off x="3472077" y="8338908"/>
            <a:ext cx="35358" cy="111158"/>
          </a:xfrm>
          <a:custGeom>
            <a:avLst/>
            <a:gdLst/>
            <a:ahLst/>
            <a:cxnLst/>
            <a:rect l="0" t="0" r="0" b="0"/>
            <a:pathLst>
              <a:path w="55" h="175">
                <a:moveTo>
                  <a:pt x="16" y="158"/>
                </a:moveTo>
                <a:lnTo>
                  <a:pt x="16" y="121"/>
                </a:lnTo>
                <a:lnTo>
                  <a:pt x="16" y="85"/>
                </a:lnTo>
                <a:lnTo>
                  <a:pt x="38" y="16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206" name="path"/>
          <p:cNvSpPr/>
          <p:nvPr/>
        </p:nvSpPr>
        <p:spPr>
          <a:xfrm>
            <a:off x="6474490" y="8189262"/>
            <a:ext cx="21371" cy="70345"/>
          </a:xfrm>
          <a:custGeom>
            <a:avLst/>
            <a:gdLst/>
            <a:ahLst/>
            <a:cxnLst/>
            <a:rect l="0" t="0" r="0" b="0"/>
            <a:pathLst>
              <a:path w="33" h="110">
                <a:moveTo>
                  <a:pt x="16" y="16"/>
                </a:moveTo>
                <a:lnTo>
                  <a:pt x="16" y="55"/>
                </a:lnTo>
                <a:lnTo>
                  <a:pt x="16" y="93"/>
                </a:lnTo>
              </a:path>
            </a:pathLst>
          </a:custGeom>
          <a:noFill/>
          <a:ln w="21370" cap="sq">
            <a:solidFill>
              <a:srgbClr val="000000">
                <a:alpha val="100000"/>
              </a:srgbClr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rot="21600000">
            <a:off x="787161" y="3683245"/>
            <a:ext cx="3758357" cy="352294"/>
          </a:xfrm>
          <a:prstGeom prst="rect">
            <a:avLst/>
          </a:prstGeom>
        </p:spPr>
      </p:pic>
      <p:sp>
        <p:nvSpPr>
          <p:cNvPr id="4" name="path 4"/>
          <p:cNvSpPr/>
          <p:nvPr/>
        </p:nvSpPr>
        <p:spPr>
          <a:xfrm>
            <a:off x="2062255" y="898283"/>
            <a:ext cx="334312" cy="2820105"/>
          </a:xfrm>
          <a:custGeom>
            <a:avLst/>
            <a:gdLst/>
            <a:ahLst/>
            <a:cxnLst/>
            <a:rect l="0" t="0" r="0" b="0"/>
            <a:pathLst>
              <a:path w="526" h="4441">
                <a:moveTo>
                  <a:pt x="7" y="4432"/>
                </a:moveTo>
                <a:lnTo>
                  <a:pt x="35" y="4236"/>
                </a:lnTo>
                <a:lnTo>
                  <a:pt x="64" y="4076"/>
                </a:lnTo>
                <a:lnTo>
                  <a:pt x="92" y="3824"/>
                </a:lnTo>
                <a:lnTo>
                  <a:pt x="121" y="3458"/>
                </a:lnTo>
                <a:lnTo>
                  <a:pt x="149" y="3173"/>
                </a:lnTo>
                <a:lnTo>
                  <a:pt x="177" y="2775"/>
                </a:lnTo>
                <a:lnTo>
                  <a:pt x="206" y="2374"/>
                </a:lnTo>
                <a:lnTo>
                  <a:pt x="234" y="1668"/>
                </a:lnTo>
                <a:lnTo>
                  <a:pt x="263" y="840"/>
                </a:lnTo>
                <a:lnTo>
                  <a:pt x="291" y="158"/>
                </a:lnTo>
                <a:lnTo>
                  <a:pt x="320" y="7"/>
                </a:lnTo>
                <a:lnTo>
                  <a:pt x="348" y="605"/>
                </a:lnTo>
                <a:lnTo>
                  <a:pt x="376" y="1539"/>
                </a:lnTo>
                <a:lnTo>
                  <a:pt x="405" y="2536"/>
                </a:lnTo>
                <a:lnTo>
                  <a:pt x="433" y="3387"/>
                </a:lnTo>
                <a:lnTo>
                  <a:pt x="462" y="3879"/>
                </a:lnTo>
                <a:lnTo>
                  <a:pt x="490" y="4220"/>
                </a:lnTo>
                <a:lnTo>
                  <a:pt x="519" y="4433"/>
                </a:lnTo>
              </a:path>
            </a:pathLst>
          </a:custGeom>
          <a:noFill/>
          <a:ln w="9260" cap="rnd">
            <a:solidFill>
              <a:srgbClr val="000000"/>
            </a:solidFill>
            <a:prstDash val="solid"/>
            <a:round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pic>
        <p:nvPicPr>
          <p:cNvPr id="6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600000">
            <a:off x="929204" y="1275016"/>
            <a:ext cx="3611684" cy="2626131"/>
          </a:xfrm>
          <a:prstGeom prst="rect">
            <a:avLst/>
          </a:prstGeom>
        </p:spPr>
      </p:pic>
      <p:sp>
        <p:nvSpPr>
          <p:cNvPr id="8" name="textbox 8"/>
          <p:cNvSpPr/>
          <p:nvPr/>
        </p:nvSpPr>
        <p:spPr>
          <a:xfrm>
            <a:off x="5148708" y="463314"/>
            <a:ext cx="2123439" cy="330898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76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ct val="10200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ile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nalyzed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231222</a:t>
            </a:r>
            <a:r>
              <a:rPr sz="900" u="sng" kern="0" spc="10" dirty="0">
                <a:solidFill>
                  <a:srgbClr val="0000FF">
                    <a:alpha val="100000"/>
                  </a:srgbClr>
                </a:solidFill>
                <a:uFill>
                  <a:solidFill>
                    <a:srgbClr val="000000"/>
                  </a:solidFill>
                </a:u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900" u="sng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</a:t>
            </a:r>
            <a:r>
              <a:rPr sz="900" u="sng" kern="0" spc="10" dirty="0">
                <a:solidFill>
                  <a:srgbClr val="0000FF">
                    <a:alpha val="100000"/>
                  </a:srgbClr>
                </a:solidFill>
                <a:uFill>
                  <a:solidFill>
                    <a:srgbClr val="000000"/>
                  </a:solidFill>
                </a:u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9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07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.fcs        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ate analyzed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7-Dec-20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3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l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nn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n_DSD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230"/>
              </a:lnSpc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nalysis type:</a:t>
            </a:r>
            <a:r>
              <a:rPr sz="10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anual analy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is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87000"/>
              </a:lnSpc>
              <a:spcBef>
                <a:spcPts val="7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uto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Linearity:</a:t>
            </a:r>
            <a:r>
              <a:rPr sz="10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o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270"/>
              </a:lnSpc>
              <a:spcBef>
                <a:spcPts val="94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loidy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</a:t>
            </a:r>
            <a:r>
              <a:rPr sz="900" kern="0" spc="1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irst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ycle</a:t>
            </a:r>
            <a:r>
              <a:rPr sz="900" kern="0" spc="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is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loid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195"/>
              </a:lnSpc>
              <a:spcBef>
                <a:spcPts val="97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loid:</a:t>
            </a:r>
            <a:r>
              <a:rPr sz="900" kern="0" spc="1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.00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827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G1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8.73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t</a:t>
            </a:r>
            <a:r>
              <a:rPr sz="9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2.78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827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G2: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.97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t</a:t>
            </a:r>
            <a:r>
              <a:rPr sz="900" kern="0" spc="9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41.91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8270" algn="l" rtl="0" eaLnBrk="0">
              <a:lnSpc>
                <a:spcPts val="123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S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3.30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r>
              <a:rPr sz="9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2/G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:</a:t>
            </a:r>
            <a:r>
              <a:rPr sz="900" kern="0" spc="18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.95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6365" algn="l" rtl="0" eaLnBrk="0">
              <a:lnSpc>
                <a:spcPts val="1230"/>
              </a:lnSpc>
              <a:spcBef>
                <a:spcPts val="70"/>
              </a:spcBef>
            </a:pP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CV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.93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5240" algn="l" rtl="0" eaLnBrk="0">
              <a:lnSpc>
                <a:spcPts val="1195"/>
              </a:lnSpc>
              <a:spcBef>
                <a:spcPts val="760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Total S-Phase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3.30</a:t>
            </a:r>
            <a:r>
              <a:rPr sz="9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5240" algn="l" rtl="0" eaLnBrk="0">
              <a:lnSpc>
                <a:spcPts val="1195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Total B.A.D.:</a:t>
            </a:r>
            <a:r>
              <a:rPr sz="900" kern="0" spc="1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.00 %    no debris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o aggs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ct val="100000"/>
              </a:lnSpc>
              <a:spcBef>
                <a:spcPts val="970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ebris:</a:t>
            </a:r>
            <a:r>
              <a:rPr sz="1000" kern="0" spc="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3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ggregates:</a:t>
            </a:r>
            <a:r>
              <a:rPr sz="1000" kern="0" spc="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1000" kern="0" spc="-5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%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ts val="1120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eled event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: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8642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3000"/>
              </a:lnSpc>
              <a:spcBef>
                <a:spcPts val="5"/>
              </a:spcBef>
            </a:pP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All cycle events:</a:t>
            </a:r>
            <a:r>
              <a:rPr sz="10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10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8642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8415" algn="l" rtl="0" eaLnBrk="0">
              <a:lnSpc>
                <a:spcPts val="1225"/>
              </a:lnSpc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ycle</a:t>
            </a:r>
            <a:r>
              <a:rPr sz="900" kern="0" spc="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events</a:t>
            </a:r>
            <a:r>
              <a:rPr sz="900" kern="0" spc="1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er</a:t>
            </a:r>
            <a:r>
              <a:rPr sz="900" kern="0" spc="7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channel</a:t>
            </a:r>
            <a:r>
              <a:rPr sz="900" kern="0" spc="2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: 408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21590" algn="l" rtl="0" eaLnBrk="0">
              <a:lnSpc>
                <a:spcPct val="92000"/>
              </a:lnSpc>
              <a:spcBef>
                <a:spcPts val="5"/>
              </a:spcBef>
            </a:pP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CS:</a:t>
            </a:r>
            <a:r>
              <a:rPr sz="900" kern="0" spc="10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.395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pic>
        <p:nvPicPr>
          <p:cNvPr id="10" name="pictur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1600000">
            <a:off x="5545751" y="7436918"/>
            <a:ext cx="1223862" cy="1301232"/>
          </a:xfrm>
          <a:prstGeom prst="rect">
            <a:avLst/>
          </a:prstGeom>
        </p:spPr>
      </p:pic>
      <p:grpSp>
        <p:nvGrpSpPr>
          <p:cNvPr id="3" name="group 2"/>
          <p:cNvGrpSpPr/>
          <p:nvPr/>
        </p:nvGrpSpPr>
        <p:grpSpPr>
          <a:xfrm rot="21600000">
            <a:off x="5431773" y="7426391"/>
            <a:ext cx="1353491" cy="1303625"/>
            <a:chOff x="0" y="0"/>
            <a:chExt cx="1353491" cy="1303625"/>
          </a:xfrm>
        </p:grpSpPr>
        <p:sp>
          <p:nvSpPr>
            <p:cNvPr id="12" name="path 12"/>
            <p:cNvSpPr/>
            <p:nvPr/>
          </p:nvSpPr>
          <p:spPr>
            <a:xfrm>
              <a:off x="0" y="0"/>
              <a:ext cx="1353491" cy="1303625"/>
            </a:xfrm>
            <a:custGeom>
              <a:avLst/>
              <a:gdLst/>
              <a:ahLst/>
              <a:cxnLst/>
              <a:rect l="0" t="0" r="0" b="0"/>
              <a:pathLst>
                <a:path w="2131" h="2052">
                  <a:moveTo>
                    <a:pt x="263" y="1867"/>
                  </a:moveTo>
                  <a:lnTo>
                    <a:pt x="263" y="1957"/>
                  </a:lnTo>
                  <a:moveTo>
                    <a:pt x="342" y="1867"/>
                  </a:moveTo>
                  <a:lnTo>
                    <a:pt x="342" y="1957"/>
                  </a:lnTo>
                  <a:moveTo>
                    <a:pt x="420" y="1867"/>
                  </a:moveTo>
                  <a:lnTo>
                    <a:pt x="420" y="1957"/>
                  </a:lnTo>
                  <a:moveTo>
                    <a:pt x="487" y="1867"/>
                  </a:moveTo>
                  <a:lnTo>
                    <a:pt x="487" y="2047"/>
                  </a:lnTo>
                  <a:moveTo>
                    <a:pt x="566" y="1867"/>
                  </a:moveTo>
                  <a:lnTo>
                    <a:pt x="566" y="1957"/>
                  </a:lnTo>
                  <a:moveTo>
                    <a:pt x="645" y="1867"/>
                  </a:moveTo>
                  <a:lnTo>
                    <a:pt x="645" y="1957"/>
                  </a:lnTo>
                  <a:moveTo>
                    <a:pt x="723" y="1867"/>
                  </a:moveTo>
                  <a:lnTo>
                    <a:pt x="723" y="1957"/>
                  </a:lnTo>
                  <a:moveTo>
                    <a:pt x="802" y="1867"/>
                  </a:moveTo>
                  <a:lnTo>
                    <a:pt x="802" y="2047"/>
                  </a:lnTo>
                  <a:moveTo>
                    <a:pt x="880" y="1867"/>
                  </a:moveTo>
                  <a:lnTo>
                    <a:pt x="880" y="1957"/>
                  </a:lnTo>
                  <a:moveTo>
                    <a:pt x="959" y="1867"/>
                  </a:moveTo>
                  <a:lnTo>
                    <a:pt x="959" y="1957"/>
                  </a:lnTo>
                  <a:moveTo>
                    <a:pt x="1037" y="1867"/>
                  </a:moveTo>
                  <a:lnTo>
                    <a:pt x="1037" y="1957"/>
                  </a:lnTo>
                  <a:moveTo>
                    <a:pt x="1105" y="1867"/>
                  </a:moveTo>
                  <a:lnTo>
                    <a:pt x="1105" y="2047"/>
                  </a:lnTo>
                  <a:moveTo>
                    <a:pt x="1183" y="1867"/>
                  </a:moveTo>
                  <a:lnTo>
                    <a:pt x="1183" y="1957"/>
                  </a:lnTo>
                  <a:moveTo>
                    <a:pt x="1262" y="1867"/>
                  </a:moveTo>
                  <a:lnTo>
                    <a:pt x="1262" y="1957"/>
                  </a:lnTo>
                  <a:moveTo>
                    <a:pt x="1340" y="1867"/>
                  </a:moveTo>
                  <a:lnTo>
                    <a:pt x="1340" y="1957"/>
                  </a:lnTo>
                  <a:moveTo>
                    <a:pt x="1419" y="1867"/>
                  </a:moveTo>
                  <a:lnTo>
                    <a:pt x="1419" y="2047"/>
                  </a:lnTo>
                  <a:moveTo>
                    <a:pt x="1497" y="1867"/>
                  </a:moveTo>
                  <a:lnTo>
                    <a:pt x="1497" y="1957"/>
                  </a:lnTo>
                  <a:moveTo>
                    <a:pt x="1576" y="1867"/>
                  </a:moveTo>
                  <a:lnTo>
                    <a:pt x="1576" y="1957"/>
                  </a:lnTo>
                  <a:moveTo>
                    <a:pt x="1643" y="1867"/>
                  </a:moveTo>
                  <a:lnTo>
                    <a:pt x="1643" y="1957"/>
                  </a:lnTo>
                  <a:moveTo>
                    <a:pt x="1722" y="1867"/>
                  </a:moveTo>
                  <a:lnTo>
                    <a:pt x="1722" y="2047"/>
                  </a:lnTo>
                  <a:moveTo>
                    <a:pt x="1800" y="1867"/>
                  </a:moveTo>
                  <a:lnTo>
                    <a:pt x="1800" y="1957"/>
                  </a:lnTo>
                  <a:moveTo>
                    <a:pt x="1879" y="1867"/>
                  </a:moveTo>
                  <a:lnTo>
                    <a:pt x="1879" y="1957"/>
                  </a:lnTo>
                  <a:moveTo>
                    <a:pt x="1957" y="1867"/>
                  </a:moveTo>
                  <a:lnTo>
                    <a:pt x="1957" y="1957"/>
                  </a:lnTo>
                  <a:moveTo>
                    <a:pt x="2036" y="1867"/>
                  </a:moveTo>
                  <a:lnTo>
                    <a:pt x="2036" y="2047"/>
                  </a:lnTo>
                  <a:moveTo>
                    <a:pt x="2114" y="1867"/>
                  </a:moveTo>
                  <a:lnTo>
                    <a:pt x="2114" y="1957"/>
                  </a:lnTo>
                  <a:moveTo>
                    <a:pt x="185" y="1867"/>
                  </a:moveTo>
                  <a:lnTo>
                    <a:pt x="2125" y="1867"/>
                  </a:lnTo>
                  <a:moveTo>
                    <a:pt x="185" y="1867"/>
                  </a:moveTo>
                  <a:lnTo>
                    <a:pt x="5" y="1867"/>
                  </a:lnTo>
                  <a:moveTo>
                    <a:pt x="185" y="1789"/>
                  </a:moveTo>
                  <a:lnTo>
                    <a:pt x="95" y="1789"/>
                  </a:lnTo>
                  <a:moveTo>
                    <a:pt x="185" y="1722"/>
                  </a:moveTo>
                  <a:lnTo>
                    <a:pt x="95" y="1722"/>
                  </a:lnTo>
                  <a:moveTo>
                    <a:pt x="185" y="1643"/>
                  </a:moveTo>
                  <a:lnTo>
                    <a:pt x="95" y="1643"/>
                  </a:lnTo>
                  <a:moveTo>
                    <a:pt x="185" y="1576"/>
                  </a:moveTo>
                  <a:lnTo>
                    <a:pt x="5" y="1576"/>
                  </a:lnTo>
                  <a:moveTo>
                    <a:pt x="185" y="1497"/>
                  </a:moveTo>
                  <a:lnTo>
                    <a:pt x="95" y="1497"/>
                  </a:lnTo>
                  <a:moveTo>
                    <a:pt x="185" y="1430"/>
                  </a:moveTo>
                  <a:lnTo>
                    <a:pt x="95" y="1430"/>
                  </a:lnTo>
                  <a:moveTo>
                    <a:pt x="185" y="1351"/>
                  </a:moveTo>
                  <a:lnTo>
                    <a:pt x="95" y="1351"/>
                  </a:lnTo>
                  <a:moveTo>
                    <a:pt x="185" y="1284"/>
                  </a:moveTo>
                  <a:lnTo>
                    <a:pt x="5" y="1284"/>
                  </a:lnTo>
                  <a:moveTo>
                    <a:pt x="185" y="1205"/>
                  </a:moveTo>
                  <a:lnTo>
                    <a:pt x="95" y="1205"/>
                  </a:lnTo>
                  <a:moveTo>
                    <a:pt x="185" y="1138"/>
                  </a:moveTo>
                  <a:lnTo>
                    <a:pt x="95" y="1138"/>
                  </a:lnTo>
                  <a:moveTo>
                    <a:pt x="185" y="1060"/>
                  </a:moveTo>
                  <a:lnTo>
                    <a:pt x="95" y="1060"/>
                  </a:lnTo>
                  <a:moveTo>
                    <a:pt x="185" y="992"/>
                  </a:moveTo>
                  <a:lnTo>
                    <a:pt x="5" y="992"/>
                  </a:lnTo>
                  <a:moveTo>
                    <a:pt x="185" y="914"/>
                  </a:moveTo>
                  <a:lnTo>
                    <a:pt x="95" y="914"/>
                  </a:lnTo>
                  <a:moveTo>
                    <a:pt x="185" y="846"/>
                  </a:moveTo>
                  <a:lnTo>
                    <a:pt x="95" y="846"/>
                  </a:lnTo>
                  <a:moveTo>
                    <a:pt x="185" y="768"/>
                  </a:moveTo>
                  <a:lnTo>
                    <a:pt x="95" y="768"/>
                  </a:lnTo>
                  <a:moveTo>
                    <a:pt x="185" y="689"/>
                  </a:moveTo>
                  <a:lnTo>
                    <a:pt x="5" y="689"/>
                  </a:lnTo>
                  <a:moveTo>
                    <a:pt x="185" y="622"/>
                  </a:moveTo>
                  <a:lnTo>
                    <a:pt x="95" y="622"/>
                  </a:lnTo>
                  <a:moveTo>
                    <a:pt x="185" y="544"/>
                  </a:moveTo>
                  <a:lnTo>
                    <a:pt x="95" y="544"/>
                  </a:lnTo>
                  <a:moveTo>
                    <a:pt x="185" y="476"/>
                  </a:moveTo>
                  <a:lnTo>
                    <a:pt x="95" y="476"/>
                  </a:lnTo>
                  <a:moveTo>
                    <a:pt x="185" y="398"/>
                  </a:moveTo>
                  <a:lnTo>
                    <a:pt x="5" y="398"/>
                  </a:lnTo>
                  <a:moveTo>
                    <a:pt x="185" y="330"/>
                  </a:moveTo>
                  <a:lnTo>
                    <a:pt x="95" y="330"/>
                  </a:lnTo>
                  <a:moveTo>
                    <a:pt x="185" y="252"/>
                  </a:moveTo>
                  <a:lnTo>
                    <a:pt x="95" y="252"/>
                  </a:lnTo>
                  <a:moveTo>
                    <a:pt x="185" y="185"/>
                  </a:moveTo>
                  <a:lnTo>
                    <a:pt x="95" y="185"/>
                  </a:lnTo>
                  <a:moveTo>
                    <a:pt x="185" y="106"/>
                  </a:moveTo>
                  <a:lnTo>
                    <a:pt x="5" y="106"/>
                  </a:lnTo>
                  <a:moveTo>
                    <a:pt x="185" y="39"/>
                  </a:moveTo>
                  <a:lnTo>
                    <a:pt x="95" y="39"/>
                  </a:lnTo>
                  <a:moveTo>
                    <a:pt x="185" y="1867"/>
                  </a:moveTo>
                  <a:lnTo>
                    <a:pt x="185" y="5"/>
                  </a:lnTo>
                </a:path>
              </a:pathLst>
            </a:custGeom>
            <a:noFill/>
            <a:ln w="7123" cap="sq">
              <a:solidFill>
                <a:srgbClr val="000000"/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14" name="path 14"/>
            <p:cNvSpPr/>
            <p:nvPr/>
          </p:nvSpPr>
          <p:spPr>
            <a:xfrm>
              <a:off x="334972" y="537042"/>
              <a:ext cx="729115" cy="598187"/>
            </a:xfrm>
            <a:custGeom>
              <a:avLst/>
              <a:gdLst/>
              <a:ahLst/>
              <a:cxnLst/>
              <a:rect l="0" t="0" r="0" b="0"/>
              <a:pathLst>
                <a:path w="1148" h="942">
                  <a:moveTo>
                    <a:pt x="928" y="21"/>
                  </a:moveTo>
                  <a:lnTo>
                    <a:pt x="986" y="72"/>
                  </a:lnTo>
                  <a:lnTo>
                    <a:pt x="1047" y="132"/>
                  </a:lnTo>
                  <a:lnTo>
                    <a:pt x="1091" y="213"/>
                  </a:lnTo>
                  <a:lnTo>
                    <a:pt x="1122" y="299"/>
                  </a:lnTo>
                  <a:lnTo>
                    <a:pt x="1131" y="372"/>
                  </a:lnTo>
                  <a:lnTo>
                    <a:pt x="1131" y="411"/>
                  </a:lnTo>
                  <a:lnTo>
                    <a:pt x="1131" y="449"/>
                  </a:lnTo>
                  <a:lnTo>
                    <a:pt x="1096" y="531"/>
                  </a:lnTo>
                  <a:lnTo>
                    <a:pt x="1052" y="590"/>
                  </a:lnTo>
                  <a:lnTo>
                    <a:pt x="999" y="642"/>
                  </a:lnTo>
                  <a:lnTo>
                    <a:pt x="941" y="702"/>
                  </a:lnTo>
                  <a:lnTo>
                    <a:pt x="880" y="758"/>
                  </a:lnTo>
                  <a:lnTo>
                    <a:pt x="823" y="805"/>
                  </a:lnTo>
                  <a:lnTo>
                    <a:pt x="765" y="848"/>
                  </a:lnTo>
                  <a:lnTo>
                    <a:pt x="704" y="886"/>
                  </a:lnTo>
                  <a:lnTo>
                    <a:pt x="629" y="908"/>
                  </a:lnTo>
                  <a:lnTo>
                    <a:pt x="554" y="920"/>
                  </a:lnTo>
                  <a:lnTo>
                    <a:pt x="474" y="925"/>
                  </a:lnTo>
                  <a:lnTo>
                    <a:pt x="400" y="925"/>
                  </a:lnTo>
                  <a:lnTo>
                    <a:pt x="329" y="916"/>
                  </a:lnTo>
                  <a:lnTo>
                    <a:pt x="259" y="895"/>
                  </a:lnTo>
                  <a:lnTo>
                    <a:pt x="193" y="860"/>
                  </a:lnTo>
                  <a:lnTo>
                    <a:pt x="140" y="813"/>
                  </a:lnTo>
                  <a:lnTo>
                    <a:pt x="78" y="766"/>
                  </a:lnTo>
                  <a:lnTo>
                    <a:pt x="30" y="706"/>
                  </a:lnTo>
                  <a:lnTo>
                    <a:pt x="16" y="638"/>
                  </a:lnTo>
                  <a:lnTo>
                    <a:pt x="21" y="569"/>
                  </a:lnTo>
                  <a:lnTo>
                    <a:pt x="43" y="501"/>
                  </a:lnTo>
                  <a:lnTo>
                    <a:pt x="69" y="436"/>
                  </a:lnTo>
                  <a:lnTo>
                    <a:pt x="100" y="372"/>
                  </a:lnTo>
                  <a:lnTo>
                    <a:pt x="144" y="312"/>
                  </a:lnTo>
                  <a:lnTo>
                    <a:pt x="201" y="248"/>
                  </a:lnTo>
                  <a:lnTo>
                    <a:pt x="259" y="205"/>
                  </a:lnTo>
                  <a:lnTo>
                    <a:pt x="316" y="162"/>
                  </a:lnTo>
                  <a:lnTo>
                    <a:pt x="382" y="132"/>
                  </a:lnTo>
                  <a:lnTo>
                    <a:pt x="452" y="98"/>
                  </a:lnTo>
                  <a:lnTo>
                    <a:pt x="519" y="68"/>
                  </a:lnTo>
                  <a:lnTo>
                    <a:pt x="589" y="42"/>
                  </a:lnTo>
                  <a:lnTo>
                    <a:pt x="660" y="21"/>
                  </a:lnTo>
                  <a:lnTo>
                    <a:pt x="673" y="16"/>
                  </a:lnTo>
                  <a:lnTo>
                    <a:pt x="737" y="17"/>
                  </a:lnTo>
                  <a:lnTo>
                    <a:pt x="800" y="18"/>
                  </a:lnTo>
                  <a:lnTo>
                    <a:pt x="864" y="20"/>
                  </a:lnTo>
                  <a:lnTo>
                    <a:pt x="928" y="21"/>
                  </a:lnTo>
                </a:path>
              </a:pathLst>
            </a:custGeom>
            <a:noFill/>
            <a:ln w="21370" cap="sq">
              <a:solidFill>
                <a:srgbClr val="000000"/>
              </a:solidFill>
              <a:prstDash val="solid"/>
              <a:miter lim="1000000"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</p:grpSp>
      <p:pic>
        <p:nvPicPr>
          <p:cNvPr id="16" name="picture 1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21600000">
            <a:off x="3209198" y="7436918"/>
            <a:ext cx="1225214" cy="1301232"/>
          </a:xfrm>
          <a:prstGeom prst="rect">
            <a:avLst/>
          </a:prstGeom>
        </p:spPr>
      </p:pic>
      <p:grpSp>
        <p:nvGrpSpPr>
          <p:cNvPr id="5" name="group 4"/>
          <p:cNvGrpSpPr/>
          <p:nvPr/>
        </p:nvGrpSpPr>
        <p:grpSpPr>
          <a:xfrm rot="21600000">
            <a:off x="3095220" y="7426391"/>
            <a:ext cx="1353491" cy="1303625"/>
            <a:chOff x="0" y="0"/>
            <a:chExt cx="1353491" cy="1303625"/>
          </a:xfrm>
        </p:grpSpPr>
        <p:sp>
          <p:nvSpPr>
            <p:cNvPr id="18" name="path 18"/>
            <p:cNvSpPr/>
            <p:nvPr/>
          </p:nvSpPr>
          <p:spPr>
            <a:xfrm>
              <a:off x="0" y="0"/>
              <a:ext cx="1353491" cy="1303625"/>
            </a:xfrm>
            <a:custGeom>
              <a:avLst/>
              <a:gdLst/>
              <a:ahLst/>
              <a:cxnLst/>
              <a:rect l="0" t="0" r="0" b="0"/>
              <a:pathLst>
                <a:path w="2131" h="2052">
                  <a:moveTo>
                    <a:pt x="263" y="1867"/>
                  </a:moveTo>
                  <a:lnTo>
                    <a:pt x="263" y="1957"/>
                  </a:lnTo>
                  <a:moveTo>
                    <a:pt x="342" y="1867"/>
                  </a:moveTo>
                  <a:lnTo>
                    <a:pt x="342" y="1957"/>
                  </a:lnTo>
                  <a:moveTo>
                    <a:pt x="420" y="1867"/>
                  </a:moveTo>
                  <a:lnTo>
                    <a:pt x="420" y="1957"/>
                  </a:lnTo>
                  <a:moveTo>
                    <a:pt x="487" y="1867"/>
                  </a:moveTo>
                  <a:lnTo>
                    <a:pt x="487" y="2047"/>
                  </a:lnTo>
                  <a:moveTo>
                    <a:pt x="566" y="1867"/>
                  </a:moveTo>
                  <a:lnTo>
                    <a:pt x="566" y="1957"/>
                  </a:lnTo>
                  <a:moveTo>
                    <a:pt x="645" y="1867"/>
                  </a:moveTo>
                  <a:lnTo>
                    <a:pt x="645" y="1957"/>
                  </a:lnTo>
                  <a:moveTo>
                    <a:pt x="723" y="1867"/>
                  </a:moveTo>
                  <a:lnTo>
                    <a:pt x="723" y="1957"/>
                  </a:lnTo>
                  <a:moveTo>
                    <a:pt x="802" y="1867"/>
                  </a:moveTo>
                  <a:lnTo>
                    <a:pt x="802" y="2047"/>
                  </a:lnTo>
                  <a:moveTo>
                    <a:pt x="880" y="1867"/>
                  </a:moveTo>
                  <a:lnTo>
                    <a:pt x="880" y="1957"/>
                  </a:lnTo>
                  <a:moveTo>
                    <a:pt x="959" y="1867"/>
                  </a:moveTo>
                  <a:lnTo>
                    <a:pt x="959" y="1957"/>
                  </a:lnTo>
                  <a:moveTo>
                    <a:pt x="1037" y="1867"/>
                  </a:moveTo>
                  <a:lnTo>
                    <a:pt x="1037" y="1957"/>
                  </a:lnTo>
                  <a:moveTo>
                    <a:pt x="1105" y="1867"/>
                  </a:moveTo>
                  <a:lnTo>
                    <a:pt x="1105" y="2047"/>
                  </a:lnTo>
                  <a:moveTo>
                    <a:pt x="1183" y="1867"/>
                  </a:moveTo>
                  <a:lnTo>
                    <a:pt x="1183" y="1957"/>
                  </a:lnTo>
                  <a:moveTo>
                    <a:pt x="1262" y="1867"/>
                  </a:moveTo>
                  <a:lnTo>
                    <a:pt x="1262" y="1957"/>
                  </a:lnTo>
                  <a:moveTo>
                    <a:pt x="1340" y="1867"/>
                  </a:moveTo>
                  <a:lnTo>
                    <a:pt x="1340" y="1957"/>
                  </a:lnTo>
                  <a:moveTo>
                    <a:pt x="1419" y="1867"/>
                  </a:moveTo>
                  <a:lnTo>
                    <a:pt x="1419" y="2047"/>
                  </a:lnTo>
                  <a:moveTo>
                    <a:pt x="1497" y="1867"/>
                  </a:moveTo>
                  <a:lnTo>
                    <a:pt x="1497" y="1957"/>
                  </a:lnTo>
                  <a:moveTo>
                    <a:pt x="1576" y="1867"/>
                  </a:moveTo>
                  <a:lnTo>
                    <a:pt x="1576" y="1957"/>
                  </a:lnTo>
                  <a:moveTo>
                    <a:pt x="1643" y="1867"/>
                  </a:moveTo>
                  <a:lnTo>
                    <a:pt x="1643" y="1957"/>
                  </a:lnTo>
                  <a:moveTo>
                    <a:pt x="1722" y="1867"/>
                  </a:moveTo>
                  <a:lnTo>
                    <a:pt x="1722" y="2047"/>
                  </a:lnTo>
                  <a:moveTo>
                    <a:pt x="1800" y="1867"/>
                  </a:moveTo>
                  <a:lnTo>
                    <a:pt x="1800" y="1957"/>
                  </a:lnTo>
                  <a:moveTo>
                    <a:pt x="1879" y="1867"/>
                  </a:moveTo>
                  <a:lnTo>
                    <a:pt x="1879" y="1957"/>
                  </a:lnTo>
                  <a:moveTo>
                    <a:pt x="1957" y="1867"/>
                  </a:moveTo>
                  <a:lnTo>
                    <a:pt x="1957" y="1957"/>
                  </a:lnTo>
                  <a:moveTo>
                    <a:pt x="2036" y="1867"/>
                  </a:moveTo>
                  <a:lnTo>
                    <a:pt x="2036" y="2047"/>
                  </a:lnTo>
                  <a:moveTo>
                    <a:pt x="2114" y="1867"/>
                  </a:moveTo>
                  <a:lnTo>
                    <a:pt x="2114" y="1957"/>
                  </a:lnTo>
                  <a:moveTo>
                    <a:pt x="185" y="1867"/>
                  </a:moveTo>
                  <a:lnTo>
                    <a:pt x="2125" y="1867"/>
                  </a:lnTo>
                  <a:moveTo>
                    <a:pt x="185" y="1867"/>
                  </a:moveTo>
                  <a:lnTo>
                    <a:pt x="5" y="1867"/>
                  </a:lnTo>
                  <a:moveTo>
                    <a:pt x="185" y="1789"/>
                  </a:moveTo>
                  <a:lnTo>
                    <a:pt x="95" y="1789"/>
                  </a:lnTo>
                  <a:moveTo>
                    <a:pt x="185" y="1722"/>
                  </a:moveTo>
                  <a:lnTo>
                    <a:pt x="95" y="1722"/>
                  </a:lnTo>
                  <a:moveTo>
                    <a:pt x="185" y="1643"/>
                  </a:moveTo>
                  <a:lnTo>
                    <a:pt x="95" y="1643"/>
                  </a:lnTo>
                  <a:moveTo>
                    <a:pt x="185" y="1576"/>
                  </a:moveTo>
                  <a:lnTo>
                    <a:pt x="5" y="1576"/>
                  </a:lnTo>
                  <a:moveTo>
                    <a:pt x="185" y="1497"/>
                  </a:moveTo>
                  <a:lnTo>
                    <a:pt x="95" y="1497"/>
                  </a:lnTo>
                  <a:moveTo>
                    <a:pt x="185" y="1430"/>
                  </a:moveTo>
                  <a:lnTo>
                    <a:pt x="95" y="1430"/>
                  </a:lnTo>
                  <a:moveTo>
                    <a:pt x="185" y="1351"/>
                  </a:moveTo>
                  <a:lnTo>
                    <a:pt x="95" y="1351"/>
                  </a:lnTo>
                  <a:moveTo>
                    <a:pt x="185" y="1284"/>
                  </a:moveTo>
                  <a:lnTo>
                    <a:pt x="5" y="1284"/>
                  </a:lnTo>
                  <a:moveTo>
                    <a:pt x="185" y="1205"/>
                  </a:moveTo>
                  <a:lnTo>
                    <a:pt x="95" y="1205"/>
                  </a:lnTo>
                  <a:moveTo>
                    <a:pt x="185" y="1138"/>
                  </a:moveTo>
                  <a:lnTo>
                    <a:pt x="95" y="1138"/>
                  </a:lnTo>
                  <a:moveTo>
                    <a:pt x="185" y="1060"/>
                  </a:moveTo>
                  <a:lnTo>
                    <a:pt x="95" y="1060"/>
                  </a:lnTo>
                  <a:moveTo>
                    <a:pt x="185" y="992"/>
                  </a:moveTo>
                  <a:lnTo>
                    <a:pt x="5" y="992"/>
                  </a:lnTo>
                  <a:moveTo>
                    <a:pt x="185" y="914"/>
                  </a:moveTo>
                  <a:lnTo>
                    <a:pt x="95" y="914"/>
                  </a:lnTo>
                  <a:moveTo>
                    <a:pt x="185" y="846"/>
                  </a:moveTo>
                  <a:lnTo>
                    <a:pt x="95" y="846"/>
                  </a:lnTo>
                  <a:moveTo>
                    <a:pt x="185" y="768"/>
                  </a:moveTo>
                  <a:lnTo>
                    <a:pt x="95" y="768"/>
                  </a:lnTo>
                  <a:moveTo>
                    <a:pt x="185" y="689"/>
                  </a:moveTo>
                  <a:lnTo>
                    <a:pt x="5" y="689"/>
                  </a:lnTo>
                  <a:moveTo>
                    <a:pt x="185" y="622"/>
                  </a:moveTo>
                  <a:lnTo>
                    <a:pt x="95" y="622"/>
                  </a:lnTo>
                  <a:moveTo>
                    <a:pt x="185" y="544"/>
                  </a:moveTo>
                  <a:lnTo>
                    <a:pt x="95" y="544"/>
                  </a:lnTo>
                  <a:moveTo>
                    <a:pt x="185" y="476"/>
                  </a:moveTo>
                  <a:lnTo>
                    <a:pt x="95" y="476"/>
                  </a:lnTo>
                  <a:moveTo>
                    <a:pt x="185" y="398"/>
                  </a:moveTo>
                  <a:lnTo>
                    <a:pt x="5" y="398"/>
                  </a:lnTo>
                  <a:moveTo>
                    <a:pt x="185" y="330"/>
                  </a:moveTo>
                  <a:lnTo>
                    <a:pt x="95" y="330"/>
                  </a:lnTo>
                  <a:moveTo>
                    <a:pt x="185" y="252"/>
                  </a:moveTo>
                  <a:lnTo>
                    <a:pt x="95" y="252"/>
                  </a:lnTo>
                  <a:moveTo>
                    <a:pt x="185" y="185"/>
                  </a:moveTo>
                  <a:lnTo>
                    <a:pt x="95" y="185"/>
                  </a:lnTo>
                  <a:moveTo>
                    <a:pt x="185" y="106"/>
                  </a:moveTo>
                  <a:lnTo>
                    <a:pt x="5" y="106"/>
                  </a:lnTo>
                  <a:moveTo>
                    <a:pt x="185" y="39"/>
                  </a:moveTo>
                  <a:lnTo>
                    <a:pt x="95" y="39"/>
                  </a:lnTo>
                  <a:moveTo>
                    <a:pt x="185" y="1867"/>
                  </a:moveTo>
                  <a:lnTo>
                    <a:pt x="185" y="5"/>
                  </a:lnTo>
                </a:path>
              </a:pathLst>
            </a:custGeom>
            <a:noFill/>
            <a:ln w="7123" cap="sq">
              <a:solidFill>
                <a:srgbClr val="000000"/>
              </a:solidFill>
              <a:prstDash val="solid"/>
              <a:bevel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  <p:sp>
          <p:nvSpPr>
            <p:cNvPr id="20" name="path 20"/>
            <p:cNvSpPr/>
            <p:nvPr/>
          </p:nvSpPr>
          <p:spPr>
            <a:xfrm>
              <a:off x="376856" y="634992"/>
              <a:ext cx="720723" cy="554654"/>
            </a:xfrm>
            <a:custGeom>
              <a:avLst/>
              <a:gdLst/>
              <a:ahLst/>
              <a:cxnLst/>
              <a:rect l="0" t="0" r="0" b="0"/>
              <a:pathLst>
                <a:path w="1134" h="873">
                  <a:moveTo>
                    <a:pt x="1082" y="76"/>
                  </a:moveTo>
                  <a:lnTo>
                    <a:pt x="1104" y="153"/>
                  </a:lnTo>
                  <a:lnTo>
                    <a:pt x="1118" y="222"/>
                  </a:lnTo>
                  <a:lnTo>
                    <a:pt x="1118" y="267"/>
                  </a:lnTo>
                  <a:lnTo>
                    <a:pt x="1118" y="312"/>
                  </a:lnTo>
                  <a:lnTo>
                    <a:pt x="1113" y="389"/>
                  </a:lnTo>
                  <a:lnTo>
                    <a:pt x="1087" y="483"/>
                  </a:lnTo>
                  <a:lnTo>
                    <a:pt x="1052" y="560"/>
                  </a:lnTo>
                  <a:lnTo>
                    <a:pt x="1012" y="625"/>
                  </a:lnTo>
                  <a:lnTo>
                    <a:pt x="959" y="676"/>
                  </a:lnTo>
                  <a:lnTo>
                    <a:pt x="906" y="723"/>
                  </a:lnTo>
                  <a:lnTo>
                    <a:pt x="840" y="766"/>
                  </a:lnTo>
                  <a:lnTo>
                    <a:pt x="778" y="800"/>
                  </a:lnTo>
                  <a:lnTo>
                    <a:pt x="699" y="830"/>
                  </a:lnTo>
                  <a:lnTo>
                    <a:pt x="615" y="843"/>
                  </a:lnTo>
                  <a:lnTo>
                    <a:pt x="545" y="852"/>
                  </a:lnTo>
                  <a:lnTo>
                    <a:pt x="474" y="852"/>
                  </a:lnTo>
                  <a:lnTo>
                    <a:pt x="400" y="856"/>
                  </a:lnTo>
                  <a:lnTo>
                    <a:pt x="325" y="856"/>
                  </a:lnTo>
                  <a:lnTo>
                    <a:pt x="254" y="856"/>
                  </a:lnTo>
                  <a:lnTo>
                    <a:pt x="175" y="830"/>
                  </a:lnTo>
                  <a:lnTo>
                    <a:pt x="104" y="800"/>
                  </a:lnTo>
                  <a:lnTo>
                    <a:pt x="47" y="749"/>
                  </a:lnTo>
                  <a:lnTo>
                    <a:pt x="21" y="668"/>
                  </a:lnTo>
                  <a:lnTo>
                    <a:pt x="16" y="595"/>
                  </a:lnTo>
                  <a:lnTo>
                    <a:pt x="16" y="558"/>
                  </a:lnTo>
                  <a:lnTo>
                    <a:pt x="16" y="522"/>
                  </a:lnTo>
                  <a:lnTo>
                    <a:pt x="38" y="453"/>
                  </a:lnTo>
                  <a:lnTo>
                    <a:pt x="82" y="381"/>
                  </a:lnTo>
                  <a:lnTo>
                    <a:pt x="126" y="312"/>
                  </a:lnTo>
                  <a:lnTo>
                    <a:pt x="171" y="256"/>
                  </a:lnTo>
                  <a:lnTo>
                    <a:pt x="223" y="205"/>
                  </a:lnTo>
                  <a:lnTo>
                    <a:pt x="294" y="145"/>
                  </a:lnTo>
                  <a:lnTo>
                    <a:pt x="360" y="102"/>
                  </a:lnTo>
                  <a:lnTo>
                    <a:pt x="426" y="68"/>
                  </a:lnTo>
                  <a:lnTo>
                    <a:pt x="492" y="38"/>
                  </a:lnTo>
                  <a:lnTo>
                    <a:pt x="580" y="21"/>
                  </a:lnTo>
                  <a:lnTo>
                    <a:pt x="660" y="16"/>
                  </a:lnTo>
                  <a:lnTo>
                    <a:pt x="730" y="16"/>
                  </a:lnTo>
                  <a:lnTo>
                    <a:pt x="805" y="21"/>
                  </a:lnTo>
                  <a:lnTo>
                    <a:pt x="831" y="25"/>
                  </a:lnTo>
                  <a:lnTo>
                    <a:pt x="894" y="38"/>
                  </a:lnTo>
                  <a:lnTo>
                    <a:pt x="957" y="51"/>
                  </a:lnTo>
                  <a:lnTo>
                    <a:pt x="1020" y="63"/>
                  </a:lnTo>
                  <a:lnTo>
                    <a:pt x="1082" y="76"/>
                  </a:lnTo>
                </a:path>
              </a:pathLst>
            </a:custGeom>
            <a:noFill/>
            <a:ln w="21370" cap="sq">
              <a:solidFill>
                <a:srgbClr val="000000"/>
              </a:solidFill>
              <a:prstDash val="solid"/>
              <a:miter lim="1000000"/>
            </a:ln>
          </p:spPr>
          <p:txBody>
            <a:bodyPr rtlCol="0"/>
            <a:lstStyle/>
            <a:p>
              <a:pPr algn="ctr"/>
              <a:endParaRPr lang="zh-CN" altLang="en-US"/>
            </a:p>
          </p:txBody>
        </p:sp>
      </p:grpSp>
      <p:pic>
        <p:nvPicPr>
          <p:cNvPr id="22" name="picture 2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21600000">
            <a:off x="872645" y="7436918"/>
            <a:ext cx="1239083" cy="1301232"/>
          </a:xfrm>
          <a:prstGeom prst="rect">
            <a:avLst/>
          </a:prstGeom>
        </p:spPr>
      </p:pic>
      <p:sp>
        <p:nvSpPr>
          <p:cNvPr id="24" name="textbox 24"/>
          <p:cNvSpPr/>
          <p:nvPr/>
        </p:nvSpPr>
        <p:spPr>
          <a:xfrm>
            <a:off x="882499" y="4078020"/>
            <a:ext cx="3767454" cy="3124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81000"/>
              </a:lnSpc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</a:t>
            </a:r>
            <a:r>
              <a:rPr sz="9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5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50                       200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741170" algn="l" rtl="0" eaLnBrk="0">
              <a:lnSpc>
                <a:spcPts val="1270"/>
              </a:lnSpc>
              <a:spcBef>
                <a:spcPts val="115"/>
              </a:spcBef>
            </a:pPr>
            <a:r>
              <a:rPr sz="1000" kern="0" spc="-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I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26" name="textbox 26"/>
          <p:cNvSpPr/>
          <p:nvPr/>
        </p:nvSpPr>
        <p:spPr>
          <a:xfrm>
            <a:off x="5519459" y="8760429"/>
            <a:ext cx="1303019" cy="32639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6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537210" indent="-525145" algn="l" rtl="0" eaLnBrk="0">
              <a:lnSpc>
                <a:spcPct val="116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   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80</a:t>
            </a:r>
            <a:r>
              <a:rPr sz="700" kern="0" spc="10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  120  </a:t>
            </a:r>
            <a:r>
              <a:rPr sz="1000" kern="0" spc="-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I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28" name="textbox 28"/>
          <p:cNvSpPr/>
          <p:nvPr/>
        </p:nvSpPr>
        <p:spPr>
          <a:xfrm>
            <a:off x="846353" y="8760429"/>
            <a:ext cx="1303019" cy="2870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l" rtl="0" eaLnBrk="0">
              <a:lnSpc>
                <a:spcPct val="148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47371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30" name="textbox 30"/>
          <p:cNvSpPr/>
          <p:nvPr/>
        </p:nvSpPr>
        <p:spPr>
          <a:xfrm>
            <a:off x="3182906" y="8760429"/>
            <a:ext cx="1303019" cy="28702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    2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4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60</a:t>
            </a:r>
            <a:r>
              <a:rPr sz="700" kern="0" spc="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   100  1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l" rtl="0" eaLnBrk="0">
              <a:lnSpc>
                <a:spcPct val="148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47371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32" name="textbox 32"/>
          <p:cNvSpPr/>
          <p:nvPr/>
        </p:nvSpPr>
        <p:spPr>
          <a:xfrm rot="16200000">
            <a:off x="-952306" y="2214200"/>
            <a:ext cx="3289934" cy="162560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26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81000"/>
              </a:lnSpc>
              <a:spcBef>
                <a:spcPts val="0"/>
              </a:spcBef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5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0</a:t>
            </a:r>
            <a:r>
              <a:rPr sz="900" kern="0" spc="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5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00</a:t>
            </a:r>
            <a:r>
              <a:rPr sz="900" kern="0" spc="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500</a:t>
            </a:r>
            <a:r>
              <a:rPr sz="9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   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00</a:t>
            </a:r>
            <a:r>
              <a:rPr sz="900" kern="0" spc="-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34" name="path 34"/>
          <p:cNvSpPr/>
          <p:nvPr/>
        </p:nvSpPr>
        <p:spPr>
          <a:xfrm>
            <a:off x="1166600" y="8053654"/>
            <a:ext cx="651294" cy="325403"/>
          </a:xfrm>
          <a:custGeom>
            <a:avLst/>
            <a:gdLst/>
            <a:ahLst/>
            <a:cxnLst/>
            <a:rect l="0" t="0" r="0" b="0"/>
            <a:pathLst>
              <a:path w="1025" h="512">
                <a:moveTo>
                  <a:pt x="663" y="35"/>
                </a:moveTo>
                <a:lnTo>
                  <a:pt x="732" y="25"/>
                </a:lnTo>
                <a:lnTo>
                  <a:pt x="822" y="16"/>
                </a:lnTo>
                <a:lnTo>
                  <a:pt x="902" y="20"/>
                </a:lnTo>
                <a:lnTo>
                  <a:pt x="964" y="42"/>
                </a:lnTo>
                <a:lnTo>
                  <a:pt x="995" y="96"/>
                </a:lnTo>
                <a:lnTo>
                  <a:pt x="1008" y="159"/>
                </a:lnTo>
                <a:lnTo>
                  <a:pt x="1006" y="225"/>
                </a:lnTo>
                <a:lnTo>
                  <a:pt x="962" y="281"/>
                </a:lnTo>
                <a:lnTo>
                  <a:pt x="904" y="320"/>
                </a:lnTo>
                <a:lnTo>
                  <a:pt x="849" y="350"/>
                </a:lnTo>
                <a:lnTo>
                  <a:pt x="782" y="375"/>
                </a:lnTo>
                <a:lnTo>
                  <a:pt x="709" y="397"/>
                </a:lnTo>
                <a:lnTo>
                  <a:pt x="626" y="420"/>
                </a:lnTo>
                <a:lnTo>
                  <a:pt x="557" y="441"/>
                </a:lnTo>
                <a:lnTo>
                  <a:pt x="493" y="458"/>
                </a:lnTo>
                <a:lnTo>
                  <a:pt x="432" y="474"/>
                </a:lnTo>
                <a:lnTo>
                  <a:pt x="366" y="484"/>
                </a:lnTo>
                <a:lnTo>
                  <a:pt x="296" y="493"/>
                </a:lnTo>
                <a:lnTo>
                  <a:pt x="229" y="495"/>
                </a:lnTo>
                <a:lnTo>
                  <a:pt x="160" y="486"/>
                </a:lnTo>
                <a:lnTo>
                  <a:pt x="99" y="471"/>
                </a:lnTo>
                <a:lnTo>
                  <a:pt x="49" y="424"/>
                </a:lnTo>
                <a:lnTo>
                  <a:pt x="21" y="367"/>
                </a:lnTo>
                <a:lnTo>
                  <a:pt x="16" y="306"/>
                </a:lnTo>
                <a:lnTo>
                  <a:pt x="47" y="241"/>
                </a:lnTo>
                <a:lnTo>
                  <a:pt x="100" y="195"/>
                </a:lnTo>
                <a:lnTo>
                  <a:pt x="154" y="160"/>
                </a:lnTo>
                <a:lnTo>
                  <a:pt x="222" y="135"/>
                </a:lnTo>
                <a:lnTo>
                  <a:pt x="286" y="111"/>
                </a:lnTo>
                <a:lnTo>
                  <a:pt x="347" y="98"/>
                </a:lnTo>
                <a:lnTo>
                  <a:pt x="410" y="86"/>
                </a:lnTo>
                <a:lnTo>
                  <a:pt x="473" y="73"/>
                </a:lnTo>
                <a:lnTo>
                  <a:pt x="536" y="60"/>
                </a:lnTo>
                <a:lnTo>
                  <a:pt x="599" y="48"/>
                </a:lnTo>
                <a:lnTo>
                  <a:pt x="663" y="35"/>
                </a:lnTo>
              </a:path>
            </a:pathLst>
          </a:custGeom>
          <a:noFill/>
          <a:ln w="21370" cap="sq">
            <a:solidFill>
              <a:srgbClr val="000000"/>
            </a:solidFill>
            <a:prstDash val="solid"/>
            <a:miter lim="100000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36" name="path 36"/>
          <p:cNvSpPr/>
          <p:nvPr/>
        </p:nvSpPr>
        <p:spPr>
          <a:xfrm>
            <a:off x="758667" y="7447762"/>
            <a:ext cx="121101" cy="1075669"/>
          </a:xfrm>
          <a:custGeom>
            <a:avLst/>
            <a:gdLst/>
            <a:ahLst/>
            <a:cxnLst/>
            <a:rect l="0" t="0" r="0" b="0"/>
            <a:pathLst>
              <a:path w="190" h="1693">
                <a:moveTo>
                  <a:pt x="185" y="1688"/>
                </a:moveTo>
                <a:lnTo>
                  <a:pt x="95" y="1688"/>
                </a:lnTo>
                <a:moveTo>
                  <a:pt x="185" y="1609"/>
                </a:moveTo>
                <a:lnTo>
                  <a:pt x="95" y="1609"/>
                </a:lnTo>
                <a:moveTo>
                  <a:pt x="185" y="1542"/>
                </a:moveTo>
                <a:lnTo>
                  <a:pt x="5" y="1542"/>
                </a:lnTo>
                <a:moveTo>
                  <a:pt x="185" y="1463"/>
                </a:moveTo>
                <a:lnTo>
                  <a:pt x="95" y="1463"/>
                </a:lnTo>
                <a:moveTo>
                  <a:pt x="185" y="1396"/>
                </a:moveTo>
                <a:lnTo>
                  <a:pt x="95" y="1396"/>
                </a:lnTo>
                <a:moveTo>
                  <a:pt x="185" y="1318"/>
                </a:moveTo>
                <a:lnTo>
                  <a:pt x="95" y="1318"/>
                </a:lnTo>
                <a:moveTo>
                  <a:pt x="185" y="1250"/>
                </a:moveTo>
                <a:lnTo>
                  <a:pt x="5" y="1250"/>
                </a:lnTo>
                <a:moveTo>
                  <a:pt x="185" y="1172"/>
                </a:moveTo>
                <a:lnTo>
                  <a:pt x="95" y="1172"/>
                </a:lnTo>
                <a:moveTo>
                  <a:pt x="185" y="1105"/>
                </a:moveTo>
                <a:lnTo>
                  <a:pt x="95" y="1105"/>
                </a:lnTo>
                <a:moveTo>
                  <a:pt x="185" y="1026"/>
                </a:moveTo>
                <a:lnTo>
                  <a:pt x="95" y="1026"/>
                </a:lnTo>
                <a:moveTo>
                  <a:pt x="185" y="959"/>
                </a:moveTo>
                <a:lnTo>
                  <a:pt x="5" y="959"/>
                </a:lnTo>
                <a:moveTo>
                  <a:pt x="185" y="880"/>
                </a:moveTo>
                <a:lnTo>
                  <a:pt x="95" y="880"/>
                </a:lnTo>
                <a:moveTo>
                  <a:pt x="185" y="813"/>
                </a:moveTo>
                <a:lnTo>
                  <a:pt x="95" y="813"/>
                </a:lnTo>
                <a:moveTo>
                  <a:pt x="185" y="734"/>
                </a:moveTo>
                <a:lnTo>
                  <a:pt x="95" y="734"/>
                </a:lnTo>
                <a:moveTo>
                  <a:pt x="185" y="656"/>
                </a:moveTo>
                <a:lnTo>
                  <a:pt x="5" y="656"/>
                </a:lnTo>
                <a:moveTo>
                  <a:pt x="185" y="588"/>
                </a:moveTo>
                <a:lnTo>
                  <a:pt x="95" y="588"/>
                </a:lnTo>
                <a:moveTo>
                  <a:pt x="185" y="510"/>
                </a:moveTo>
                <a:lnTo>
                  <a:pt x="95" y="510"/>
                </a:lnTo>
                <a:moveTo>
                  <a:pt x="185" y="443"/>
                </a:moveTo>
                <a:lnTo>
                  <a:pt x="95" y="443"/>
                </a:lnTo>
                <a:moveTo>
                  <a:pt x="185" y="364"/>
                </a:moveTo>
                <a:lnTo>
                  <a:pt x="5" y="364"/>
                </a:lnTo>
                <a:moveTo>
                  <a:pt x="185" y="297"/>
                </a:moveTo>
                <a:lnTo>
                  <a:pt x="95" y="297"/>
                </a:lnTo>
                <a:moveTo>
                  <a:pt x="185" y="218"/>
                </a:moveTo>
                <a:lnTo>
                  <a:pt x="95" y="218"/>
                </a:lnTo>
                <a:moveTo>
                  <a:pt x="185" y="151"/>
                </a:moveTo>
                <a:lnTo>
                  <a:pt x="95" y="151"/>
                </a:lnTo>
                <a:moveTo>
                  <a:pt x="185" y="72"/>
                </a:moveTo>
                <a:lnTo>
                  <a:pt x="5" y="72"/>
                </a:lnTo>
                <a:moveTo>
                  <a:pt x="185" y="5"/>
                </a:moveTo>
                <a:lnTo>
                  <a:pt x="9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38" name="textbox 38"/>
          <p:cNvSpPr/>
          <p:nvPr/>
        </p:nvSpPr>
        <p:spPr>
          <a:xfrm>
            <a:off x="468099" y="9566299"/>
            <a:ext cx="949325" cy="1612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065"/>
              </a:lnSpc>
            </a:pPr>
            <a:r>
              <a:rPr sz="800" kern="0" spc="-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ModFit</a:t>
            </a:r>
            <a:r>
              <a:rPr sz="800" kern="0" spc="6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800" kern="0" spc="-3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LTV4.1.</a:t>
            </a:r>
            <a:r>
              <a:rPr sz="8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7(Win)</a:t>
            </a:r>
            <a:endParaRPr sz="8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40" name="textbox 40"/>
          <p:cNvSpPr/>
          <p:nvPr/>
        </p:nvSpPr>
        <p:spPr>
          <a:xfrm>
            <a:off x="3805569" y="454610"/>
            <a:ext cx="495300" cy="28638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4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33350" algn="l" rtl="0" eaLnBrk="0">
              <a:lnSpc>
                <a:spcPct val="122000"/>
              </a:lnSpc>
              <a:tabLst>
                <a:tab pos="198120" algn="l"/>
              </a:tabLst>
            </a:pP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G</a:t>
            </a:r>
            <a:r>
              <a:rPr sz="700" kern="0" spc="1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pic>
        <p:nvPicPr>
          <p:cNvPr id="42" name="picture 4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21600000">
            <a:off x="3818269" y="598385"/>
            <a:ext cx="121101" cy="99731"/>
          </a:xfrm>
          <a:prstGeom prst="rect">
            <a:avLst/>
          </a:prstGeom>
        </p:spPr>
      </p:pic>
      <p:pic>
        <p:nvPicPr>
          <p:cNvPr id="44" name="picture 4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21600000">
            <a:off x="3818269" y="477284"/>
            <a:ext cx="121101" cy="99730"/>
          </a:xfrm>
          <a:prstGeom prst="rect">
            <a:avLst/>
          </a:prstGeom>
        </p:spPr>
      </p:pic>
      <p:sp>
        <p:nvSpPr>
          <p:cNvPr id="46" name="textbox 46"/>
          <p:cNvSpPr/>
          <p:nvPr/>
        </p:nvSpPr>
        <p:spPr>
          <a:xfrm rot="16200000">
            <a:off x="2389390" y="7948715"/>
            <a:ext cx="1245869" cy="14160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48" name="textbox 48"/>
          <p:cNvSpPr/>
          <p:nvPr/>
        </p:nvSpPr>
        <p:spPr>
          <a:xfrm rot="16200000">
            <a:off x="52837" y="7948715"/>
            <a:ext cx="1245869" cy="14160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50" name="textbox 50"/>
          <p:cNvSpPr/>
          <p:nvPr/>
        </p:nvSpPr>
        <p:spPr>
          <a:xfrm rot="16200000">
            <a:off x="4725942" y="7948715"/>
            <a:ext cx="1245869" cy="141604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07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90000"/>
              </a:lnSpc>
              <a:spcBef>
                <a:spcPts val="0"/>
              </a:spcBef>
            </a:pP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0</a:t>
            </a:r>
            <a:r>
              <a:rPr sz="700" kern="0" spc="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0   40   60</a:t>
            </a:r>
            <a:r>
              <a:rPr sz="700" kern="0" spc="4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80</a:t>
            </a:r>
            <a:r>
              <a:rPr sz="700" kern="0" spc="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00</a:t>
            </a:r>
            <a:r>
              <a:rPr sz="700" kern="0" spc="1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700" kern="0" spc="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120</a:t>
            </a:r>
            <a:endParaRPr sz="7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52" name="path 52"/>
          <p:cNvSpPr/>
          <p:nvPr/>
        </p:nvSpPr>
        <p:spPr>
          <a:xfrm>
            <a:off x="1506649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4" name="path 54"/>
          <p:cNvSpPr/>
          <p:nvPr/>
        </p:nvSpPr>
        <p:spPr>
          <a:xfrm>
            <a:off x="13143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6" name="path 56"/>
          <p:cNvSpPr/>
          <p:nvPr/>
        </p:nvSpPr>
        <p:spPr>
          <a:xfrm>
            <a:off x="9225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58" name="path 58"/>
          <p:cNvSpPr/>
          <p:nvPr/>
        </p:nvSpPr>
        <p:spPr>
          <a:xfrm>
            <a:off x="1706111" y="8608915"/>
            <a:ext cx="149596" cy="121101"/>
          </a:xfrm>
          <a:custGeom>
            <a:avLst/>
            <a:gdLst/>
            <a:ahLst/>
            <a:cxnLst/>
            <a:rect l="0" t="0" r="0" b="0"/>
            <a:pathLst>
              <a:path w="235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51" y="5"/>
                </a:moveTo>
                <a:lnTo>
                  <a:pt x="151" y="95"/>
                </a:lnTo>
                <a:moveTo>
                  <a:pt x="229" y="5"/>
                </a:moveTo>
                <a:lnTo>
                  <a:pt x="229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0" name="path 60"/>
          <p:cNvSpPr/>
          <p:nvPr/>
        </p:nvSpPr>
        <p:spPr>
          <a:xfrm>
            <a:off x="1114849" y="8608915"/>
            <a:ext cx="156719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2" name="path 62"/>
          <p:cNvSpPr/>
          <p:nvPr/>
        </p:nvSpPr>
        <p:spPr>
          <a:xfrm>
            <a:off x="1898449" y="8608915"/>
            <a:ext cx="156720" cy="121101"/>
          </a:xfrm>
          <a:custGeom>
            <a:avLst/>
            <a:gdLst/>
            <a:ahLst/>
            <a:cxnLst/>
            <a:rect l="0" t="0" r="0" b="0"/>
            <a:pathLst>
              <a:path w="246" h="190">
                <a:moveTo>
                  <a:pt x="5" y="5"/>
                </a:moveTo>
                <a:lnTo>
                  <a:pt x="5" y="95"/>
                </a:lnTo>
                <a:moveTo>
                  <a:pt x="84" y="5"/>
                </a:moveTo>
                <a:lnTo>
                  <a:pt x="84" y="95"/>
                </a:lnTo>
                <a:moveTo>
                  <a:pt x="162" y="5"/>
                </a:moveTo>
                <a:lnTo>
                  <a:pt x="162" y="95"/>
                </a:lnTo>
                <a:moveTo>
                  <a:pt x="241" y="5"/>
                </a:moveTo>
                <a:lnTo>
                  <a:pt x="241" y="18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4" name="path 64"/>
          <p:cNvSpPr/>
          <p:nvPr/>
        </p:nvSpPr>
        <p:spPr>
          <a:xfrm>
            <a:off x="872645" y="8608915"/>
            <a:ext cx="1239512" cy="64112"/>
          </a:xfrm>
          <a:custGeom>
            <a:avLst/>
            <a:gdLst/>
            <a:ahLst/>
            <a:cxnLst/>
            <a:rect l="0" t="0" r="0" b="0"/>
            <a:pathLst>
              <a:path w="1951" h="100">
                <a:moveTo>
                  <a:pt x="1935" y="5"/>
                </a:moveTo>
                <a:lnTo>
                  <a:pt x="1935" y="95"/>
                </a:lnTo>
                <a:moveTo>
                  <a:pt x="5" y="5"/>
                </a:moveTo>
                <a:lnTo>
                  <a:pt x="1946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66" name="textbox 66"/>
          <p:cNvSpPr/>
          <p:nvPr/>
        </p:nvSpPr>
        <p:spPr>
          <a:xfrm rot="16200000">
            <a:off x="310755" y="2249794"/>
            <a:ext cx="421640" cy="1866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270"/>
              </a:lnSpc>
            </a:pPr>
            <a:r>
              <a:rPr sz="900" kern="0" spc="-2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Number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68" name="path 68"/>
          <p:cNvSpPr/>
          <p:nvPr/>
        </p:nvSpPr>
        <p:spPr>
          <a:xfrm>
            <a:off x="787161" y="2860140"/>
            <a:ext cx="135349" cy="427418"/>
          </a:xfrm>
          <a:custGeom>
            <a:avLst/>
            <a:gdLst/>
            <a:ahLst/>
            <a:cxnLst/>
            <a:rect l="0" t="0" r="0" b="0"/>
            <a:pathLst>
              <a:path w="213" h="673">
                <a:moveTo>
                  <a:pt x="207" y="667"/>
                </a:moveTo>
                <a:lnTo>
                  <a:pt x="106" y="667"/>
                </a:lnTo>
                <a:moveTo>
                  <a:pt x="207" y="499"/>
                </a:moveTo>
                <a:lnTo>
                  <a:pt x="106" y="499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73"/>
                </a:moveTo>
                <a:lnTo>
                  <a:pt x="106" y="173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0" name="path 70"/>
          <p:cNvSpPr/>
          <p:nvPr/>
        </p:nvSpPr>
        <p:spPr>
          <a:xfrm>
            <a:off x="787161" y="2347238"/>
            <a:ext cx="135349" cy="420294"/>
          </a:xfrm>
          <a:custGeom>
            <a:avLst/>
            <a:gdLst/>
            <a:ahLst/>
            <a:cxnLst/>
            <a:rect l="0" t="0" r="0" b="0"/>
            <a:pathLst>
              <a:path w="213" h="661">
                <a:moveTo>
                  <a:pt x="207" y="656"/>
                </a:moveTo>
                <a:lnTo>
                  <a:pt x="106" y="656"/>
                </a:lnTo>
                <a:moveTo>
                  <a:pt x="207" y="487"/>
                </a:moveTo>
                <a:lnTo>
                  <a:pt x="106" y="487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62"/>
                </a:moveTo>
                <a:lnTo>
                  <a:pt x="106" y="162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2" name="path 72"/>
          <p:cNvSpPr/>
          <p:nvPr/>
        </p:nvSpPr>
        <p:spPr>
          <a:xfrm>
            <a:off x="787161" y="1307187"/>
            <a:ext cx="135349" cy="420294"/>
          </a:xfrm>
          <a:custGeom>
            <a:avLst/>
            <a:gdLst/>
            <a:ahLst/>
            <a:cxnLst/>
            <a:rect l="0" t="0" r="0" b="0"/>
            <a:pathLst>
              <a:path w="213" h="661">
                <a:moveTo>
                  <a:pt x="207" y="656"/>
                </a:moveTo>
                <a:lnTo>
                  <a:pt x="106" y="656"/>
                </a:lnTo>
                <a:moveTo>
                  <a:pt x="207" y="499"/>
                </a:moveTo>
                <a:lnTo>
                  <a:pt x="106" y="499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62"/>
                </a:moveTo>
                <a:lnTo>
                  <a:pt x="106" y="162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4" name="path 74"/>
          <p:cNvSpPr/>
          <p:nvPr/>
        </p:nvSpPr>
        <p:spPr>
          <a:xfrm>
            <a:off x="787161" y="787162"/>
            <a:ext cx="135349" cy="420294"/>
          </a:xfrm>
          <a:custGeom>
            <a:avLst/>
            <a:gdLst/>
            <a:ahLst/>
            <a:cxnLst/>
            <a:rect l="0" t="0" r="0" b="0"/>
            <a:pathLst>
              <a:path w="213" h="661">
                <a:moveTo>
                  <a:pt x="207" y="656"/>
                </a:moveTo>
                <a:lnTo>
                  <a:pt x="106" y="656"/>
                </a:lnTo>
                <a:moveTo>
                  <a:pt x="207" y="499"/>
                </a:moveTo>
                <a:lnTo>
                  <a:pt x="106" y="499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73"/>
                </a:moveTo>
                <a:lnTo>
                  <a:pt x="106" y="173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6" name="path 76"/>
          <p:cNvSpPr/>
          <p:nvPr/>
        </p:nvSpPr>
        <p:spPr>
          <a:xfrm>
            <a:off x="787161" y="1827213"/>
            <a:ext cx="135349" cy="420294"/>
          </a:xfrm>
          <a:custGeom>
            <a:avLst/>
            <a:gdLst/>
            <a:ahLst/>
            <a:cxnLst/>
            <a:rect l="0" t="0" r="0" b="0"/>
            <a:pathLst>
              <a:path w="213" h="661">
                <a:moveTo>
                  <a:pt x="207" y="656"/>
                </a:moveTo>
                <a:lnTo>
                  <a:pt x="106" y="656"/>
                </a:lnTo>
                <a:moveTo>
                  <a:pt x="207" y="487"/>
                </a:moveTo>
                <a:lnTo>
                  <a:pt x="106" y="487"/>
                </a:lnTo>
                <a:moveTo>
                  <a:pt x="207" y="330"/>
                </a:moveTo>
                <a:lnTo>
                  <a:pt x="106" y="330"/>
                </a:lnTo>
                <a:moveTo>
                  <a:pt x="207" y="162"/>
                </a:moveTo>
                <a:lnTo>
                  <a:pt x="106" y="162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78" name="textbox 78"/>
          <p:cNvSpPr/>
          <p:nvPr/>
        </p:nvSpPr>
        <p:spPr>
          <a:xfrm>
            <a:off x="3805569" y="696814"/>
            <a:ext cx="434975" cy="1612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33350" algn="l" rtl="0" eaLnBrk="0">
              <a:lnSpc>
                <a:spcPts val="1065"/>
              </a:lnSpc>
              <a:tabLst>
                <a:tab pos="198120" algn="l"/>
              </a:tabLst>
            </a:pPr>
            <a:r>
              <a:rPr sz="800" kern="0" spc="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	</a:t>
            </a:r>
            <a:r>
              <a:rPr sz="800" kern="0" spc="-40" dirty="0">
                <a:solidFill>
                  <a:srgbClr val="0000FF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Dip S</a:t>
            </a:r>
            <a:endParaRPr sz="8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pic>
        <p:nvPicPr>
          <p:cNvPr id="80" name="picture 8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21600000">
            <a:off x="3818269" y="719487"/>
            <a:ext cx="121101" cy="99731"/>
          </a:xfrm>
          <a:prstGeom prst="rect">
            <a:avLst/>
          </a:prstGeom>
        </p:spPr>
      </p:pic>
      <p:sp>
        <p:nvSpPr>
          <p:cNvPr id="82" name="textbox 82"/>
          <p:cNvSpPr/>
          <p:nvPr/>
        </p:nvSpPr>
        <p:spPr>
          <a:xfrm rot="16200000">
            <a:off x="5064821" y="7915550"/>
            <a:ext cx="259715" cy="18668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ts val="1270"/>
              </a:lnSpc>
            </a:pP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P</a:t>
            </a:r>
            <a:r>
              <a:rPr sz="900" kern="0" spc="-1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 </a:t>
            </a:r>
            <a:r>
              <a:rPr sz="900" kern="0" spc="-1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I-H</a:t>
            </a:r>
            <a:endParaRPr sz="9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84" name="textbox 84"/>
          <p:cNvSpPr/>
          <p:nvPr/>
        </p:nvSpPr>
        <p:spPr>
          <a:xfrm rot="16200000">
            <a:off x="315261" y="7933009"/>
            <a:ext cx="407034" cy="17462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34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FSC-W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86" name="textbox 86"/>
          <p:cNvSpPr/>
          <p:nvPr/>
        </p:nvSpPr>
        <p:spPr>
          <a:xfrm rot="16200000">
            <a:off x="2662193" y="7926484"/>
            <a:ext cx="386079" cy="17462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134000"/>
              </a:lnSpc>
            </a:pPr>
            <a:endParaRPr sz="2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marL="12700" algn="l" rtl="0" eaLnBrk="0">
              <a:lnSpc>
                <a:spcPct val="79000"/>
              </a:lnSpc>
              <a:spcBef>
                <a:spcPts val="0"/>
              </a:spcBef>
            </a:pPr>
            <a:r>
              <a:rPr sz="1000" kern="0" spc="-5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SSC-A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88" name="path 88"/>
          <p:cNvSpPr/>
          <p:nvPr/>
        </p:nvSpPr>
        <p:spPr>
          <a:xfrm>
            <a:off x="787161" y="3380165"/>
            <a:ext cx="135349" cy="213709"/>
          </a:xfrm>
          <a:custGeom>
            <a:avLst/>
            <a:gdLst/>
            <a:ahLst/>
            <a:cxnLst/>
            <a:rect l="0" t="0" r="0" b="0"/>
            <a:pathLst>
              <a:path w="213" h="336">
                <a:moveTo>
                  <a:pt x="207" y="330"/>
                </a:moveTo>
                <a:lnTo>
                  <a:pt x="106" y="330"/>
                </a:lnTo>
                <a:moveTo>
                  <a:pt x="207" y="173"/>
                </a:moveTo>
                <a:lnTo>
                  <a:pt x="106" y="173"/>
                </a:lnTo>
                <a:moveTo>
                  <a:pt x="207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0" name="path 90"/>
          <p:cNvSpPr/>
          <p:nvPr/>
        </p:nvSpPr>
        <p:spPr>
          <a:xfrm>
            <a:off x="915387" y="787162"/>
            <a:ext cx="7123" cy="3120152"/>
          </a:xfrm>
          <a:custGeom>
            <a:avLst/>
            <a:gdLst/>
            <a:ahLst/>
            <a:cxnLst/>
            <a:rect l="0" t="0" r="0" b="0"/>
            <a:pathLst>
              <a:path w="11" h="4913">
                <a:moveTo>
                  <a:pt x="5" y="4908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2" name="rect 92"/>
          <p:cNvSpPr/>
          <p:nvPr/>
        </p:nvSpPr>
        <p:spPr>
          <a:xfrm>
            <a:off x="3381900" y="7613574"/>
            <a:ext cx="142473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w="0"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4" name="rect 94"/>
          <p:cNvSpPr/>
          <p:nvPr/>
        </p:nvSpPr>
        <p:spPr>
          <a:xfrm>
            <a:off x="5716958" y="7534850"/>
            <a:ext cx="142472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w="0"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6" name="rect 96"/>
          <p:cNvSpPr/>
          <p:nvPr/>
        </p:nvSpPr>
        <p:spPr>
          <a:xfrm>
            <a:off x="1098199" y="7602667"/>
            <a:ext cx="142472" cy="135349"/>
          </a:xfrm>
          <a:prstGeom prst="rect">
            <a:avLst/>
          </a:prstGeom>
          <a:solidFill>
            <a:srgbClr val="FFFFFF">
              <a:alpha val="49803"/>
            </a:srgbClr>
          </a:solidFill>
          <a:ln w="0" cap="flat">
            <a:noFill/>
            <a:prstDash val="solid"/>
            <a:miter lim="0"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98" name="textbox 98"/>
          <p:cNvSpPr/>
          <p:nvPr/>
        </p:nvSpPr>
        <p:spPr>
          <a:xfrm>
            <a:off x="5713715" y="7540575"/>
            <a:ext cx="161289" cy="144145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2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r" rtl="0" eaLnBrk="0">
              <a:lnSpc>
                <a:spcPct val="78000"/>
              </a:lnSpc>
            </a:pPr>
            <a:r>
              <a:rPr sz="1000" kern="0" spc="-9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</a:t>
            </a:r>
            <a:r>
              <a:rPr sz="1000" kern="0" spc="-5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3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00" name="textbox 100"/>
          <p:cNvSpPr/>
          <p:nvPr/>
        </p:nvSpPr>
        <p:spPr>
          <a:xfrm>
            <a:off x="1094927" y="7608361"/>
            <a:ext cx="161289" cy="14477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r" rtl="0" eaLnBrk="0">
              <a:lnSpc>
                <a:spcPct val="78000"/>
              </a:lnSpc>
            </a:pPr>
            <a:r>
              <a:rPr sz="1000" kern="0" spc="-7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1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02" name="textbox 102"/>
          <p:cNvSpPr/>
          <p:nvPr/>
        </p:nvSpPr>
        <p:spPr>
          <a:xfrm>
            <a:off x="3378609" y="7619269"/>
            <a:ext cx="161289" cy="144779"/>
          </a:xfrm>
          <a:prstGeom prst="rect">
            <a:avLst/>
          </a:prstGeom>
          <a:noFill/>
          <a:ln w="0" cap="flat">
            <a:noFill/>
            <a:prstDash val="solid"/>
            <a:miter lim="0"/>
          </a:ln>
        </p:spPr>
        <p:txBody>
          <a:bodyPr vert="horz" wrap="square" lIns="0" tIns="0" rIns="0" bIns="0"/>
          <a:lstStyle/>
          <a:p>
            <a:pPr algn="l" rtl="0" eaLnBrk="0">
              <a:lnSpc>
                <a:spcPct val="83000"/>
              </a:lnSpc>
            </a:pPr>
            <a:endParaRPr sz="100" dirty="0">
              <a:latin typeface="Arial" panose="020B0604020202020204"/>
              <a:ea typeface="Arial" panose="020B0604020202020204"/>
              <a:cs typeface="Arial" panose="020B0604020202020204"/>
            </a:endParaRPr>
          </a:p>
          <a:p>
            <a:pPr algn="r" rtl="0" eaLnBrk="0">
              <a:lnSpc>
                <a:spcPct val="78000"/>
              </a:lnSpc>
            </a:pPr>
            <a:r>
              <a:rPr sz="1000" kern="0" spc="-8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R</a:t>
            </a:r>
            <a:r>
              <a:rPr sz="1000" kern="0" spc="-60" dirty="0">
                <a:solidFill>
                  <a:srgbClr val="000000">
                    <a:alpha val="100000"/>
                  </a:srgbClr>
                </a:solidFill>
                <a:latin typeface="Arial" panose="020B0604020202020204"/>
                <a:ea typeface="Arial" panose="020B0604020202020204"/>
                <a:cs typeface="Arial" panose="020B0604020202020204"/>
              </a:rPr>
              <a:t>2</a:t>
            </a:r>
            <a:endParaRPr sz="1000" dirty="0">
              <a:latin typeface="Arial" panose="020B0604020202020204"/>
              <a:ea typeface="Arial" panose="020B0604020202020204"/>
              <a:cs typeface="Arial" panose="020B0604020202020204"/>
            </a:endParaRPr>
          </a:p>
        </p:txBody>
      </p:sp>
      <p:sp>
        <p:nvSpPr>
          <p:cNvPr id="104" name="path 104"/>
          <p:cNvSpPr/>
          <p:nvPr/>
        </p:nvSpPr>
        <p:spPr>
          <a:xfrm>
            <a:off x="758667" y="8608915"/>
            <a:ext cx="121101" cy="7123"/>
          </a:xfrm>
          <a:custGeom>
            <a:avLst/>
            <a:gdLst/>
            <a:ahLst/>
            <a:cxnLst/>
            <a:rect l="0" t="0" r="0" b="0"/>
            <a:pathLst>
              <a:path w="190" h="11">
                <a:moveTo>
                  <a:pt x="18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6" name="path 106"/>
          <p:cNvSpPr/>
          <p:nvPr/>
        </p:nvSpPr>
        <p:spPr>
          <a:xfrm>
            <a:off x="815656" y="8559049"/>
            <a:ext cx="64112" cy="7123"/>
          </a:xfrm>
          <a:custGeom>
            <a:avLst/>
            <a:gdLst/>
            <a:ahLst/>
            <a:cxnLst/>
            <a:rect l="0" t="0" r="0" b="0"/>
            <a:pathLst>
              <a:path w="100" h="11">
                <a:moveTo>
                  <a:pt x="95" y="5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  <p:sp>
        <p:nvSpPr>
          <p:cNvPr id="108" name="path 108"/>
          <p:cNvSpPr/>
          <p:nvPr/>
        </p:nvSpPr>
        <p:spPr>
          <a:xfrm>
            <a:off x="872645" y="7426391"/>
            <a:ext cx="7123" cy="1189647"/>
          </a:xfrm>
          <a:custGeom>
            <a:avLst/>
            <a:gdLst/>
            <a:ahLst/>
            <a:cxnLst/>
            <a:rect l="0" t="0" r="0" b="0"/>
            <a:pathLst>
              <a:path w="11" h="1873">
                <a:moveTo>
                  <a:pt x="5" y="1867"/>
                </a:moveTo>
                <a:lnTo>
                  <a:pt x="5" y="5"/>
                </a:lnTo>
              </a:path>
            </a:pathLst>
          </a:custGeom>
          <a:noFill/>
          <a:ln w="7123" cap="sq">
            <a:solidFill>
              <a:srgbClr val="000000"/>
            </a:solidFill>
            <a:prstDash val="solid"/>
            <a:bevel/>
          </a:ln>
        </p:spPr>
        <p:txBody>
          <a:bodyPr rtlCol="0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NjQ5NjlkZjQ4NmY2YmRlZWY0ZDc5MDc2N2QzMGZhMDQifQ=="/>
</p:tagLst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"/>
        <a:ea typeface=""/>
        <a:cs typeface=""/>
      </a:majorFont>
      <a:minorFont>
        <a:latin typeface="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satMod val="110000"/>
                <a:lum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satMod val="105000"/>
                <a:lum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shade val="94000"/>
              </a:schemeClr>
            </a:gs>
            <a:gs pos="50000">
              <a:schemeClr val="phClr">
                <a:lumMod val="110000"/>
                <a:satMod val="100000"/>
                <a:tint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64</Words>
  <Application>WPS 演示</Application>
  <PresentationFormat/>
  <Paragraphs>186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1" baseType="lpstr">
      <vt:lpstr>Arial</vt:lpstr>
      <vt:lpstr>宋体</vt:lpstr>
      <vt:lpstr>Wingdings</vt:lpstr>
      <vt:lpstr>Arial</vt:lpstr>
      <vt:lpstr>微软雅黑</vt:lpstr>
      <vt:lpstr>Arial Unicode MS</vt:lpstr>
      <vt:lpstr>Calibri</vt:lpstr>
      <vt:lpstr>Office theme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格林</cp:lastModifiedBy>
  <cp:revision>2</cp:revision>
  <dcterms:created xsi:type="dcterms:W3CDTF">2024-03-05T14:44:00Z</dcterms:created>
  <dcterms:modified xsi:type="dcterms:W3CDTF">2024-09-07T16:20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O">
    <vt:lpwstr>wqlLaW5nc29mdCBQREYgdG8gV1BTIDkw</vt:lpwstr>
  </property>
  <property fmtid="{D5CDD505-2E9C-101B-9397-08002B2CF9AE}" pid="3" name="Created">
    <vt:filetime>2024-03-06T06:35:58Z</vt:filetime>
  </property>
  <property fmtid="{D5CDD505-2E9C-101B-9397-08002B2CF9AE}" pid="4" name="ICV">
    <vt:lpwstr>E3226630D3B84580A98D59BA3C6F745D_12</vt:lpwstr>
  </property>
  <property fmtid="{D5CDD505-2E9C-101B-9397-08002B2CF9AE}" pid="5" name="KSOProductBuildVer">
    <vt:lpwstr>2052-12.1.0.16910</vt:lpwstr>
  </property>
</Properties>
</file>